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9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74CE4-CC21-41D9-BCC0-0057BF5AF3D0}" type="datetimeFigureOut">
              <a:rPr lang="es-MX" smtClean="0"/>
              <a:t>06/04/2020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B636D-ED4F-4097-844A-BE281B39B9D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60721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74CE4-CC21-41D9-BCC0-0057BF5AF3D0}" type="datetimeFigureOut">
              <a:rPr lang="es-MX" smtClean="0"/>
              <a:t>06/04/2020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B636D-ED4F-4097-844A-BE281B39B9D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64439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74CE4-CC21-41D9-BCC0-0057BF5AF3D0}" type="datetimeFigureOut">
              <a:rPr lang="es-MX" smtClean="0"/>
              <a:t>06/04/2020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B636D-ED4F-4097-844A-BE281B39B9D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53296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74CE4-CC21-41D9-BCC0-0057BF5AF3D0}" type="datetimeFigureOut">
              <a:rPr lang="es-MX" smtClean="0"/>
              <a:t>06/04/2020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B636D-ED4F-4097-844A-BE281B39B9D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16234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74CE4-CC21-41D9-BCC0-0057BF5AF3D0}" type="datetimeFigureOut">
              <a:rPr lang="es-MX" smtClean="0"/>
              <a:t>06/04/2020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B636D-ED4F-4097-844A-BE281B39B9D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10152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74CE4-CC21-41D9-BCC0-0057BF5AF3D0}" type="datetimeFigureOut">
              <a:rPr lang="es-MX" smtClean="0"/>
              <a:t>06/04/2020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B636D-ED4F-4097-844A-BE281B39B9D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17020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74CE4-CC21-41D9-BCC0-0057BF5AF3D0}" type="datetimeFigureOut">
              <a:rPr lang="es-MX" smtClean="0"/>
              <a:t>06/04/2020</a:t>
            </a:fld>
            <a:endParaRPr lang="es-MX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B636D-ED4F-4097-844A-BE281B39B9D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878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74CE4-CC21-41D9-BCC0-0057BF5AF3D0}" type="datetimeFigureOut">
              <a:rPr lang="es-MX" smtClean="0"/>
              <a:t>06/04/2020</a:t>
            </a:fld>
            <a:endParaRPr lang="es-MX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B636D-ED4F-4097-844A-BE281B39B9D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096334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74CE4-CC21-41D9-BCC0-0057BF5AF3D0}" type="datetimeFigureOut">
              <a:rPr lang="es-MX" smtClean="0"/>
              <a:t>06/04/2020</a:t>
            </a:fld>
            <a:endParaRPr lang="es-MX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B636D-ED4F-4097-844A-BE281B39B9D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53710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74CE4-CC21-41D9-BCC0-0057BF5AF3D0}" type="datetimeFigureOut">
              <a:rPr lang="es-MX" smtClean="0"/>
              <a:t>06/04/2020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B636D-ED4F-4097-844A-BE281B39B9D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423588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74CE4-CC21-41D9-BCC0-0057BF5AF3D0}" type="datetimeFigureOut">
              <a:rPr lang="es-MX" smtClean="0"/>
              <a:t>06/04/2020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B636D-ED4F-4097-844A-BE281B39B9D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43249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874CE4-CC21-41D9-BCC0-0057BF5AF3D0}" type="datetimeFigureOut">
              <a:rPr lang="es-MX" smtClean="0"/>
              <a:t>06/04/2020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9B636D-ED4F-4097-844A-BE281B39B9D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60674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21" Type="http://schemas.openxmlformats.org/officeDocument/2006/relationships/image" Target="../media/image20.png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>
            <a:grpSpLocks noChangeAspect="1"/>
          </p:cNvGrpSpPr>
          <p:nvPr/>
        </p:nvGrpSpPr>
        <p:grpSpPr bwMode="auto">
          <a:xfrm>
            <a:off x="322729" y="75865"/>
            <a:ext cx="11990097" cy="6643362"/>
            <a:chOff x="493" y="353"/>
            <a:chExt cx="6914" cy="3798"/>
          </a:xfrm>
        </p:grpSpPr>
        <p:sp>
          <p:nvSpPr>
            <p:cNvPr id="6" name="AutoShape 3"/>
            <p:cNvSpPr>
              <a:spLocks noChangeAspect="1" noChangeArrowheads="1" noTextEdit="1"/>
            </p:cNvSpPr>
            <p:nvPr/>
          </p:nvSpPr>
          <p:spPr bwMode="auto">
            <a:xfrm>
              <a:off x="2373" y="1261"/>
              <a:ext cx="606" cy="3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es-MX" dirty="0" err="1" smtClean="0"/>
                <a:t>Health</a:t>
              </a:r>
              <a:endParaRPr lang="es-MX" dirty="0" smtClean="0"/>
            </a:p>
            <a:p>
              <a:r>
                <a:rPr lang="es-MX" dirty="0" smtClean="0"/>
                <a:t>center</a:t>
              </a:r>
              <a:endParaRPr lang="es-MX" dirty="0"/>
            </a:p>
          </p:txBody>
        </p:sp>
        <p:sp>
          <p:nvSpPr>
            <p:cNvPr id="7" name="Rectangle 5"/>
            <p:cNvSpPr>
              <a:spLocks noChangeArrowheads="1"/>
            </p:cNvSpPr>
            <p:nvPr/>
          </p:nvSpPr>
          <p:spPr bwMode="auto">
            <a:xfrm>
              <a:off x="7270" y="3972"/>
              <a:ext cx="137" cy="1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1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 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Freeform 6"/>
            <p:cNvSpPr>
              <a:spLocks/>
            </p:cNvSpPr>
            <p:nvPr/>
          </p:nvSpPr>
          <p:spPr bwMode="auto">
            <a:xfrm>
              <a:off x="6331" y="3106"/>
              <a:ext cx="726" cy="637"/>
            </a:xfrm>
            <a:custGeom>
              <a:avLst/>
              <a:gdLst>
                <a:gd name="T0" fmla="*/ 0 w 3400"/>
                <a:gd name="T1" fmla="*/ 567 h 5416"/>
                <a:gd name="T2" fmla="*/ 567 w 3400"/>
                <a:gd name="T3" fmla="*/ 0 h 5416"/>
                <a:gd name="T4" fmla="*/ 2834 w 3400"/>
                <a:gd name="T5" fmla="*/ 0 h 5416"/>
                <a:gd name="T6" fmla="*/ 3400 w 3400"/>
                <a:gd name="T7" fmla="*/ 567 h 5416"/>
                <a:gd name="T8" fmla="*/ 3400 w 3400"/>
                <a:gd name="T9" fmla="*/ 4850 h 5416"/>
                <a:gd name="T10" fmla="*/ 2834 w 3400"/>
                <a:gd name="T11" fmla="*/ 5416 h 5416"/>
                <a:gd name="T12" fmla="*/ 567 w 3400"/>
                <a:gd name="T13" fmla="*/ 5416 h 5416"/>
                <a:gd name="T14" fmla="*/ 0 w 3400"/>
                <a:gd name="T15" fmla="*/ 4850 h 5416"/>
                <a:gd name="T16" fmla="*/ 0 w 3400"/>
                <a:gd name="T17" fmla="*/ 567 h 5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3400" h="5416">
                  <a:moveTo>
                    <a:pt x="0" y="567"/>
                  </a:moveTo>
                  <a:cubicBezTo>
                    <a:pt x="0" y="254"/>
                    <a:pt x="254" y="0"/>
                    <a:pt x="567" y="0"/>
                  </a:cubicBezTo>
                  <a:lnTo>
                    <a:pt x="2834" y="0"/>
                  </a:lnTo>
                  <a:cubicBezTo>
                    <a:pt x="3147" y="0"/>
                    <a:pt x="3400" y="254"/>
                    <a:pt x="3400" y="567"/>
                  </a:cubicBezTo>
                  <a:lnTo>
                    <a:pt x="3400" y="4850"/>
                  </a:lnTo>
                  <a:cubicBezTo>
                    <a:pt x="3400" y="5163"/>
                    <a:pt x="3147" y="5416"/>
                    <a:pt x="2834" y="5416"/>
                  </a:cubicBezTo>
                  <a:lnTo>
                    <a:pt x="567" y="5416"/>
                  </a:lnTo>
                  <a:cubicBezTo>
                    <a:pt x="254" y="5416"/>
                    <a:pt x="0" y="5163"/>
                    <a:pt x="0" y="4850"/>
                  </a:cubicBezTo>
                  <a:lnTo>
                    <a:pt x="0" y="567"/>
                  </a:lnTo>
                  <a:close/>
                </a:path>
              </a:pathLst>
            </a:custGeom>
            <a:solidFill>
              <a:srgbClr val="B4C7E7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es-MX" dirty="0" err="1" smtClean="0"/>
                <a:t>Patient</a:t>
              </a:r>
              <a:r>
                <a:rPr lang="es-MX" dirty="0" smtClean="0"/>
                <a:t>    </a:t>
              </a:r>
              <a:r>
                <a:rPr lang="es-MX" dirty="0" err="1" smtClean="0"/>
                <a:t>referral</a:t>
              </a:r>
              <a:r>
                <a:rPr lang="es-MX" dirty="0" smtClean="0"/>
                <a:t> </a:t>
              </a:r>
              <a:r>
                <a:rPr lang="es-MX" dirty="0" err="1" smtClean="0"/>
                <a:t>system</a:t>
              </a:r>
              <a:endParaRPr lang="es-MX" dirty="0"/>
            </a:p>
          </p:txBody>
        </p:sp>
        <p:sp>
          <p:nvSpPr>
            <p:cNvPr id="9" name="Freeform 7"/>
            <p:cNvSpPr>
              <a:spLocks/>
            </p:cNvSpPr>
            <p:nvPr/>
          </p:nvSpPr>
          <p:spPr bwMode="auto">
            <a:xfrm>
              <a:off x="6317" y="3100"/>
              <a:ext cx="766" cy="649"/>
            </a:xfrm>
            <a:custGeom>
              <a:avLst/>
              <a:gdLst>
                <a:gd name="T0" fmla="*/ 0 w 3400"/>
                <a:gd name="T1" fmla="*/ 567 h 5416"/>
                <a:gd name="T2" fmla="*/ 567 w 3400"/>
                <a:gd name="T3" fmla="*/ 0 h 5416"/>
                <a:gd name="T4" fmla="*/ 2834 w 3400"/>
                <a:gd name="T5" fmla="*/ 0 h 5416"/>
                <a:gd name="T6" fmla="*/ 3400 w 3400"/>
                <a:gd name="T7" fmla="*/ 567 h 5416"/>
                <a:gd name="T8" fmla="*/ 3400 w 3400"/>
                <a:gd name="T9" fmla="*/ 4850 h 5416"/>
                <a:gd name="T10" fmla="*/ 2834 w 3400"/>
                <a:gd name="T11" fmla="*/ 5416 h 5416"/>
                <a:gd name="T12" fmla="*/ 567 w 3400"/>
                <a:gd name="T13" fmla="*/ 5416 h 5416"/>
                <a:gd name="T14" fmla="*/ 0 w 3400"/>
                <a:gd name="T15" fmla="*/ 4850 h 5416"/>
                <a:gd name="T16" fmla="*/ 0 w 3400"/>
                <a:gd name="T17" fmla="*/ 567 h 5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3400" h="5416">
                  <a:moveTo>
                    <a:pt x="0" y="567"/>
                  </a:moveTo>
                  <a:cubicBezTo>
                    <a:pt x="0" y="254"/>
                    <a:pt x="254" y="0"/>
                    <a:pt x="567" y="0"/>
                  </a:cubicBezTo>
                  <a:lnTo>
                    <a:pt x="2834" y="0"/>
                  </a:lnTo>
                  <a:cubicBezTo>
                    <a:pt x="3147" y="0"/>
                    <a:pt x="3400" y="254"/>
                    <a:pt x="3400" y="567"/>
                  </a:cubicBezTo>
                  <a:lnTo>
                    <a:pt x="3400" y="4850"/>
                  </a:lnTo>
                  <a:cubicBezTo>
                    <a:pt x="3400" y="5163"/>
                    <a:pt x="3147" y="5416"/>
                    <a:pt x="2834" y="5416"/>
                  </a:cubicBezTo>
                  <a:lnTo>
                    <a:pt x="567" y="5416"/>
                  </a:lnTo>
                  <a:cubicBezTo>
                    <a:pt x="254" y="5416"/>
                    <a:pt x="0" y="5163"/>
                    <a:pt x="0" y="4850"/>
                  </a:cubicBezTo>
                  <a:lnTo>
                    <a:pt x="0" y="567"/>
                  </a:lnTo>
                  <a:close/>
                </a:path>
              </a:pathLst>
            </a:custGeom>
            <a:noFill/>
            <a:ln w="22225" cap="flat">
              <a:solidFill>
                <a:srgbClr val="2F559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10" name="Rectangle 8"/>
            <p:cNvSpPr>
              <a:spLocks noChangeArrowheads="1"/>
            </p:cNvSpPr>
            <p:nvPr/>
          </p:nvSpPr>
          <p:spPr bwMode="auto">
            <a:xfrm>
              <a:off x="493" y="353"/>
              <a:ext cx="6764" cy="3711"/>
            </a:xfrm>
            <a:prstGeom prst="rect">
              <a:avLst/>
            </a:prstGeom>
            <a:noFill/>
            <a:ln w="222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11" name="Line 9"/>
            <p:cNvSpPr>
              <a:spLocks noChangeShapeType="1"/>
            </p:cNvSpPr>
            <p:nvPr/>
          </p:nvSpPr>
          <p:spPr bwMode="auto">
            <a:xfrm>
              <a:off x="2815" y="1085"/>
              <a:ext cx="1089" cy="140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12" name="Line 10"/>
            <p:cNvSpPr>
              <a:spLocks noChangeShapeType="1"/>
            </p:cNvSpPr>
            <p:nvPr/>
          </p:nvSpPr>
          <p:spPr bwMode="auto">
            <a:xfrm>
              <a:off x="2815" y="1479"/>
              <a:ext cx="1089" cy="101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13" name="Line 11"/>
            <p:cNvSpPr>
              <a:spLocks noChangeShapeType="1"/>
            </p:cNvSpPr>
            <p:nvPr/>
          </p:nvSpPr>
          <p:spPr bwMode="auto">
            <a:xfrm>
              <a:off x="2815" y="2262"/>
              <a:ext cx="1089" cy="235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14" name="Line 12"/>
            <p:cNvSpPr>
              <a:spLocks noChangeShapeType="1"/>
            </p:cNvSpPr>
            <p:nvPr/>
          </p:nvSpPr>
          <p:spPr bwMode="auto">
            <a:xfrm flipV="1">
              <a:off x="2815" y="2494"/>
              <a:ext cx="1089" cy="156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15" name="Oval 13"/>
            <p:cNvSpPr>
              <a:spLocks noChangeArrowheads="1"/>
            </p:cNvSpPr>
            <p:nvPr/>
          </p:nvSpPr>
          <p:spPr bwMode="auto">
            <a:xfrm>
              <a:off x="2170" y="2480"/>
              <a:ext cx="724" cy="457"/>
            </a:xfrm>
            <a:prstGeom prst="ellipse">
              <a:avLst/>
            </a:prstGeom>
            <a:solidFill>
              <a:srgbClr val="FBE5D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es-MX" dirty="0" err="1" smtClean="0"/>
                <a:t>Health</a:t>
              </a:r>
              <a:r>
                <a:rPr lang="es-MX" dirty="0" smtClean="0"/>
                <a:t> center</a:t>
              </a:r>
              <a:endParaRPr lang="es-MX" dirty="0"/>
            </a:p>
          </p:txBody>
        </p:sp>
        <p:sp>
          <p:nvSpPr>
            <p:cNvPr id="18" name="Oval 18"/>
            <p:cNvSpPr>
              <a:spLocks noChangeArrowheads="1"/>
            </p:cNvSpPr>
            <p:nvPr/>
          </p:nvSpPr>
          <p:spPr bwMode="auto">
            <a:xfrm>
              <a:off x="2250" y="856"/>
              <a:ext cx="700" cy="404"/>
            </a:xfrm>
            <a:prstGeom prst="ellipse">
              <a:avLst/>
            </a:prstGeom>
            <a:solidFill>
              <a:schemeClr val="accent2">
                <a:lumMod val="20000"/>
                <a:lumOff val="80000"/>
              </a:schemeClr>
            </a:solidFill>
            <a:ln w="22225" cap="flat">
              <a:solidFill>
                <a:srgbClr val="ED7D3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es-MX" sz="1600" dirty="0" err="1" smtClean="0"/>
                <a:t>Health</a:t>
              </a:r>
              <a:endParaRPr lang="es-MX" sz="1600" dirty="0" smtClean="0"/>
            </a:p>
            <a:p>
              <a:r>
                <a:rPr lang="es-MX" sz="1600" dirty="0" smtClean="0"/>
                <a:t>center </a:t>
              </a:r>
              <a:endParaRPr lang="es-MX" sz="1600" dirty="0"/>
            </a:p>
          </p:txBody>
        </p:sp>
        <p:sp>
          <p:nvSpPr>
            <p:cNvPr id="20" name="Oval 22"/>
            <p:cNvSpPr>
              <a:spLocks noChangeArrowheads="1"/>
            </p:cNvSpPr>
            <p:nvPr/>
          </p:nvSpPr>
          <p:spPr bwMode="auto">
            <a:xfrm>
              <a:off x="2291" y="1664"/>
              <a:ext cx="613" cy="398"/>
            </a:xfrm>
            <a:prstGeom prst="ellipse">
              <a:avLst/>
            </a:prstGeom>
            <a:noFill/>
            <a:ln w="22225" cap="flat">
              <a:solidFill>
                <a:srgbClr val="ED7D3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22" name="Oval 26"/>
            <p:cNvSpPr>
              <a:spLocks noChangeArrowheads="1"/>
            </p:cNvSpPr>
            <p:nvPr/>
          </p:nvSpPr>
          <p:spPr bwMode="auto">
            <a:xfrm>
              <a:off x="2282" y="1279"/>
              <a:ext cx="668" cy="357"/>
            </a:xfrm>
            <a:prstGeom prst="ellipse">
              <a:avLst/>
            </a:prstGeom>
            <a:noFill/>
            <a:ln w="22225" cap="flat">
              <a:solidFill>
                <a:srgbClr val="ED7D3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24" name="Oval 30"/>
            <p:cNvSpPr>
              <a:spLocks noChangeArrowheads="1"/>
            </p:cNvSpPr>
            <p:nvPr/>
          </p:nvSpPr>
          <p:spPr bwMode="auto">
            <a:xfrm>
              <a:off x="2174" y="2112"/>
              <a:ext cx="693" cy="358"/>
            </a:xfrm>
            <a:prstGeom prst="ellipse">
              <a:avLst/>
            </a:prstGeom>
            <a:noFill/>
            <a:ln w="22225" cap="flat">
              <a:solidFill>
                <a:srgbClr val="ED7D3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25" name="Line 33"/>
            <p:cNvSpPr>
              <a:spLocks noChangeShapeType="1"/>
            </p:cNvSpPr>
            <p:nvPr/>
          </p:nvSpPr>
          <p:spPr bwMode="auto">
            <a:xfrm>
              <a:off x="2829" y="2650"/>
              <a:ext cx="1090" cy="626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26" name="Line 34"/>
            <p:cNvSpPr>
              <a:spLocks noChangeShapeType="1"/>
            </p:cNvSpPr>
            <p:nvPr/>
          </p:nvSpPr>
          <p:spPr bwMode="auto">
            <a:xfrm>
              <a:off x="2824" y="1882"/>
              <a:ext cx="1089" cy="626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27" name="Oval 35"/>
            <p:cNvSpPr>
              <a:spLocks noChangeArrowheads="1"/>
            </p:cNvSpPr>
            <p:nvPr/>
          </p:nvSpPr>
          <p:spPr bwMode="auto">
            <a:xfrm>
              <a:off x="3934" y="2820"/>
              <a:ext cx="1402" cy="915"/>
            </a:xfrm>
            <a:prstGeom prst="ellipse">
              <a:avLst/>
            </a:prstGeom>
            <a:solidFill>
              <a:srgbClr val="B4C7E7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 dirty="0"/>
            </a:p>
            <a:p>
              <a:endParaRPr lang="es-MX" dirty="0" smtClean="0"/>
            </a:p>
            <a:p>
              <a:r>
                <a:rPr lang="es-MX" sz="2000" dirty="0" smtClean="0"/>
                <a:t>Hospital</a:t>
              </a:r>
              <a:endParaRPr lang="es-MX" sz="2000" dirty="0"/>
            </a:p>
          </p:txBody>
        </p:sp>
        <p:sp>
          <p:nvSpPr>
            <p:cNvPr id="28" name="Oval 36"/>
            <p:cNvSpPr>
              <a:spLocks noChangeArrowheads="1"/>
            </p:cNvSpPr>
            <p:nvPr/>
          </p:nvSpPr>
          <p:spPr bwMode="auto">
            <a:xfrm>
              <a:off x="3932" y="2804"/>
              <a:ext cx="1387" cy="939"/>
            </a:xfrm>
            <a:prstGeom prst="ellipse">
              <a:avLst/>
            </a:prstGeom>
            <a:noFill/>
            <a:ln w="22225" cap="flat">
              <a:solidFill>
                <a:srgbClr val="2038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30" name="Oval 40"/>
            <p:cNvSpPr>
              <a:spLocks noChangeArrowheads="1"/>
            </p:cNvSpPr>
            <p:nvPr/>
          </p:nvSpPr>
          <p:spPr bwMode="auto">
            <a:xfrm>
              <a:off x="3678" y="2420"/>
              <a:ext cx="1075" cy="635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es-MX" dirty="0" smtClean="0"/>
                <a:t>Maternal </a:t>
              </a:r>
            </a:p>
            <a:p>
              <a:r>
                <a:rPr lang="es-MX" dirty="0" err="1" smtClean="0"/>
                <a:t>house</a:t>
              </a:r>
              <a:endParaRPr lang="es-MX" dirty="0"/>
            </a:p>
          </p:txBody>
        </p:sp>
        <p:sp>
          <p:nvSpPr>
            <p:cNvPr id="32" name="Oval 42"/>
            <p:cNvSpPr>
              <a:spLocks noChangeArrowheads="1"/>
            </p:cNvSpPr>
            <p:nvPr/>
          </p:nvSpPr>
          <p:spPr bwMode="auto">
            <a:xfrm>
              <a:off x="3678" y="2427"/>
              <a:ext cx="1075" cy="635"/>
            </a:xfrm>
            <a:prstGeom prst="ellipse">
              <a:avLst/>
            </a:prstGeom>
            <a:noFill/>
            <a:ln w="22225" cap="flat">
              <a:solidFill>
                <a:srgbClr val="521B9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34" name="Freeform 48"/>
            <p:cNvSpPr>
              <a:spLocks/>
            </p:cNvSpPr>
            <p:nvPr/>
          </p:nvSpPr>
          <p:spPr bwMode="auto">
            <a:xfrm>
              <a:off x="4188" y="1319"/>
              <a:ext cx="170" cy="967"/>
            </a:xfrm>
            <a:custGeom>
              <a:avLst/>
              <a:gdLst>
                <a:gd name="T0" fmla="*/ 0 w 157"/>
                <a:gd name="T1" fmla="*/ 418 h 470"/>
                <a:gd name="T2" fmla="*/ 39 w 157"/>
                <a:gd name="T3" fmla="*/ 418 h 470"/>
                <a:gd name="T4" fmla="*/ 39 w 157"/>
                <a:gd name="T5" fmla="*/ 0 h 470"/>
                <a:gd name="T6" fmla="*/ 117 w 157"/>
                <a:gd name="T7" fmla="*/ 0 h 470"/>
                <a:gd name="T8" fmla="*/ 117 w 157"/>
                <a:gd name="T9" fmla="*/ 418 h 470"/>
                <a:gd name="T10" fmla="*/ 157 w 157"/>
                <a:gd name="T11" fmla="*/ 418 h 470"/>
                <a:gd name="T12" fmla="*/ 78 w 157"/>
                <a:gd name="T13" fmla="*/ 470 h 470"/>
                <a:gd name="T14" fmla="*/ 0 w 157"/>
                <a:gd name="T15" fmla="*/ 418 h 4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57" h="470">
                  <a:moveTo>
                    <a:pt x="0" y="418"/>
                  </a:moveTo>
                  <a:lnTo>
                    <a:pt x="39" y="418"/>
                  </a:lnTo>
                  <a:lnTo>
                    <a:pt x="39" y="0"/>
                  </a:lnTo>
                  <a:lnTo>
                    <a:pt x="117" y="0"/>
                  </a:lnTo>
                  <a:lnTo>
                    <a:pt x="117" y="418"/>
                  </a:lnTo>
                  <a:lnTo>
                    <a:pt x="157" y="418"/>
                  </a:lnTo>
                  <a:lnTo>
                    <a:pt x="78" y="470"/>
                  </a:lnTo>
                  <a:lnTo>
                    <a:pt x="0" y="418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22225" cap="flat">
              <a:solidFill>
                <a:srgbClr val="3B3838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35" name="Freeform 49"/>
            <p:cNvSpPr>
              <a:spLocks/>
            </p:cNvSpPr>
            <p:nvPr/>
          </p:nvSpPr>
          <p:spPr bwMode="auto">
            <a:xfrm flipH="1">
              <a:off x="4541" y="1610"/>
              <a:ext cx="28" cy="762"/>
            </a:xfrm>
            <a:custGeom>
              <a:avLst/>
              <a:gdLst>
                <a:gd name="T0" fmla="*/ 0 w 155"/>
                <a:gd name="T1" fmla="*/ 51 h 470"/>
                <a:gd name="T2" fmla="*/ 78 w 155"/>
                <a:gd name="T3" fmla="*/ 0 h 470"/>
                <a:gd name="T4" fmla="*/ 155 w 155"/>
                <a:gd name="T5" fmla="*/ 51 h 470"/>
                <a:gd name="T6" fmla="*/ 116 w 155"/>
                <a:gd name="T7" fmla="*/ 51 h 470"/>
                <a:gd name="T8" fmla="*/ 116 w 155"/>
                <a:gd name="T9" fmla="*/ 470 h 470"/>
                <a:gd name="T10" fmla="*/ 39 w 155"/>
                <a:gd name="T11" fmla="*/ 470 h 470"/>
                <a:gd name="T12" fmla="*/ 39 w 155"/>
                <a:gd name="T13" fmla="*/ 51 h 470"/>
                <a:gd name="T14" fmla="*/ 0 w 155"/>
                <a:gd name="T15" fmla="*/ 51 h 4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55" h="470">
                  <a:moveTo>
                    <a:pt x="0" y="51"/>
                  </a:moveTo>
                  <a:lnTo>
                    <a:pt x="78" y="0"/>
                  </a:lnTo>
                  <a:lnTo>
                    <a:pt x="155" y="51"/>
                  </a:lnTo>
                  <a:lnTo>
                    <a:pt x="116" y="51"/>
                  </a:lnTo>
                  <a:lnTo>
                    <a:pt x="116" y="470"/>
                  </a:lnTo>
                  <a:lnTo>
                    <a:pt x="39" y="470"/>
                  </a:lnTo>
                  <a:lnTo>
                    <a:pt x="39" y="51"/>
                  </a:lnTo>
                  <a:lnTo>
                    <a:pt x="0" y="51"/>
                  </a:lnTo>
                  <a:close/>
                </a:path>
              </a:pathLst>
            </a:custGeom>
            <a:solidFill>
              <a:srgbClr val="D0CEC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36" name="Freeform 50"/>
            <p:cNvSpPr>
              <a:spLocks/>
            </p:cNvSpPr>
            <p:nvPr/>
          </p:nvSpPr>
          <p:spPr bwMode="auto">
            <a:xfrm>
              <a:off x="4483" y="1411"/>
              <a:ext cx="191" cy="961"/>
            </a:xfrm>
            <a:custGeom>
              <a:avLst/>
              <a:gdLst>
                <a:gd name="T0" fmla="*/ 0 w 155"/>
                <a:gd name="T1" fmla="*/ 51 h 470"/>
                <a:gd name="T2" fmla="*/ 78 w 155"/>
                <a:gd name="T3" fmla="*/ 0 h 470"/>
                <a:gd name="T4" fmla="*/ 155 w 155"/>
                <a:gd name="T5" fmla="*/ 51 h 470"/>
                <a:gd name="T6" fmla="*/ 116 w 155"/>
                <a:gd name="T7" fmla="*/ 51 h 470"/>
                <a:gd name="T8" fmla="*/ 116 w 155"/>
                <a:gd name="T9" fmla="*/ 470 h 470"/>
                <a:gd name="T10" fmla="*/ 39 w 155"/>
                <a:gd name="T11" fmla="*/ 470 h 470"/>
                <a:gd name="T12" fmla="*/ 39 w 155"/>
                <a:gd name="T13" fmla="*/ 51 h 470"/>
                <a:gd name="T14" fmla="*/ 0 w 155"/>
                <a:gd name="T15" fmla="*/ 51 h 4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55" h="470">
                  <a:moveTo>
                    <a:pt x="0" y="51"/>
                  </a:moveTo>
                  <a:lnTo>
                    <a:pt x="78" y="0"/>
                  </a:lnTo>
                  <a:lnTo>
                    <a:pt x="155" y="51"/>
                  </a:lnTo>
                  <a:lnTo>
                    <a:pt x="116" y="51"/>
                  </a:lnTo>
                  <a:lnTo>
                    <a:pt x="116" y="470"/>
                  </a:lnTo>
                  <a:lnTo>
                    <a:pt x="39" y="470"/>
                  </a:lnTo>
                  <a:lnTo>
                    <a:pt x="39" y="51"/>
                  </a:lnTo>
                  <a:lnTo>
                    <a:pt x="0" y="51"/>
                  </a:lnTo>
                  <a:close/>
                </a:path>
              </a:pathLst>
            </a:custGeom>
            <a:noFill/>
            <a:ln w="22225" cap="flat">
              <a:solidFill>
                <a:srgbClr val="3B383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pic>
          <p:nvPicPr>
            <p:cNvPr id="1075" name="Picture 51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20" y="1953"/>
              <a:ext cx="1432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77" name="Picture 5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20" y="2144"/>
              <a:ext cx="1322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79" name="Picture 55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20" y="2237"/>
              <a:ext cx="1075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7" name="Freeform 57"/>
            <p:cNvSpPr>
              <a:spLocks/>
            </p:cNvSpPr>
            <p:nvPr/>
          </p:nvSpPr>
          <p:spPr bwMode="auto">
            <a:xfrm>
              <a:off x="5630" y="3393"/>
              <a:ext cx="233" cy="234"/>
            </a:xfrm>
            <a:custGeom>
              <a:avLst/>
              <a:gdLst>
                <a:gd name="T0" fmla="*/ 0 w 233"/>
                <a:gd name="T1" fmla="*/ 0 h 234"/>
                <a:gd name="T2" fmla="*/ 116 w 233"/>
                <a:gd name="T3" fmla="*/ 0 h 234"/>
                <a:gd name="T4" fmla="*/ 233 w 233"/>
                <a:gd name="T5" fmla="*/ 117 h 234"/>
                <a:gd name="T6" fmla="*/ 116 w 233"/>
                <a:gd name="T7" fmla="*/ 234 h 234"/>
                <a:gd name="T8" fmla="*/ 0 w 233"/>
                <a:gd name="T9" fmla="*/ 234 h 234"/>
                <a:gd name="T10" fmla="*/ 116 w 233"/>
                <a:gd name="T11" fmla="*/ 117 h 234"/>
                <a:gd name="T12" fmla="*/ 0 w 233"/>
                <a:gd name="T13" fmla="*/ 0 h 2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33" h="234">
                  <a:moveTo>
                    <a:pt x="0" y="0"/>
                  </a:moveTo>
                  <a:lnTo>
                    <a:pt x="116" y="0"/>
                  </a:lnTo>
                  <a:lnTo>
                    <a:pt x="233" y="117"/>
                  </a:lnTo>
                  <a:lnTo>
                    <a:pt x="116" y="234"/>
                  </a:lnTo>
                  <a:lnTo>
                    <a:pt x="0" y="234"/>
                  </a:lnTo>
                  <a:lnTo>
                    <a:pt x="116" y="1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E2F0D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38" name="Freeform 58"/>
            <p:cNvSpPr>
              <a:spLocks/>
            </p:cNvSpPr>
            <p:nvPr/>
          </p:nvSpPr>
          <p:spPr bwMode="auto">
            <a:xfrm>
              <a:off x="5630" y="3393"/>
              <a:ext cx="233" cy="234"/>
            </a:xfrm>
            <a:custGeom>
              <a:avLst/>
              <a:gdLst>
                <a:gd name="T0" fmla="*/ 0 w 233"/>
                <a:gd name="T1" fmla="*/ 0 h 234"/>
                <a:gd name="T2" fmla="*/ 116 w 233"/>
                <a:gd name="T3" fmla="*/ 0 h 234"/>
                <a:gd name="T4" fmla="*/ 233 w 233"/>
                <a:gd name="T5" fmla="*/ 117 h 234"/>
                <a:gd name="T6" fmla="*/ 116 w 233"/>
                <a:gd name="T7" fmla="*/ 234 h 234"/>
                <a:gd name="T8" fmla="*/ 0 w 233"/>
                <a:gd name="T9" fmla="*/ 234 h 234"/>
                <a:gd name="T10" fmla="*/ 116 w 233"/>
                <a:gd name="T11" fmla="*/ 117 h 234"/>
                <a:gd name="T12" fmla="*/ 0 w 233"/>
                <a:gd name="T13" fmla="*/ 0 h 2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33" h="234">
                  <a:moveTo>
                    <a:pt x="0" y="0"/>
                  </a:moveTo>
                  <a:lnTo>
                    <a:pt x="116" y="0"/>
                  </a:lnTo>
                  <a:lnTo>
                    <a:pt x="233" y="117"/>
                  </a:lnTo>
                  <a:lnTo>
                    <a:pt x="116" y="234"/>
                  </a:lnTo>
                  <a:lnTo>
                    <a:pt x="0" y="234"/>
                  </a:lnTo>
                  <a:lnTo>
                    <a:pt x="116" y="117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22225" cap="flat">
              <a:solidFill>
                <a:srgbClr val="A9D18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39" name="Freeform 59"/>
            <p:cNvSpPr>
              <a:spLocks/>
            </p:cNvSpPr>
            <p:nvPr/>
          </p:nvSpPr>
          <p:spPr bwMode="auto">
            <a:xfrm>
              <a:off x="5791" y="3393"/>
              <a:ext cx="232" cy="234"/>
            </a:xfrm>
            <a:custGeom>
              <a:avLst/>
              <a:gdLst>
                <a:gd name="T0" fmla="*/ 0 w 232"/>
                <a:gd name="T1" fmla="*/ 0 h 234"/>
                <a:gd name="T2" fmla="*/ 116 w 232"/>
                <a:gd name="T3" fmla="*/ 0 h 234"/>
                <a:gd name="T4" fmla="*/ 232 w 232"/>
                <a:gd name="T5" fmla="*/ 117 h 234"/>
                <a:gd name="T6" fmla="*/ 116 w 232"/>
                <a:gd name="T7" fmla="*/ 234 h 234"/>
                <a:gd name="T8" fmla="*/ 0 w 232"/>
                <a:gd name="T9" fmla="*/ 234 h 234"/>
                <a:gd name="T10" fmla="*/ 116 w 232"/>
                <a:gd name="T11" fmla="*/ 117 h 234"/>
                <a:gd name="T12" fmla="*/ 0 w 232"/>
                <a:gd name="T13" fmla="*/ 0 h 2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32" h="234">
                  <a:moveTo>
                    <a:pt x="0" y="0"/>
                  </a:moveTo>
                  <a:lnTo>
                    <a:pt x="116" y="0"/>
                  </a:lnTo>
                  <a:lnTo>
                    <a:pt x="232" y="117"/>
                  </a:lnTo>
                  <a:lnTo>
                    <a:pt x="116" y="234"/>
                  </a:lnTo>
                  <a:lnTo>
                    <a:pt x="0" y="234"/>
                  </a:lnTo>
                  <a:lnTo>
                    <a:pt x="116" y="1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E2F0D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40" name="Freeform 60"/>
            <p:cNvSpPr>
              <a:spLocks/>
            </p:cNvSpPr>
            <p:nvPr/>
          </p:nvSpPr>
          <p:spPr bwMode="auto">
            <a:xfrm>
              <a:off x="5791" y="3393"/>
              <a:ext cx="232" cy="234"/>
            </a:xfrm>
            <a:custGeom>
              <a:avLst/>
              <a:gdLst>
                <a:gd name="T0" fmla="*/ 0 w 232"/>
                <a:gd name="T1" fmla="*/ 0 h 234"/>
                <a:gd name="T2" fmla="*/ 116 w 232"/>
                <a:gd name="T3" fmla="*/ 0 h 234"/>
                <a:gd name="T4" fmla="*/ 232 w 232"/>
                <a:gd name="T5" fmla="*/ 117 h 234"/>
                <a:gd name="T6" fmla="*/ 116 w 232"/>
                <a:gd name="T7" fmla="*/ 234 h 234"/>
                <a:gd name="T8" fmla="*/ 0 w 232"/>
                <a:gd name="T9" fmla="*/ 234 h 234"/>
                <a:gd name="T10" fmla="*/ 116 w 232"/>
                <a:gd name="T11" fmla="*/ 117 h 234"/>
                <a:gd name="T12" fmla="*/ 0 w 232"/>
                <a:gd name="T13" fmla="*/ 0 h 2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32" h="234">
                  <a:moveTo>
                    <a:pt x="0" y="0"/>
                  </a:moveTo>
                  <a:lnTo>
                    <a:pt x="116" y="0"/>
                  </a:lnTo>
                  <a:lnTo>
                    <a:pt x="232" y="117"/>
                  </a:lnTo>
                  <a:lnTo>
                    <a:pt x="116" y="234"/>
                  </a:lnTo>
                  <a:lnTo>
                    <a:pt x="0" y="234"/>
                  </a:lnTo>
                  <a:lnTo>
                    <a:pt x="116" y="117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22225" cap="flat">
              <a:solidFill>
                <a:srgbClr val="A9D18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41" name="Freeform 61"/>
            <p:cNvSpPr>
              <a:spLocks/>
            </p:cNvSpPr>
            <p:nvPr/>
          </p:nvSpPr>
          <p:spPr bwMode="auto">
            <a:xfrm>
              <a:off x="5944" y="3393"/>
              <a:ext cx="232" cy="234"/>
            </a:xfrm>
            <a:custGeom>
              <a:avLst/>
              <a:gdLst>
                <a:gd name="T0" fmla="*/ 0 w 232"/>
                <a:gd name="T1" fmla="*/ 0 h 234"/>
                <a:gd name="T2" fmla="*/ 116 w 232"/>
                <a:gd name="T3" fmla="*/ 0 h 234"/>
                <a:gd name="T4" fmla="*/ 232 w 232"/>
                <a:gd name="T5" fmla="*/ 117 h 234"/>
                <a:gd name="T6" fmla="*/ 116 w 232"/>
                <a:gd name="T7" fmla="*/ 234 h 234"/>
                <a:gd name="T8" fmla="*/ 0 w 232"/>
                <a:gd name="T9" fmla="*/ 234 h 234"/>
                <a:gd name="T10" fmla="*/ 116 w 232"/>
                <a:gd name="T11" fmla="*/ 117 h 234"/>
                <a:gd name="T12" fmla="*/ 0 w 232"/>
                <a:gd name="T13" fmla="*/ 0 h 2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32" h="234">
                  <a:moveTo>
                    <a:pt x="0" y="0"/>
                  </a:moveTo>
                  <a:lnTo>
                    <a:pt x="116" y="0"/>
                  </a:lnTo>
                  <a:lnTo>
                    <a:pt x="232" y="117"/>
                  </a:lnTo>
                  <a:lnTo>
                    <a:pt x="116" y="234"/>
                  </a:lnTo>
                  <a:lnTo>
                    <a:pt x="0" y="234"/>
                  </a:lnTo>
                  <a:lnTo>
                    <a:pt x="116" y="1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E2F0D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42" name="Freeform 62"/>
            <p:cNvSpPr>
              <a:spLocks/>
            </p:cNvSpPr>
            <p:nvPr/>
          </p:nvSpPr>
          <p:spPr bwMode="auto">
            <a:xfrm>
              <a:off x="5944" y="3393"/>
              <a:ext cx="232" cy="234"/>
            </a:xfrm>
            <a:custGeom>
              <a:avLst/>
              <a:gdLst>
                <a:gd name="T0" fmla="*/ 0 w 232"/>
                <a:gd name="T1" fmla="*/ 0 h 234"/>
                <a:gd name="T2" fmla="*/ 116 w 232"/>
                <a:gd name="T3" fmla="*/ 0 h 234"/>
                <a:gd name="T4" fmla="*/ 232 w 232"/>
                <a:gd name="T5" fmla="*/ 117 h 234"/>
                <a:gd name="T6" fmla="*/ 116 w 232"/>
                <a:gd name="T7" fmla="*/ 234 h 234"/>
                <a:gd name="T8" fmla="*/ 0 w 232"/>
                <a:gd name="T9" fmla="*/ 234 h 234"/>
                <a:gd name="T10" fmla="*/ 116 w 232"/>
                <a:gd name="T11" fmla="*/ 117 h 234"/>
                <a:gd name="T12" fmla="*/ 0 w 232"/>
                <a:gd name="T13" fmla="*/ 0 h 2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32" h="234">
                  <a:moveTo>
                    <a:pt x="0" y="0"/>
                  </a:moveTo>
                  <a:lnTo>
                    <a:pt x="116" y="0"/>
                  </a:lnTo>
                  <a:lnTo>
                    <a:pt x="232" y="117"/>
                  </a:lnTo>
                  <a:lnTo>
                    <a:pt x="116" y="234"/>
                  </a:lnTo>
                  <a:lnTo>
                    <a:pt x="0" y="234"/>
                  </a:lnTo>
                  <a:lnTo>
                    <a:pt x="116" y="117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22225" cap="flat">
              <a:solidFill>
                <a:srgbClr val="A9D18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pic>
          <p:nvPicPr>
            <p:cNvPr id="1095" name="Picture 71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42" y="3177"/>
              <a:ext cx="890" cy="1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97" name="Picture 73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92" y="3177"/>
              <a:ext cx="745" cy="1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99" name="Picture 75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82" y="3271"/>
              <a:ext cx="1048" cy="1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01" name="Picture 77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53" y="3367"/>
              <a:ext cx="1075" cy="1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6" name="Freeform 82"/>
            <p:cNvSpPr>
              <a:spLocks/>
            </p:cNvSpPr>
            <p:nvPr/>
          </p:nvSpPr>
          <p:spPr bwMode="auto">
            <a:xfrm>
              <a:off x="4170" y="589"/>
              <a:ext cx="1076" cy="592"/>
            </a:xfrm>
            <a:custGeom>
              <a:avLst/>
              <a:gdLst>
                <a:gd name="T0" fmla="*/ 0 w 1401"/>
                <a:gd name="T1" fmla="*/ 477 h 953"/>
                <a:gd name="T2" fmla="*/ 700 w 1401"/>
                <a:gd name="T3" fmla="*/ 0 h 953"/>
                <a:gd name="T4" fmla="*/ 1401 w 1401"/>
                <a:gd name="T5" fmla="*/ 477 h 953"/>
                <a:gd name="T6" fmla="*/ 700 w 1401"/>
                <a:gd name="T7" fmla="*/ 953 h 953"/>
                <a:gd name="T8" fmla="*/ 0 w 1401"/>
                <a:gd name="T9" fmla="*/ 477 h 9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01" h="953">
                  <a:moveTo>
                    <a:pt x="0" y="477"/>
                  </a:moveTo>
                  <a:cubicBezTo>
                    <a:pt x="0" y="213"/>
                    <a:pt x="314" y="0"/>
                    <a:pt x="700" y="0"/>
                  </a:cubicBezTo>
                  <a:cubicBezTo>
                    <a:pt x="1088" y="0"/>
                    <a:pt x="1401" y="213"/>
                    <a:pt x="1401" y="477"/>
                  </a:cubicBezTo>
                  <a:cubicBezTo>
                    <a:pt x="1401" y="740"/>
                    <a:pt x="1088" y="953"/>
                    <a:pt x="700" y="953"/>
                  </a:cubicBezTo>
                  <a:cubicBezTo>
                    <a:pt x="314" y="953"/>
                    <a:pt x="0" y="740"/>
                    <a:pt x="0" y="477"/>
                  </a:cubicBezTo>
                </a:path>
              </a:pathLst>
            </a:custGeom>
            <a:solidFill>
              <a:schemeClr val="accent1">
                <a:lumMod val="40000"/>
                <a:lumOff val="60000"/>
              </a:schemeClr>
            </a:solidFill>
            <a:ln w="22225" cap="flat">
              <a:solidFill>
                <a:srgbClr val="0070C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pic>
          <p:nvPicPr>
            <p:cNvPr id="1108" name="Picture 84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04" y="765"/>
              <a:ext cx="526" cy="2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7" name="Freeform 85"/>
            <p:cNvSpPr>
              <a:spLocks noEditPoints="1"/>
            </p:cNvSpPr>
            <p:nvPr/>
          </p:nvSpPr>
          <p:spPr bwMode="auto">
            <a:xfrm>
              <a:off x="2818" y="896"/>
              <a:ext cx="1382" cy="188"/>
            </a:xfrm>
            <a:custGeom>
              <a:avLst/>
              <a:gdLst>
                <a:gd name="T0" fmla="*/ 21 w 935"/>
                <a:gd name="T1" fmla="*/ 153 h 161"/>
                <a:gd name="T2" fmla="*/ 29 w 935"/>
                <a:gd name="T3" fmla="*/ 156 h 161"/>
                <a:gd name="T4" fmla="*/ 28 w 935"/>
                <a:gd name="T5" fmla="*/ 152 h 161"/>
                <a:gd name="T6" fmla="*/ 78 w 935"/>
                <a:gd name="T7" fmla="*/ 148 h 161"/>
                <a:gd name="T8" fmla="*/ 57 w 935"/>
                <a:gd name="T9" fmla="*/ 152 h 161"/>
                <a:gd name="T10" fmla="*/ 104 w 935"/>
                <a:gd name="T11" fmla="*/ 139 h 161"/>
                <a:gd name="T12" fmla="*/ 113 w 935"/>
                <a:gd name="T13" fmla="*/ 142 h 161"/>
                <a:gd name="T14" fmla="*/ 111 w 935"/>
                <a:gd name="T15" fmla="*/ 138 h 161"/>
                <a:gd name="T16" fmla="*/ 162 w 935"/>
                <a:gd name="T17" fmla="*/ 134 h 161"/>
                <a:gd name="T18" fmla="*/ 141 w 935"/>
                <a:gd name="T19" fmla="*/ 138 h 161"/>
                <a:gd name="T20" fmla="*/ 188 w 935"/>
                <a:gd name="T21" fmla="*/ 125 h 161"/>
                <a:gd name="T22" fmla="*/ 197 w 935"/>
                <a:gd name="T23" fmla="*/ 128 h 161"/>
                <a:gd name="T24" fmla="*/ 195 w 935"/>
                <a:gd name="T25" fmla="*/ 124 h 161"/>
                <a:gd name="T26" fmla="*/ 246 w 935"/>
                <a:gd name="T27" fmla="*/ 120 h 161"/>
                <a:gd name="T28" fmla="*/ 225 w 935"/>
                <a:gd name="T29" fmla="*/ 124 h 161"/>
                <a:gd name="T30" fmla="*/ 272 w 935"/>
                <a:gd name="T31" fmla="*/ 111 h 161"/>
                <a:gd name="T32" fmla="*/ 281 w 935"/>
                <a:gd name="T33" fmla="*/ 114 h 161"/>
                <a:gd name="T34" fmla="*/ 279 w 935"/>
                <a:gd name="T35" fmla="*/ 110 h 161"/>
                <a:gd name="T36" fmla="*/ 330 w 935"/>
                <a:gd name="T37" fmla="*/ 106 h 161"/>
                <a:gd name="T38" fmla="*/ 309 w 935"/>
                <a:gd name="T39" fmla="*/ 110 h 161"/>
                <a:gd name="T40" fmla="*/ 356 w 935"/>
                <a:gd name="T41" fmla="*/ 97 h 161"/>
                <a:gd name="T42" fmla="*/ 365 w 935"/>
                <a:gd name="T43" fmla="*/ 100 h 161"/>
                <a:gd name="T44" fmla="*/ 363 w 935"/>
                <a:gd name="T45" fmla="*/ 96 h 161"/>
                <a:gd name="T46" fmla="*/ 414 w 935"/>
                <a:gd name="T47" fmla="*/ 92 h 161"/>
                <a:gd name="T48" fmla="*/ 393 w 935"/>
                <a:gd name="T49" fmla="*/ 96 h 161"/>
                <a:gd name="T50" fmla="*/ 440 w 935"/>
                <a:gd name="T51" fmla="*/ 83 h 161"/>
                <a:gd name="T52" fmla="*/ 448 w 935"/>
                <a:gd name="T53" fmla="*/ 86 h 161"/>
                <a:gd name="T54" fmla="*/ 447 w 935"/>
                <a:gd name="T55" fmla="*/ 82 h 161"/>
                <a:gd name="T56" fmla="*/ 497 w 935"/>
                <a:gd name="T57" fmla="*/ 78 h 161"/>
                <a:gd name="T58" fmla="*/ 476 w 935"/>
                <a:gd name="T59" fmla="*/ 82 h 161"/>
                <a:gd name="T60" fmla="*/ 524 w 935"/>
                <a:gd name="T61" fmla="*/ 69 h 161"/>
                <a:gd name="T62" fmla="*/ 532 w 935"/>
                <a:gd name="T63" fmla="*/ 72 h 161"/>
                <a:gd name="T64" fmla="*/ 531 w 935"/>
                <a:gd name="T65" fmla="*/ 67 h 161"/>
                <a:gd name="T66" fmla="*/ 581 w 935"/>
                <a:gd name="T67" fmla="*/ 64 h 161"/>
                <a:gd name="T68" fmla="*/ 560 w 935"/>
                <a:gd name="T69" fmla="*/ 67 h 161"/>
                <a:gd name="T70" fmla="*/ 607 w 935"/>
                <a:gd name="T71" fmla="*/ 55 h 161"/>
                <a:gd name="T72" fmla="*/ 616 w 935"/>
                <a:gd name="T73" fmla="*/ 58 h 161"/>
                <a:gd name="T74" fmla="*/ 614 w 935"/>
                <a:gd name="T75" fmla="*/ 53 h 161"/>
                <a:gd name="T76" fmla="*/ 665 w 935"/>
                <a:gd name="T77" fmla="*/ 50 h 161"/>
                <a:gd name="T78" fmla="*/ 644 w 935"/>
                <a:gd name="T79" fmla="*/ 53 h 161"/>
                <a:gd name="T80" fmla="*/ 691 w 935"/>
                <a:gd name="T81" fmla="*/ 41 h 161"/>
                <a:gd name="T82" fmla="*/ 700 w 935"/>
                <a:gd name="T83" fmla="*/ 44 h 161"/>
                <a:gd name="T84" fmla="*/ 698 w 935"/>
                <a:gd name="T85" fmla="*/ 39 h 161"/>
                <a:gd name="T86" fmla="*/ 749 w 935"/>
                <a:gd name="T87" fmla="*/ 36 h 161"/>
                <a:gd name="T88" fmla="*/ 728 w 935"/>
                <a:gd name="T89" fmla="*/ 39 h 161"/>
                <a:gd name="T90" fmla="*/ 775 w 935"/>
                <a:gd name="T91" fmla="*/ 27 h 161"/>
                <a:gd name="T92" fmla="*/ 784 w 935"/>
                <a:gd name="T93" fmla="*/ 30 h 161"/>
                <a:gd name="T94" fmla="*/ 782 w 935"/>
                <a:gd name="T95" fmla="*/ 25 h 161"/>
                <a:gd name="T96" fmla="*/ 833 w 935"/>
                <a:gd name="T97" fmla="*/ 22 h 161"/>
                <a:gd name="T98" fmla="*/ 812 w 935"/>
                <a:gd name="T99" fmla="*/ 25 h 161"/>
                <a:gd name="T100" fmla="*/ 859 w 935"/>
                <a:gd name="T101" fmla="*/ 12 h 161"/>
                <a:gd name="T102" fmla="*/ 868 w 935"/>
                <a:gd name="T103" fmla="*/ 16 h 161"/>
                <a:gd name="T104" fmla="*/ 866 w 935"/>
                <a:gd name="T105" fmla="*/ 11 h 161"/>
                <a:gd name="T106" fmla="*/ 916 w 935"/>
                <a:gd name="T107" fmla="*/ 8 h 161"/>
                <a:gd name="T108" fmla="*/ 896 w 935"/>
                <a:gd name="T109" fmla="*/ 11 h 161"/>
                <a:gd name="T110" fmla="*/ 933 w 935"/>
                <a:gd name="T111" fmla="*/ 0 h 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935" h="161">
                  <a:moveTo>
                    <a:pt x="1" y="161"/>
                  </a:moveTo>
                  <a:lnTo>
                    <a:pt x="22" y="158"/>
                  </a:lnTo>
                  <a:lnTo>
                    <a:pt x="21" y="153"/>
                  </a:lnTo>
                  <a:lnTo>
                    <a:pt x="0" y="156"/>
                  </a:lnTo>
                  <a:lnTo>
                    <a:pt x="1" y="161"/>
                  </a:lnTo>
                  <a:close/>
                  <a:moveTo>
                    <a:pt x="29" y="156"/>
                  </a:moveTo>
                  <a:lnTo>
                    <a:pt x="50" y="153"/>
                  </a:lnTo>
                  <a:lnTo>
                    <a:pt x="49" y="148"/>
                  </a:lnTo>
                  <a:lnTo>
                    <a:pt x="28" y="152"/>
                  </a:lnTo>
                  <a:lnTo>
                    <a:pt x="29" y="156"/>
                  </a:lnTo>
                  <a:close/>
                  <a:moveTo>
                    <a:pt x="57" y="152"/>
                  </a:moveTo>
                  <a:lnTo>
                    <a:pt x="78" y="148"/>
                  </a:lnTo>
                  <a:lnTo>
                    <a:pt x="77" y="144"/>
                  </a:lnTo>
                  <a:lnTo>
                    <a:pt x="56" y="147"/>
                  </a:lnTo>
                  <a:lnTo>
                    <a:pt x="57" y="152"/>
                  </a:lnTo>
                  <a:close/>
                  <a:moveTo>
                    <a:pt x="85" y="147"/>
                  </a:moveTo>
                  <a:lnTo>
                    <a:pt x="106" y="144"/>
                  </a:lnTo>
                  <a:lnTo>
                    <a:pt x="104" y="139"/>
                  </a:lnTo>
                  <a:lnTo>
                    <a:pt x="83" y="142"/>
                  </a:lnTo>
                  <a:lnTo>
                    <a:pt x="85" y="147"/>
                  </a:lnTo>
                  <a:close/>
                  <a:moveTo>
                    <a:pt x="113" y="142"/>
                  </a:moveTo>
                  <a:lnTo>
                    <a:pt x="134" y="139"/>
                  </a:lnTo>
                  <a:lnTo>
                    <a:pt x="132" y="134"/>
                  </a:lnTo>
                  <a:lnTo>
                    <a:pt x="111" y="138"/>
                  </a:lnTo>
                  <a:lnTo>
                    <a:pt x="113" y="142"/>
                  </a:lnTo>
                  <a:close/>
                  <a:moveTo>
                    <a:pt x="141" y="138"/>
                  </a:moveTo>
                  <a:lnTo>
                    <a:pt x="162" y="134"/>
                  </a:lnTo>
                  <a:lnTo>
                    <a:pt x="160" y="130"/>
                  </a:lnTo>
                  <a:lnTo>
                    <a:pt x="139" y="133"/>
                  </a:lnTo>
                  <a:lnTo>
                    <a:pt x="141" y="138"/>
                  </a:lnTo>
                  <a:close/>
                  <a:moveTo>
                    <a:pt x="169" y="133"/>
                  </a:moveTo>
                  <a:lnTo>
                    <a:pt x="190" y="130"/>
                  </a:lnTo>
                  <a:lnTo>
                    <a:pt x="188" y="125"/>
                  </a:lnTo>
                  <a:lnTo>
                    <a:pt x="167" y="128"/>
                  </a:lnTo>
                  <a:lnTo>
                    <a:pt x="169" y="133"/>
                  </a:lnTo>
                  <a:close/>
                  <a:moveTo>
                    <a:pt x="197" y="128"/>
                  </a:moveTo>
                  <a:lnTo>
                    <a:pt x="218" y="125"/>
                  </a:lnTo>
                  <a:lnTo>
                    <a:pt x="216" y="120"/>
                  </a:lnTo>
                  <a:lnTo>
                    <a:pt x="195" y="124"/>
                  </a:lnTo>
                  <a:lnTo>
                    <a:pt x="197" y="128"/>
                  </a:lnTo>
                  <a:close/>
                  <a:moveTo>
                    <a:pt x="225" y="124"/>
                  </a:moveTo>
                  <a:lnTo>
                    <a:pt x="246" y="120"/>
                  </a:lnTo>
                  <a:lnTo>
                    <a:pt x="244" y="116"/>
                  </a:lnTo>
                  <a:lnTo>
                    <a:pt x="223" y="119"/>
                  </a:lnTo>
                  <a:lnTo>
                    <a:pt x="225" y="124"/>
                  </a:lnTo>
                  <a:close/>
                  <a:moveTo>
                    <a:pt x="253" y="119"/>
                  </a:moveTo>
                  <a:lnTo>
                    <a:pt x="274" y="115"/>
                  </a:lnTo>
                  <a:lnTo>
                    <a:pt x="272" y="111"/>
                  </a:lnTo>
                  <a:lnTo>
                    <a:pt x="251" y="114"/>
                  </a:lnTo>
                  <a:lnTo>
                    <a:pt x="253" y="119"/>
                  </a:lnTo>
                  <a:close/>
                  <a:moveTo>
                    <a:pt x="281" y="114"/>
                  </a:moveTo>
                  <a:lnTo>
                    <a:pt x="302" y="111"/>
                  </a:lnTo>
                  <a:lnTo>
                    <a:pt x="300" y="106"/>
                  </a:lnTo>
                  <a:lnTo>
                    <a:pt x="279" y="110"/>
                  </a:lnTo>
                  <a:lnTo>
                    <a:pt x="281" y="114"/>
                  </a:lnTo>
                  <a:close/>
                  <a:moveTo>
                    <a:pt x="309" y="110"/>
                  </a:moveTo>
                  <a:lnTo>
                    <a:pt x="330" y="106"/>
                  </a:lnTo>
                  <a:lnTo>
                    <a:pt x="328" y="102"/>
                  </a:lnTo>
                  <a:lnTo>
                    <a:pt x="307" y="105"/>
                  </a:lnTo>
                  <a:lnTo>
                    <a:pt x="309" y="110"/>
                  </a:lnTo>
                  <a:close/>
                  <a:moveTo>
                    <a:pt x="337" y="105"/>
                  </a:moveTo>
                  <a:lnTo>
                    <a:pt x="358" y="101"/>
                  </a:lnTo>
                  <a:lnTo>
                    <a:pt x="356" y="97"/>
                  </a:lnTo>
                  <a:lnTo>
                    <a:pt x="335" y="100"/>
                  </a:lnTo>
                  <a:lnTo>
                    <a:pt x="337" y="105"/>
                  </a:lnTo>
                  <a:close/>
                  <a:moveTo>
                    <a:pt x="365" y="100"/>
                  </a:moveTo>
                  <a:lnTo>
                    <a:pt x="386" y="97"/>
                  </a:lnTo>
                  <a:lnTo>
                    <a:pt x="384" y="92"/>
                  </a:lnTo>
                  <a:lnTo>
                    <a:pt x="363" y="96"/>
                  </a:lnTo>
                  <a:lnTo>
                    <a:pt x="365" y="100"/>
                  </a:lnTo>
                  <a:close/>
                  <a:moveTo>
                    <a:pt x="393" y="96"/>
                  </a:moveTo>
                  <a:lnTo>
                    <a:pt x="414" y="92"/>
                  </a:lnTo>
                  <a:lnTo>
                    <a:pt x="412" y="87"/>
                  </a:lnTo>
                  <a:lnTo>
                    <a:pt x="391" y="91"/>
                  </a:lnTo>
                  <a:lnTo>
                    <a:pt x="393" y="96"/>
                  </a:lnTo>
                  <a:close/>
                  <a:moveTo>
                    <a:pt x="421" y="91"/>
                  </a:moveTo>
                  <a:lnTo>
                    <a:pt x="441" y="87"/>
                  </a:lnTo>
                  <a:lnTo>
                    <a:pt x="440" y="83"/>
                  </a:lnTo>
                  <a:lnTo>
                    <a:pt x="419" y="86"/>
                  </a:lnTo>
                  <a:lnTo>
                    <a:pt x="421" y="91"/>
                  </a:lnTo>
                  <a:close/>
                  <a:moveTo>
                    <a:pt x="448" y="86"/>
                  </a:moveTo>
                  <a:lnTo>
                    <a:pt x="469" y="83"/>
                  </a:lnTo>
                  <a:lnTo>
                    <a:pt x="468" y="78"/>
                  </a:lnTo>
                  <a:lnTo>
                    <a:pt x="447" y="82"/>
                  </a:lnTo>
                  <a:lnTo>
                    <a:pt x="448" y="86"/>
                  </a:lnTo>
                  <a:close/>
                  <a:moveTo>
                    <a:pt x="476" y="82"/>
                  </a:moveTo>
                  <a:lnTo>
                    <a:pt x="497" y="78"/>
                  </a:lnTo>
                  <a:lnTo>
                    <a:pt x="496" y="73"/>
                  </a:lnTo>
                  <a:lnTo>
                    <a:pt x="475" y="77"/>
                  </a:lnTo>
                  <a:lnTo>
                    <a:pt x="476" y="82"/>
                  </a:lnTo>
                  <a:close/>
                  <a:moveTo>
                    <a:pt x="504" y="77"/>
                  </a:moveTo>
                  <a:lnTo>
                    <a:pt x="525" y="73"/>
                  </a:lnTo>
                  <a:lnTo>
                    <a:pt x="524" y="69"/>
                  </a:lnTo>
                  <a:lnTo>
                    <a:pt x="503" y="72"/>
                  </a:lnTo>
                  <a:lnTo>
                    <a:pt x="504" y="77"/>
                  </a:lnTo>
                  <a:close/>
                  <a:moveTo>
                    <a:pt x="532" y="72"/>
                  </a:moveTo>
                  <a:lnTo>
                    <a:pt x="553" y="69"/>
                  </a:lnTo>
                  <a:lnTo>
                    <a:pt x="551" y="64"/>
                  </a:lnTo>
                  <a:lnTo>
                    <a:pt x="531" y="67"/>
                  </a:lnTo>
                  <a:lnTo>
                    <a:pt x="532" y="72"/>
                  </a:lnTo>
                  <a:close/>
                  <a:moveTo>
                    <a:pt x="560" y="67"/>
                  </a:moveTo>
                  <a:lnTo>
                    <a:pt x="581" y="64"/>
                  </a:lnTo>
                  <a:lnTo>
                    <a:pt x="579" y="59"/>
                  </a:lnTo>
                  <a:lnTo>
                    <a:pt x="558" y="63"/>
                  </a:lnTo>
                  <a:lnTo>
                    <a:pt x="560" y="67"/>
                  </a:lnTo>
                  <a:close/>
                  <a:moveTo>
                    <a:pt x="588" y="63"/>
                  </a:moveTo>
                  <a:lnTo>
                    <a:pt x="609" y="59"/>
                  </a:lnTo>
                  <a:lnTo>
                    <a:pt x="607" y="55"/>
                  </a:lnTo>
                  <a:lnTo>
                    <a:pt x="586" y="58"/>
                  </a:lnTo>
                  <a:lnTo>
                    <a:pt x="588" y="63"/>
                  </a:lnTo>
                  <a:close/>
                  <a:moveTo>
                    <a:pt x="616" y="58"/>
                  </a:moveTo>
                  <a:lnTo>
                    <a:pt x="637" y="55"/>
                  </a:lnTo>
                  <a:lnTo>
                    <a:pt x="635" y="50"/>
                  </a:lnTo>
                  <a:lnTo>
                    <a:pt x="614" y="53"/>
                  </a:lnTo>
                  <a:lnTo>
                    <a:pt x="616" y="58"/>
                  </a:lnTo>
                  <a:close/>
                  <a:moveTo>
                    <a:pt x="644" y="53"/>
                  </a:moveTo>
                  <a:lnTo>
                    <a:pt x="665" y="50"/>
                  </a:lnTo>
                  <a:lnTo>
                    <a:pt x="663" y="45"/>
                  </a:lnTo>
                  <a:lnTo>
                    <a:pt x="642" y="49"/>
                  </a:lnTo>
                  <a:lnTo>
                    <a:pt x="644" y="53"/>
                  </a:lnTo>
                  <a:close/>
                  <a:moveTo>
                    <a:pt x="672" y="49"/>
                  </a:moveTo>
                  <a:lnTo>
                    <a:pt x="693" y="45"/>
                  </a:lnTo>
                  <a:lnTo>
                    <a:pt x="691" y="41"/>
                  </a:lnTo>
                  <a:lnTo>
                    <a:pt x="670" y="44"/>
                  </a:lnTo>
                  <a:lnTo>
                    <a:pt x="672" y="49"/>
                  </a:lnTo>
                  <a:close/>
                  <a:moveTo>
                    <a:pt x="700" y="44"/>
                  </a:moveTo>
                  <a:lnTo>
                    <a:pt x="721" y="41"/>
                  </a:lnTo>
                  <a:lnTo>
                    <a:pt x="719" y="36"/>
                  </a:lnTo>
                  <a:lnTo>
                    <a:pt x="698" y="39"/>
                  </a:lnTo>
                  <a:lnTo>
                    <a:pt x="700" y="44"/>
                  </a:lnTo>
                  <a:close/>
                  <a:moveTo>
                    <a:pt x="728" y="39"/>
                  </a:moveTo>
                  <a:lnTo>
                    <a:pt x="749" y="36"/>
                  </a:lnTo>
                  <a:lnTo>
                    <a:pt x="747" y="31"/>
                  </a:lnTo>
                  <a:lnTo>
                    <a:pt x="726" y="35"/>
                  </a:lnTo>
                  <a:lnTo>
                    <a:pt x="728" y="39"/>
                  </a:lnTo>
                  <a:close/>
                  <a:moveTo>
                    <a:pt x="756" y="35"/>
                  </a:moveTo>
                  <a:lnTo>
                    <a:pt x="777" y="31"/>
                  </a:lnTo>
                  <a:lnTo>
                    <a:pt x="775" y="27"/>
                  </a:lnTo>
                  <a:lnTo>
                    <a:pt x="754" y="30"/>
                  </a:lnTo>
                  <a:lnTo>
                    <a:pt x="756" y="35"/>
                  </a:lnTo>
                  <a:close/>
                  <a:moveTo>
                    <a:pt x="784" y="30"/>
                  </a:moveTo>
                  <a:lnTo>
                    <a:pt x="805" y="26"/>
                  </a:lnTo>
                  <a:lnTo>
                    <a:pt x="803" y="22"/>
                  </a:lnTo>
                  <a:lnTo>
                    <a:pt x="782" y="25"/>
                  </a:lnTo>
                  <a:lnTo>
                    <a:pt x="784" y="30"/>
                  </a:lnTo>
                  <a:close/>
                  <a:moveTo>
                    <a:pt x="812" y="25"/>
                  </a:moveTo>
                  <a:lnTo>
                    <a:pt x="833" y="22"/>
                  </a:lnTo>
                  <a:lnTo>
                    <a:pt x="831" y="17"/>
                  </a:lnTo>
                  <a:lnTo>
                    <a:pt x="810" y="21"/>
                  </a:lnTo>
                  <a:lnTo>
                    <a:pt x="812" y="25"/>
                  </a:lnTo>
                  <a:close/>
                  <a:moveTo>
                    <a:pt x="840" y="21"/>
                  </a:moveTo>
                  <a:lnTo>
                    <a:pt x="861" y="17"/>
                  </a:lnTo>
                  <a:lnTo>
                    <a:pt x="859" y="12"/>
                  </a:lnTo>
                  <a:lnTo>
                    <a:pt x="838" y="16"/>
                  </a:lnTo>
                  <a:lnTo>
                    <a:pt x="840" y="21"/>
                  </a:lnTo>
                  <a:close/>
                  <a:moveTo>
                    <a:pt x="868" y="16"/>
                  </a:moveTo>
                  <a:lnTo>
                    <a:pt x="889" y="12"/>
                  </a:lnTo>
                  <a:lnTo>
                    <a:pt x="887" y="8"/>
                  </a:lnTo>
                  <a:lnTo>
                    <a:pt x="866" y="11"/>
                  </a:lnTo>
                  <a:lnTo>
                    <a:pt x="868" y="16"/>
                  </a:lnTo>
                  <a:close/>
                  <a:moveTo>
                    <a:pt x="896" y="11"/>
                  </a:moveTo>
                  <a:lnTo>
                    <a:pt x="916" y="8"/>
                  </a:lnTo>
                  <a:lnTo>
                    <a:pt x="915" y="3"/>
                  </a:lnTo>
                  <a:lnTo>
                    <a:pt x="894" y="7"/>
                  </a:lnTo>
                  <a:lnTo>
                    <a:pt x="896" y="11"/>
                  </a:lnTo>
                  <a:close/>
                  <a:moveTo>
                    <a:pt x="923" y="7"/>
                  </a:moveTo>
                  <a:lnTo>
                    <a:pt x="935" y="5"/>
                  </a:lnTo>
                  <a:lnTo>
                    <a:pt x="933" y="0"/>
                  </a:lnTo>
                  <a:lnTo>
                    <a:pt x="922" y="2"/>
                  </a:lnTo>
                  <a:lnTo>
                    <a:pt x="923" y="7"/>
                  </a:lnTo>
                  <a:close/>
                </a:path>
              </a:pathLst>
            </a:custGeom>
            <a:solidFill>
              <a:srgbClr val="DBDBDB"/>
            </a:solidFill>
            <a:ln w="0" cap="flat">
              <a:solidFill>
                <a:srgbClr val="DBDBD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48" name="Freeform 86"/>
            <p:cNvSpPr>
              <a:spLocks noEditPoints="1"/>
            </p:cNvSpPr>
            <p:nvPr/>
          </p:nvSpPr>
          <p:spPr bwMode="auto">
            <a:xfrm>
              <a:off x="2816" y="949"/>
              <a:ext cx="1372" cy="526"/>
            </a:xfrm>
            <a:custGeom>
              <a:avLst/>
              <a:gdLst>
                <a:gd name="T0" fmla="*/ 0 w 938"/>
                <a:gd name="T1" fmla="*/ 547 h 551"/>
                <a:gd name="T2" fmla="*/ 38 w 938"/>
                <a:gd name="T3" fmla="*/ 525 h 551"/>
                <a:gd name="T4" fmla="*/ 64 w 938"/>
                <a:gd name="T5" fmla="*/ 516 h 551"/>
                <a:gd name="T6" fmla="*/ 70 w 938"/>
                <a:gd name="T7" fmla="*/ 513 h 551"/>
                <a:gd name="T8" fmla="*/ 70 w 938"/>
                <a:gd name="T9" fmla="*/ 513 h 551"/>
                <a:gd name="T10" fmla="*/ 87 w 938"/>
                <a:gd name="T11" fmla="*/ 497 h 551"/>
                <a:gd name="T12" fmla="*/ 124 w 938"/>
                <a:gd name="T13" fmla="*/ 475 h 551"/>
                <a:gd name="T14" fmla="*/ 151 w 938"/>
                <a:gd name="T15" fmla="*/ 466 h 551"/>
                <a:gd name="T16" fmla="*/ 156 w 938"/>
                <a:gd name="T17" fmla="*/ 462 h 551"/>
                <a:gd name="T18" fmla="*/ 156 w 938"/>
                <a:gd name="T19" fmla="*/ 462 h 551"/>
                <a:gd name="T20" fmla="*/ 173 w 938"/>
                <a:gd name="T21" fmla="*/ 446 h 551"/>
                <a:gd name="T22" fmla="*/ 211 w 938"/>
                <a:gd name="T23" fmla="*/ 424 h 551"/>
                <a:gd name="T24" fmla="*/ 237 w 938"/>
                <a:gd name="T25" fmla="*/ 415 h 551"/>
                <a:gd name="T26" fmla="*/ 242 w 938"/>
                <a:gd name="T27" fmla="*/ 412 h 551"/>
                <a:gd name="T28" fmla="*/ 242 w 938"/>
                <a:gd name="T29" fmla="*/ 412 h 551"/>
                <a:gd name="T30" fmla="*/ 259 w 938"/>
                <a:gd name="T31" fmla="*/ 395 h 551"/>
                <a:gd name="T32" fmla="*/ 297 w 938"/>
                <a:gd name="T33" fmla="*/ 373 h 551"/>
                <a:gd name="T34" fmla="*/ 323 w 938"/>
                <a:gd name="T35" fmla="*/ 364 h 551"/>
                <a:gd name="T36" fmla="*/ 329 w 938"/>
                <a:gd name="T37" fmla="*/ 361 h 551"/>
                <a:gd name="T38" fmla="*/ 329 w 938"/>
                <a:gd name="T39" fmla="*/ 361 h 551"/>
                <a:gd name="T40" fmla="*/ 345 w 938"/>
                <a:gd name="T41" fmla="*/ 345 h 551"/>
                <a:gd name="T42" fmla="*/ 383 w 938"/>
                <a:gd name="T43" fmla="*/ 323 h 551"/>
                <a:gd name="T44" fmla="*/ 409 w 938"/>
                <a:gd name="T45" fmla="*/ 314 h 551"/>
                <a:gd name="T46" fmla="*/ 415 w 938"/>
                <a:gd name="T47" fmla="*/ 310 h 551"/>
                <a:gd name="T48" fmla="*/ 415 w 938"/>
                <a:gd name="T49" fmla="*/ 310 h 551"/>
                <a:gd name="T50" fmla="*/ 432 w 938"/>
                <a:gd name="T51" fmla="*/ 294 h 551"/>
                <a:gd name="T52" fmla="*/ 469 w 938"/>
                <a:gd name="T53" fmla="*/ 272 h 551"/>
                <a:gd name="T54" fmla="*/ 496 w 938"/>
                <a:gd name="T55" fmla="*/ 263 h 551"/>
                <a:gd name="T56" fmla="*/ 501 w 938"/>
                <a:gd name="T57" fmla="*/ 260 h 551"/>
                <a:gd name="T58" fmla="*/ 501 w 938"/>
                <a:gd name="T59" fmla="*/ 260 h 551"/>
                <a:gd name="T60" fmla="*/ 518 w 938"/>
                <a:gd name="T61" fmla="*/ 243 h 551"/>
                <a:gd name="T62" fmla="*/ 556 w 938"/>
                <a:gd name="T63" fmla="*/ 221 h 551"/>
                <a:gd name="T64" fmla="*/ 582 w 938"/>
                <a:gd name="T65" fmla="*/ 212 h 551"/>
                <a:gd name="T66" fmla="*/ 588 w 938"/>
                <a:gd name="T67" fmla="*/ 209 h 551"/>
                <a:gd name="T68" fmla="*/ 588 w 938"/>
                <a:gd name="T69" fmla="*/ 209 h 551"/>
                <a:gd name="T70" fmla="*/ 604 w 938"/>
                <a:gd name="T71" fmla="*/ 193 h 551"/>
                <a:gd name="T72" fmla="*/ 642 w 938"/>
                <a:gd name="T73" fmla="*/ 171 h 551"/>
                <a:gd name="T74" fmla="*/ 668 w 938"/>
                <a:gd name="T75" fmla="*/ 162 h 551"/>
                <a:gd name="T76" fmla="*/ 674 w 938"/>
                <a:gd name="T77" fmla="*/ 158 h 551"/>
                <a:gd name="T78" fmla="*/ 674 w 938"/>
                <a:gd name="T79" fmla="*/ 158 h 551"/>
                <a:gd name="T80" fmla="*/ 691 w 938"/>
                <a:gd name="T81" fmla="*/ 142 h 551"/>
                <a:gd name="T82" fmla="*/ 728 w 938"/>
                <a:gd name="T83" fmla="*/ 120 h 551"/>
                <a:gd name="T84" fmla="*/ 755 w 938"/>
                <a:gd name="T85" fmla="*/ 111 h 551"/>
                <a:gd name="T86" fmla="*/ 760 w 938"/>
                <a:gd name="T87" fmla="*/ 108 h 551"/>
                <a:gd name="T88" fmla="*/ 760 w 938"/>
                <a:gd name="T89" fmla="*/ 108 h 551"/>
                <a:gd name="T90" fmla="*/ 777 w 938"/>
                <a:gd name="T91" fmla="*/ 92 h 551"/>
                <a:gd name="T92" fmla="*/ 815 w 938"/>
                <a:gd name="T93" fmla="*/ 69 h 551"/>
                <a:gd name="T94" fmla="*/ 841 w 938"/>
                <a:gd name="T95" fmla="*/ 60 h 551"/>
                <a:gd name="T96" fmla="*/ 846 w 938"/>
                <a:gd name="T97" fmla="*/ 57 h 551"/>
                <a:gd name="T98" fmla="*/ 846 w 938"/>
                <a:gd name="T99" fmla="*/ 57 h 551"/>
                <a:gd name="T100" fmla="*/ 863 w 938"/>
                <a:gd name="T101" fmla="*/ 41 h 551"/>
                <a:gd name="T102" fmla="*/ 901 w 938"/>
                <a:gd name="T103" fmla="*/ 19 h 551"/>
                <a:gd name="T104" fmla="*/ 927 w 938"/>
                <a:gd name="T105" fmla="*/ 10 h 551"/>
                <a:gd name="T106" fmla="*/ 933 w 938"/>
                <a:gd name="T107" fmla="*/ 6 h 551"/>
                <a:gd name="T108" fmla="*/ 933 w 938"/>
                <a:gd name="T109" fmla="*/ 6 h 5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938" h="551">
                  <a:moveTo>
                    <a:pt x="5" y="551"/>
                  </a:moveTo>
                  <a:lnTo>
                    <a:pt x="21" y="541"/>
                  </a:lnTo>
                  <a:lnTo>
                    <a:pt x="16" y="538"/>
                  </a:lnTo>
                  <a:lnTo>
                    <a:pt x="0" y="547"/>
                  </a:lnTo>
                  <a:lnTo>
                    <a:pt x="5" y="551"/>
                  </a:lnTo>
                  <a:close/>
                  <a:moveTo>
                    <a:pt x="27" y="538"/>
                  </a:moveTo>
                  <a:lnTo>
                    <a:pt x="43" y="529"/>
                  </a:lnTo>
                  <a:lnTo>
                    <a:pt x="38" y="525"/>
                  </a:lnTo>
                  <a:lnTo>
                    <a:pt x="22" y="535"/>
                  </a:lnTo>
                  <a:lnTo>
                    <a:pt x="27" y="538"/>
                  </a:lnTo>
                  <a:close/>
                  <a:moveTo>
                    <a:pt x="48" y="526"/>
                  </a:moveTo>
                  <a:lnTo>
                    <a:pt x="64" y="516"/>
                  </a:lnTo>
                  <a:lnTo>
                    <a:pt x="59" y="513"/>
                  </a:lnTo>
                  <a:lnTo>
                    <a:pt x="43" y="522"/>
                  </a:lnTo>
                  <a:lnTo>
                    <a:pt x="48" y="526"/>
                  </a:lnTo>
                  <a:close/>
                  <a:moveTo>
                    <a:pt x="70" y="513"/>
                  </a:moveTo>
                  <a:lnTo>
                    <a:pt x="86" y="503"/>
                  </a:lnTo>
                  <a:lnTo>
                    <a:pt x="81" y="500"/>
                  </a:lnTo>
                  <a:lnTo>
                    <a:pt x="65" y="509"/>
                  </a:lnTo>
                  <a:lnTo>
                    <a:pt x="70" y="513"/>
                  </a:lnTo>
                  <a:close/>
                  <a:moveTo>
                    <a:pt x="91" y="500"/>
                  </a:moveTo>
                  <a:lnTo>
                    <a:pt x="107" y="491"/>
                  </a:lnTo>
                  <a:lnTo>
                    <a:pt x="103" y="487"/>
                  </a:lnTo>
                  <a:lnTo>
                    <a:pt x="87" y="497"/>
                  </a:lnTo>
                  <a:lnTo>
                    <a:pt x="91" y="500"/>
                  </a:lnTo>
                  <a:close/>
                  <a:moveTo>
                    <a:pt x="113" y="488"/>
                  </a:moveTo>
                  <a:lnTo>
                    <a:pt x="129" y="478"/>
                  </a:lnTo>
                  <a:lnTo>
                    <a:pt x="124" y="475"/>
                  </a:lnTo>
                  <a:lnTo>
                    <a:pt x="108" y="484"/>
                  </a:lnTo>
                  <a:lnTo>
                    <a:pt x="113" y="488"/>
                  </a:lnTo>
                  <a:close/>
                  <a:moveTo>
                    <a:pt x="134" y="475"/>
                  </a:moveTo>
                  <a:lnTo>
                    <a:pt x="151" y="466"/>
                  </a:lnTo>
                  <a:lnTo>
                    <a:pt x="146" y="462"/>
                  </a:lnTo>
                  <a:lnTo>
                    <a:pt x="130" y="471"/>
                  </a:lnTo>
                  <a:lnTo>
                    <a:pt x="134" y="475"/>
                  </a:lnTo>
                  <a:close/>
                  <a:moveTo>
                    <a:pt x="156" y="462"/>
                  </a:moveTo>
                  <a:lnTo>
                    <a:pt x="172" y="453"/>
                  </a:lnTo>
                  <a:lnTo>
                    <a:pt x="167" y="449"/>
                  </a:lnTo>
                  <a:lnTo>
                    <a:pt x="151" y="459"/>
                  </a:lnTo>
                  <a:lnTo>
                    <a:pt x="156" y="462"/>
                  </a:lnTo>
                  <a:close/>
                  <a:moveTo>
                    <a:pt x="178" y="450"/>
                  </a:moveTo>
                  <a:lnTo>
                    <a:pt x="194" y="440"/>
                  </a:lnTo>
                  <a:lnTo>
                    <a:pt x="189" y="437"/>
                  </a:lnTo>
                  <a:lnTo>
                    <a:pt x="173" y="446"/>
                  </a:lnTo>
                  <a:lnTo>
                    <a:pt x="178" y="450"/>
                  </a:lnTo>
                  <a:close/>
                  <a:moveTo>
                    <a:pt x="199" y="437"/>
                  </a:moveTo>
                  <a:lnTo>
                    <a:pt x="215" y="427"/>
                  </a:lnTo>
                  <a:lnTo>
                    <a:pt x="211" y="424"/>
                  </a:lnTo>
                  <a:lnTo>
                    <a:pt x="194" y="433"/>
                  </a:lnTo>
                  <a:lnTo>
                    <a:pt x="199" y="437"/>
                  </a:lnTo>
                  <a:close/>
                  <a:moveTo>
                    <a:pt x="221" y="424"/>
                  </a:moveTo>
                  <a:lnTo>
                    <a:pt x="237" y="415"/>
                  </a:lnTo>
                  <a:lnTo>
                    <a:pt x="232" y="411"/>
                  </a:lnTo>
                  <a:lnTo>
                    <a:pt x="216" y="421"/>
                  </a:lnTo>
                  <a:lnTo>
                    <a:pt x="221" y="424"/>
                  </a:lnTo>
                  <a:close/>
                  <a:moveTo>
                    <a:pt x="242" y="412"/>
                  </a:moveTo>
                  <a:lnTo>
                    <a:pt x="259" y="402"/>
                  </a:lnTo>
                  <a:lnTo>
                    <a:pt x="254" y="399"/>
                  </a:lnTo>
                  <a:lnTo>
                    <a:pt x="238" y="408"/>
                  </a:lnTo>
                  <a:lnTo>
                    <a:pt x="242" y="412"/>
                  </a:lnTo>
                  <a:close/>
                  <a:moveTo>
                    <a:pt x="264" y="399"/>
                  </a:moveTo>
                  <a:lnTo>
                    <a:pt x="280" y="389"/>
                  </a:lnTo>
                  <a:lnTo>
                    <a:pt x="275" y="386"/>
                  </a:lnTo>
                  <a:lnTo>
                    <a:pt x="259" y="395"/>
                  </a:lnTo>
                  <a:lnTo>
                    <a:pt x="264" y="399"/>
                  </a:lnTo>
                  <a:close/>
                  <a:moveTo>
                    <a:pt x="285" y="386"/>
                  </a:moveTo>
                  <a:lnTo>
                    <a:pt x="302" y="377"/>
                  </a:lnTo>
                  <a:lnTo>
                    <a:pt x="297" y="373"/>
                  </a:lnTo>
                  <a:lnTo>
                    <a:pt x="281" y="383"/>
                  </a:lnTo>
                  <a:lnTo>
                    <a:pt x="285" y="386"/>
                  </a:lnTo>
                  <a:close/>
                  <a:moveTo>
                    <a:pt x="307" y="374"/>
                  </a:moveTo>
                  <a:lnTo>
                    <a:pt x="323" y="364"/>
                  </a:lnTo>
                  <a:lnTo>
                    <a:pt x="318" y="361"/>
                  </a:lnTo>
                  <a:lnTo>
                    <a:pt x="302" y="370"/>
                  </a:lnTo>
                  <a:lnTo>
                    <a:pt x="307" y="374"/>
                  </a:lnTo>
                  <a:close/>
                  <a:moveTo>
                    <a:pt x="329" y="361"/>
                  </a:moveTo>
                  <a:lnTo>
                    <a:pt x="345" y="352"/>
                  </a:lnTo>
                  <a:lnTo>
                    <a:pt x="340" y="348"/>
                  </a:lnTo>
                  <a:lnTo>
                    <a:pt x="324" y="357"/>
                  </a:lnTo>
                  <a:lnTo>
                    <a:pt x="329" y="361"/>
                  </a:lnTo>
                  <a:close/>
                  <a:moveTo>
                    <a:pt x="350" y="348"/>
                  </a:moveTo>
                  <a:lnTo>
                    <a:pt x="366" y="339"/>
                  </a:lnTo>
                  <a:lnTo>
                    <a:pt x="362" y="335"/>
                  </a:lnTo>
                  <a:lnTo>
                    <a:pt x="345" y="345"/>
                  </a:lnTo>
                  <a:lnTo>
                    <a:pt x="350" y="348"/>
                  </a:lnTo>
                  <a:close/>
                  <a:moveTo>
                    <a:pt x="372" y="336"/>
                  </a:moveTo>
                  <a:lnTo>
                    <a:pt x="388" y="326"/>
                  </a:lnTo>
                  <a:lnTo>
                    <a:pt x="383" y="323"/>
                  </a:lnTo>
                  <a:lnTo>
                    <a:pt x="367" y="332"/>
                  </a:lnTo>
                  <a:lnTo>
                    <a:pt x="372" y="336"/>
                  </a:lnTo>
                  <a:close/>
                  <a:moveTo>
                    <a:pt x="393" y="323"/>
                  </a:moveTo>
                  <a:lnTo>
                    <a:pt x="409" y="314"/>
                  </a:lnTo>
                  <a:lnTo>
                    <a:pt x="405" y="310"/>
                  </a:lnTo>
                  <a:lnTo>
                    <a:pt x="389" y="319"/>
                  </a:lnTo>
                  <a:lnTo>
                    <a:pt x="393" y="323"/>
                  </a:lnTo>
                  <a:close/>
                  <a:moveTo>
                    <a:pt x="415" y="310"/>
                  </a:moveTo>
                  <a:lnTo>
                    <a:pt x="431" y="301"/>
                  </a:lnTo>
                  <a:lnTo>
                    <a:pt x="426" y="297"/>
                  </a:lnTo>
                  <a:lnTo>
                    <a:pt x="410" y="307"/>
                  </a:lnTo>
                  <a:lnTo>
                    <a:pt x="415" y="310"/>
                  </a:lnTo>
                  <a:close/>
                  <a:moveTo>
                    <a:pt x="437" y="298"/>
                  </a:moveTo>
                  <a:lnTo>
                    <a:pt x="453" y="288"/>
                  </a:lnTo>
                  <a:lnTo>
                    <a:pt x="448" y="285"/>
                  </a:lnTo>
                  <a:lnTo>
                    <a:pt x="432" y="294"/>
                  </a:lnTo>
                  <a:lnTo>
                    <a:pt x="437" y="298"/>
                  </a:lnTo>
                  <a:close/>
                  <a:moveTo>
                    <a:pt x="458" y="285"/>
                  </a:moveTo>
                  <a:lnTo>
                    <a:pt x="474" y="276"/>
                  </a:lnTo>
                  <a:lnTo>
                    <a:pt x="469" y="272"/>
                  </a:lnTo>
                  <a:lnTo>
                    <a:pt x="453" y="281"/>
                  </a:lnTo>
                  <a:lnTo>
                    <a:pt x="458" y="285"/>
                  </a:lnTo>
                  <a:close/>
                  <a:moveTo>
                    <a:pt x="480" y="272"/>
                  </a:moveTo>
                  <a:lnTo>
                    <a:pt x="496" y="263"/>
                  </a:lnTo>
                  <a:lnTo>
                    <a:pt x="491" y="259"/>
                  </a:lnTo>
                  <a:lnTo>
                    <a:pt x="475" y="269"/>
                  </a:lnTo>
                  <a:lnTo>
                    <a:pt x="480" y="272"/>
                  </a:lnTo>
                  <a:close/>
                  <a:moveTo>
                    <a:pt x="501" y="260"/>
                  </a:moveTo>
                  <a:lnTo>
                    <a:pt x="517" y="250"/>
                  </a:lnTo>
                  <a:lnTo>
                    <a:pt x="513" y="247"/>
                  </a:lnTo>
                  <a:lnTo>
                    <a:pt x="496" y="256"/>
                  </a:lnTo>
                  <a:lnTo>
                    <a:pt x="501" y="260"/>
                  </a:lnTo>
                  <a:close/>
                  <a:moveTo>
                    <a:pt x="523" y="247"/>
                  </a:moveTo>
                  <a:lnTo>
                    <a:pt x="539" y="238"/>
                  </a:lnTo>
                  <a:lnTo>
                    <a:pt x="534" y="234"/>
                  </a:lnTo>
                  <a:lnTo>
                    <a:pt x="518" y="243"/>
                  </a:lnTo>
                  <a:lnTo>
                    <a:pt x="523" y="247"/>
                  </a:lnTo>
                  <a:close/>
                  <a:moveTo>
                    <a:pt x="544" y="234"/>
                  </a:moveTo>
                  <a:lnTo>
                    <a:pt x="561" y="225"/>
                  </a:lnTo>
                  <a:lnTo>
                    <a:pt x="556" y="221"/>
                  </a:lnTo>
                  <a:lnTo>
                    <a:pt x="540" y="231"/>
                  </a:lnTo>
                  <a:lnTo>
                    <a:pt x="544" y="234"/>
                  </a:lnTo>
                  <a:close/>
                  <a:moveTo>
                    <a:pt x="566" y="222"/>
                  </a:moveTo>
                  <a:lnTo>
                    <a:pt x="582" y="212"/>
                  </a:lnTo>
                  <a:lnTo>
                    <a:pt x="577" y="209"/>
                  </a:lnTo>
                  <a:lnTo>
                    <a:pt x="561" y="218"/>
                  </a:lnTo>
                  <a:lnTo>
                    <a:pt x="566" y="222"/>
                  </a:lnTo>
                  <a:close/>
                  <a:moveTo>
                    <a:pt x="588" y="209"/>
                  </a:moveTo>
                  <a:lnTo>
                    <a:pt x="604" y="200"/>
                  </a:lnTo>
                  <a:lnTo>
                    <a:pt x="599" y="196"/>
                  </a:lnTo>
                  <a:lnTo>
                    <a:pt x="583" y="205"/>
                  </a:lnTo>
                  <a:lnTo>
                    <a:pt x="588" y="209"/>
                  </a:lnTo>
                  <a:close/>
                  <a:moveTo>
                    <a:pt x="609" y="196"/>
                  </a:moveTo>
                  <a:lnTo>
                    <a:pt x="625" y="187"/>
                  </a:lnTo>
                  <a:lnTo>
                    <a:pt x="621" y="183"/>
                  </a:lnTo>
                  <a:lnTo>
                    <a:pt x="604" y="193"/>
                  </a:lnTo>
                  <a:lnTo>
                    <a:pt x="609" y="196"/>
                  </a:lnTo>
                  <a:close/>
                  <a:moveTo>
                    <a:pt x="631" y="184"/>
                  </a:moveTo>
                  <a:lnTo>
                    <a:pt x="647" y="174"/>
                  </a:lnTo>
                  <a:lnTo>
                    <a:pt x="642" y="171"/>
                  </a:lnTo>
                  <a:lnTo>
                    <a:pt x="626" y="180"/>
                  </a:lnTo>
                  <a:lnTo>
                    <a:pt x="631" y="184"/>
                  </a:lnTo>
                  <a:close/>
                  <a:moveTo>
                    <a:pt x="652" y="171"/>
                  </a:moveTo>
                  <a:lnTo>
                    <a:pt x="668" y="162"/>
                  </a:lnTo>
                  <a:lnTo>
                    <a:pt x="664" y="158"/>
                  </a:lnTo>
                  <a:lnTo>
                    <a:pt x="647" y="168"/>
                  </a:lnTo>
                  <a:lnTo>
                    <a:pt x="652" y="171"/>
                  </a:lnTo>
                  <a:close/>
                  <a:moveTo>
                    <a:pt x="674" y="158"/>
                  </a:moveTo>
                  <a:lnTo>
                    <a:pt x="690" y="149"/>
                  </a:lnTo>
                  <a:lnTo>
                    <a:pt x="685" y="145"/>
                  </a:lnTo>
                  <a:lnTo>
                    <a:pt x="669" y="155"/>
                  </a:lnTo>
                  <a:lnTo>
                    <a:pt x="674" y="158"/>
                  </a:lnTo>
                  <a:close/>
                  <a:moveTo>
                    <a:pt x="695" y="146"/>
                  </a:moveTo>
                  <a:lnTo>
                    <a:pt x="712" y="136"/>
                  </a:lnTo>
                  <a:lnTo>
                    <a:pt x="707" y="133"/>
                  </a:lnTo>
                  <a:lnTo>
                    <a:pt x="691" y="142"/>
                  </a:lnTo>
                  <a:lnTo>
                    <a:pt x="695" y="146"/>
                  </a:lnTo>
                  <a:close/>
                  <a:moveTo>
                    <a:pt x="717" y="133"/>
                  </a:moveTo>
                  <a:lnTo>
                    <a:pt x="733" y="124"/>
                  </a:lnTo>
                  <a:lnTo>
                    <a:pt x="728" y="120"/>
                  </a:lnTo>
                  <a:lnTo>
                    <a:pt x="712" y="130"/>
                  </a:lnTo>
                  <a:lnTo>
                    <a:pt x="717" y="133"/>
                  </a:lnTo>
                  <a:close/>
                  <a:moveTo>
                    <a:pt x="739" y="120"/>
                  </a:moveTo>
                  <a:lnTo>
                    <a:pt x="755" y="111"/>
                  </a:lnTo>
                  <a:lnTo>
                    <a:pt x="750" y="107"/>
                  </a:lnTo>
                  <a:lnTo>
                    <a:pt x="734" y="117"/>
                  </a:lnTo>
                  <a:lnTo>
                    <a:pt x="739" y="120"/>
                  </a:lnTo>
                  <a:close/>
                  <a:moveTo>
                    <a:pt x="760" y="108"/>
                  </a:moveTo>
                  <a:lnTo>
                    <a:pt x="776" y="98"/>
                  </a:lnTo>
                  <a:lnTo>
                    <a:pt x="772" y="95"/>
                  </a:lnTo>
                  <a:lnTo>
                    <a:pt x="755" y="104"/>
                  </a:lnTo>
                  <a:lnTo>
                    <a:pt x="760" y="108"/>
                  </a:lnTo>
                  <a:close/>
                  <a:moveTo>
                    <a:pt x="782" y="95"/>
                  </a:moveTo>
                  <a:lnTo>
                    <a:pt x="798" y="86"/>
                  </a:lnTo>
                  <a:lnTo>
                    <a:pt x="793" y="82"/>
                  </a:lnTo>
                  <a:lnTo>
                    <a:pt x="777" y="92"/>
                  </a:lnTo>
                  <a:lnTo>
                    <a:pt x="782" y="95"/>
                  </a:lnTo>
                  <a:close/>
                  <a:moveTo>
                    <a:pt x="803" y="82"/>
                  </a:moveTo>
                  <a:lnTo>
                    <a:pt x="820" y="73"/>
                  </a:lnTo>
                  <a:lnTo>
                    <a:pt x="815" y="69"/>
                  </a:lnTo>
                  <a:lnTo>
                    <a:pt x="799" y="79"/>
                  </a:lnTo>
                  <a:lnTo>
                    <a:pt x="803" y="82"/>
                  </a:lnTo>
                  <a:close/>
                  <a:moveTo>
                    <a:pt x="825" y="70"/>
                  </a:moveTo>
                  <a:lnTo>
                    <a:pt x="841" y="60"/>
                  </a:lnTo>
                  <a:lnTo>
                    <a:pt x="836" y="57"/>
                  </a:lnTo>
                  <a:lnTo>
                    <a:pt x="820" y="66"/>
                  </a:lnTo>
                  <a:lnTo>
                    <a:pt x="825" y="70"/>
                  </a:lnTo>
                  <a:close/>
                  <a:moveTo>
                    <a:pt x="846" y="57"/>
                  </a:moveTo>
                  <a:lnTo>
                    <a:pt x="863" y="48"/>
                  </a:lnTo>
                  <a:lnTo>
                    <a:pt x="858" y="44"/>
                  </a:lnTo>
                  <a:lnTo>
                    <a:pt x="842" y="54"/>
                  </a:lnTo>
                  <a:lnTo>
                    <a:pt x="846" y="57"/>
                  </a:lnTo>
                  <a:close/>
                  <a:moveTo>
                    <a:pt x="868" y="44"/>
                  </a:moveTo>
                  <a:lnTo>
                    <a:pt x="884" y="35"/>
                  </a:lnTo>
                  <a:lnTo>
                    <a:pt x="879" y="31"/>
                  </a:lnTo>
                  <a:lnTo>
                    <a:pt x="863" y="41"/>
                  </a:lnTo>
                  <a:lnTo>
                    <a:pt x="868" y="44"/>
                  </a:lnTo>
                  <a:close/>
                  <a:moveTo>
                    <a:pt x="890" y="32"/>
                  </a:moveTo>
                  <a:lnTo>
                    <a:pt x="906" y="22"/>
                  </a:lnTo>
                  <a:lnTo>
                    <a:pt x="901" y="19"/>
                  </a:lnTo>
                  <a:lnTo>
                    <a:pt x="885" y="28"/>
                  </a:lnTo>
                  <a:lnTo>
                    <a:pt x="890" y="32"/>
                  </a:lnTo>
                  <a:close/>
                  <a:moveTo>
                    <a:pt x="911" y="19"/>
                  </a:moveTo>
                  <a:lnTo>
                    <a:pt x="927" y="10"/>
                  </a:lnTo>
                  <a:lnTo>
                    <a:pt x="923" y="6"/>
                  </a:lnTo>
                  <a:lnTo>
                    <a:pt x="906" y="16"/>
                  </a:lnTo>
                  <a:lnTo>
                    <a:pt x="911" y="19"/>
                  </a:lnTo>
                  <a:close/>
                  <a:moveTo>
                    <a:pt x="933" y="6"/>
                  </a:moveTo>
                  <a:lnTo>
                    <a:pt x="938" y="3"/>
                  </a:lnTo>
                  <a:lnTo>
                    <a:pt x="934" y="0"/>
                  </a:lnTo>
                  <a:lnTo>
                    <a:pt x="928" y="3"/>
                  </a:lnTo>
                  <a:lnTo>
                    <a:pt x="933" y="6"/>
                  </a:lnTo>
                  <a:close/>
                </a:path>
              </a:pathLst>
            </a:custGeom>
            <a:solidFill>
              <a:srgbClr val="D0CECE"/>
            </a:solidFill>
            <a:ln w="0" cap="flat">
              <a:solidFill>
                <a:srgbClr val="D0CECE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49" name="Freeform 87"/>
            <p:cNvSpPr>
              <a:spLocks noEditPoints="1"/>
            </p:cNvSpPr>
            <p:nvPr/>
          </p:nvSpPr>
          <p:spPr bwMode="auto">
            <a:xfrm>
              <a:off x="2816" y="962"/>
              <a:ext cx="1363" cy="904"/>
            </a:xfrm>
            <a:custGeom>
              <a:avLst/>
              <a:gdLst>
                <a:gd name="T0" fmla="*/ 6 w 937"/>
                <a:gd name="T1" fmla="*/ 940 h 940"/>
                <a:gd name="T2" fmla="*/ 21 w 937"/>
                <a:gd name="T3" fmla="*/ 924 h 940"/>
                <a:gd name="T4" fmla="*/ 37 w 937"/>
                <a:gd name="T5" fmla="*/ 908 h 940"/>
                <a:gd name="T6" fmla="*/ 53 w 937"/>
                <a:gd name="T7" fmla="*/ 892 h 940"/>
                <a:gd name="T8" fmla="*/ 69 w 937"/>
                <a:gd name="T9" fmla="*/ 876 h 940"/>
                <a:gd name="T10" fmla="*/ 85 w 937"/>
                <a:gd name="T11" fmla="*/ 860 h 940"/>
                <a:gd name="T12" fmla="*/ 101 w 937"/>
                <a:gd name="T13" fmla="*/ 844 h 940"/>
                <a:gd name="T14" fmla="*/ 117 w 937"/>
                <a:gd name="T15" fmla="*/ 828 h 940"/>
                <a:gd name="T16" fmla="*/ 132 w 937"/>
                <a:gd name="T17" fmla="*/ 812 h 940"/>
                <a:gd name="T18" fmla="*/ 148 w 937"/>
                <a:gd name="T19" fmla="*/ 796 h 940"/>
                <a:gd name="T20" fmla="*/ 164 w 937"/>
                <a:gd name="T21" fmla="*/ 780 h 940"/>
                <a:gd name="T22" fmla="*/ 180 w 937"/>
                <a:gd name="T23" fmla="*/ 764 h 940"/>
                <a:gd name="T24" fmla="*/ 196 w 937"/>
                <a:gd name="T25" fmla="*/ 748 h 940"/>
                <a:gd name="T26" fmla="*/ 212 w 937"/>
                <a:gd name="T27" fmla="*/ 732 h 940"/>
                <a:gd name="T28" fmla="*/ 228 w 937"/>
                <a:gd name="T29" fmla="*/ 717 h 940"/>
                <a:gd name="T30" fmla="*/ 243 w 937"/>
                <a:gd name="T31" fmla="*/ 701 h 940"/>
                <a:gd name="T32" fmla="*/ 259 w 937"/>
                <a:gd name="T33" fmla="*/ 685 h 940"/>
                <a:gd name="T34" fmla="*/ 275 w 937"/>
                <a:gd name="T35" fmla="*/ 669 h 940"/>
                <a:gd name="T36" fmla="*/ 291 w 937"/>
                <a:gd name="T37" fmla="*/ 653 h 940"/>
                <a:gd name="T38" fmla="*/ 307 w 937"/>
                <a:gd name="T39" fmla="*/ 637 h 940"/>
                <a:gd name="T40" fmla="*/ 323 w 937"/>
                <a:gd name="T41" fmla="*/ 621 h 940"/>
                <a:gd name="T42" fmla="*/ 339 w 937"/>
                <a:gd name="T43" fmla="*/ 605 h 940"/>
                <a:gd name="T44" fmla="*/ 354 w 937"/>
                <a:gd name="T45" fmla="*/ 589 h 940"/>
                <a:gd name="T46" fmla="*/ 370 w 937"/>
                <a:gd name="T47" fmla="*/ 573 h 940"/>
                <a:gd name="T48" fmla="*/ 386 w 937"/>
                <a:gd name="T49" fmla="*/ 557 h 940"/>
                <a:gd name="T50" fmla="*/ 402 w 937"/>
                <a:gd name="T51" fmla="*/ 541 h 940"/>
                <a:gd name="T52" fmla="*/ 418 w 937"/>
                <a:gd name="T53" fmla="*/ 525 h 940"/>
                <a:gd name="T54" fmla="*/ 434 w 937"/>
                <a:gd name="T55" fmla="*/ 509 h 940"/>
                <a:gd name="T56" fmla="*/ 450 w 937"/>
                <a:gd name="T57" fmla="*/ 493 h 940"/>
                <a:gd name="T58" fmla="*/ 465 w 937"/>
                <a:gd name="T59" fmla="*/ 477 h 940"/>
                <a:gd name="T60" fmla="*/ 481 w 937"/>
                <a:gd name="T61" fmla="*/ 461 h 940"/>
                <a:gd name="T62" fmla="*/ 497 w 937"/>
                <a:gd name="T63" fmla="*/ 445 h 940"/>
                <a:gd name="T64" fmla="*/ 513 w 937"/>
                <a:gd name="T65" fmla="*/ 429 h 940"/>
                <a:gd name="T66" fmla="*/ 529 w 937"/>
                <a:gd name="T67" fmla="*/ 413 h 940"/>
                <a:gd name="T68" fmla="*/ 545 w 937"/>
                <a:gd name="T69" fmla="*/ 397 h 940"/>
                <a:gd name="T70" fmla="*/ 560 w 937"/>
                <a:gd name="T71" fmla="*/ 382 h 940"/>
                <a:gd name="T72" fmla="*/ 576 w 937"/>
                <a:gd name="T73" fmla="*/ 366 h 940"/>
                <a:gd name="T74" fmla="*/ 592 w 937"/>
                <a:gd name="T75" fmla="*/ 350 h 940"/>
                <a:gd name="T76" fmla="*/ 608 w 937"/>
                <a:gd name="T77" fmla="*/ 334 h 940"/>
                <a:gd name="T78" fmla="*/ 624 w 937"/>
                <a:gd name="T79" fmla="*/ 318 h 940"/>
                <a:gd name="T80" fmla="*/ 640 w 937"/>
                <a:gd name="T81" fmla="*/ 302 h 940"/>
                <a:gd name="T82" fmla="*/ 656 w 937"/>
                <a:gd name="T83" fmla="*/ 286 h 940"/>
                <a:gd name="T84" fmla="*/ 671 w 937"/>
                <a:gd name="T85" fmla="*/ 270 h 940"/>
                <a:gd name="T86" fmla="*/ 687 w 937"/>
                <a:gd name="T87" fmla="*/ 254 h 940"/>
                <a:gd name="T88" fmla="*/ 703 w 937"/>
                <a:gd name="T89" fmla="*/ 238 h 940"/>
                <a:gd name="T90" fmla="*/ 719 w 937"/>
                <a:gd name="T91" fmla="*/ 222 h 940"/>
                <a:gd name="T92" fmla="*/ 735 w 937"/>
                <a:gd name="T93" fmla="*/ 206 h 940"/>
                <a:gd name="T94" fmla="*/ 751 w 937"/>
                <a:gd name="T95" fmla="*/ 190 h 940"/>
                <a:gd name="T96" fmla="*/ 767 w 937"/>
                <a:gd name="T97" fmla="*/ 174 h 940"/>
                <a:gd name="T98" fmla="*/ 782 w 937"/>
                <a:gd name="T99" fmla="*/ 158 h 940"/>
                <a:gd name="T100" fmla="*/ 798 w 937"/>
                <a:gd name="T101" fmla="*/ 142 h 940"/>
                <a:gd name="T102" fmla="*/ 814 w 937"/>
                <a:gd name="T103" fmla="*/ 126 h 940"/>
                <a:gd name="T104" fmla="*/ 830 w 937"/>
                <a:gd name="T105" fmla="*/ 110 h 940"/>
                <a:gd name="T106" fmla="*/ 846 w 937"/>
                <a:gd name="T107" fmla="*/ 94 h 940"/>
                <a:gd name="T108" fmla="*/ 862 w 937"/>
                <a:gd name="T109" fmla="*/ 79 h 940"/>
                <a:gd name="T110" fmla="*/ 878 w 937"/>
                <a:gd name="T111" fmla="*/ 63 h 940"/>
                <a:gd name="T112" fmla="*/ 893 w 937"/>
                <a:gd name="T113" fmla="*/ 47 h 940"/>
                <a:gd name="T114" fmla="*/ 909 w 937"/>
                <a:gd name="T115" fmla="*/ 31 h 940"/>
                <a:gd name="T116" fmla="*/ 925 w 937"/>
                <a:gd name="T117" fmla="*/ 15 h 9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937" h="940">
                  <a:moveTo>
                    <a:pt x="6" y="940"/>
                  </a:moveTo>
                  <a:lnTo>
                    <a:pt x="18" y="928"/>
                  </a:lnTo>
                  <a:lnTo>
                    <a:pt x="11" y="925"/>
                  </a:lnTo>
                  <a:lnTo>
                    <a:pt x="0" y="937"/>
                  </a:lnTo>
                  <a:lnTo>
                    <a:pt x="6" y="940"/>
                  </a:lnTo>
                  <a:close/>
                  <a:moveTo>
                    <a:pt x="21" y="924"/>
                  </a:moveTo>
                  <a:lnTo>
                    <a:pt x="33" y="912"/>
                  </a:lnTo>
                  <a:lnTo>
                    <a:pt x="27" y="909"/>
                  </a:lnTo>
                  <a:lnTo>
                    <a:pt x="15" y="921"/>
                  </a:lnTo>
                  <a:lnTo>
                    <a:pt x="21" y="924"/>
                  </a:lnTo>
                  <a:close/>
                  <a:moveTo>
                    <a:pt x="37" y="908"/>
                  </a:moveTo>
                  <a:lnTo>
                    <a:pt x="49" y="896"/>
                  </a:lnTo>
                  <a:lnTo>
                    <a:pt x="43" y="893"/>
                  </a:lnTo>
                  <a:lnTo>
                    <a:pt x="31" y="905"/>
                  </a:lnTo>
                  <a:lnTo>
                    <a:pt x="37" y="908"/>
                  </a:lnTo>
                  <a:close/>
                  <a:moveTo>
                    <a:pt x="53" y="892"/>
                  </a:moveTo>
                  <a:lnTo>
                    <a:pt x="65" y="880"/>
                  </a:lnTo>
                  <a:lnTo>
                    <a:pt x="59" y="877"/>
                  </a:lnTo>
                  <a:lnTo>
                    <a:pt x="47" y="889"/>
                  </a:lnTo>
                  <a:lnTo>
                    <a:pt x="53" y="892"/>
                  </a:lnTo>
                  <a:close/>
                  <a:moveTo>
                    <a:pt x="69" y="876"/>
                  </a:moveTo>
                  <a:lnTo>
                    <a:pt x="81" y="864"/>
                  </a:lnTo>
                  <a:lnTo>
                    <a:pt x="75" y="861"/>
                  </a:lnTo>
                  <a:lnTo>
                    <a:pt x="63" y="873"/>
                  </a:lnTo>
                  <a:lnTo>
                    <a:pt x="69" y="876"/>
                  </a:lnTo>
                  <a:close/>
                  <a:moveTo>
                    <a:pt x="85" y="860"/>
                  </a:moveTo>
                  <a:lnTo>
                    <a:pt x="97" y="848"/>
                  </a:lnTo>
                  <a:lnTo>
                    <a:pt x="91" y="845"/>
                  </a:lnTo>
                  <a:lnTo>
                    <a:pt x="79" y="857"/>
                  </a:lnTo>
                  <a:lnTo>
                    <a:pt x="85" y="860"/>
                  </a:lnTo>
                  <a:close/>
                  <a:moveTo>
                    <a:pt x="101" y="844"/>
                  </a:moveTo>
                  <a:lnTo>
                    <a:pt x="113" y="832"/>
                  </a:lnTo>
                  <a:lnTo>
                    <a:pt x="107" y="829"/>
                  </a:lnTo>
                  <a:lnTo>
                    <a:pt x="95" y="842"/>
                  </a:lnTo>
                  <a:lnTo>
                    <a:pt x="101" y="844"/>
                  </a:lnTo>
                  <a:close/>
                  <a:moveTo>
                    <a:pt x="117" y="828"/>
                  </a:moveTo>
                  <a:lnTo>
                    <a:pt x="129" y="816"/>
                  </a:lnTo>
                  <a:lnTo>
                    <a:pt x="122" y="814"/>
                  </a:lnTo>
                  <a:lnTo>
                    <a:pt x="111" y="826"/>
                  </a:lnTo>
                  <a:lnTo>
                    <a:pt x="117" y="828"/>
                  </a:lnTo>
                  <a:close/>
                  <a:moveTo>
                    <a:pt x="132" y="812"/>
                  </a:moveTo>
                  <a:lnTo>
                    <a:pt x="144" y="800"/>
                  </a:lnTo>
                  <a:lnTo>
                    <a:pt x="138" y="798"/>
                  </a:lnTo>
                  <a:lnTo>
                    <a:pt x="126" y="810"/>
                  </a:lnTo>
                  <a:lnTo>
                    <a:pt x="132" y="812"/>
                  </a:lnTo>
                  <a:close/>
                  <a:moveTo>
                    <a:pt x="148" y="796"/>
                  </a:moveTo>
                  <a:lnTo>
                    <a:pt x="160" y="784"/>
                  </a:lnTo>
                  <a:lnTo>
                    <a:pt x="154" y="782"/>
                  </a:lnTo>
                  <a:lnTo>
                    <a:pt x="142" y="794"/>
                  </a:lnTo>
                  <a:lnTo>
                    <a:pt x="148" y="796"/>
                  </a:lnTo>
                  <a:close/>
                  <a:moveTo>
                    <a:pt x="164" y="780"/>
                  </a:moveTo>
                  <a:lnTo>
                    <a:pt x="176" y="768"/>
                  </a:lnTo>
                  <a:lnTo>
                    <a:pt x="170" y="766"/>
                  </a:lnTo>
                  <a:lnTo>
                    <a:pt x="158" y="778"/>
                  </a:lnTo>
                  <a:lnTo>
                    <a:pt x="164" y="780"/>
                  </a:lnTo>
                  <a:close/>
                  <a:moveTo>
                    <a:pt x="180" y="764"/>
                  </a:moveTo>
                  <a:lnTo>
                    <a:pt x="192" y="752"/>
                  </a:lnTo>
                  <a:lnTo>
                    <a:pt x="186" y="750"/>
                  </a:lnTo>
                  <a:lnTo>
                    <a:pt x="174" y="762"/>
                  </a:lnTo>
                  <a:lnTo>
                    <a:pt x="180" y="764"/>
                  </a:lnTo>
                  <a:close/>
                  <a:moveTo>
                    <a:pt x="196" y="748"/>
                  </a:moveTo>
                  <a:lnTo>
                    <a:pt x="208" y="736"/>
                  </a:lnTo>
                  <a:lnTo>
                    <a:pt x="202" y="734"/>
                  </a:lnTo>
                  <a:lnTo>
                    <a:pt x="190" y="746"/>
                  </a:lnTo>
                  <a:lnTo>
                    <a:pt x="196" y="748"/>
                  </a:lnTo>
                  <a:close/>
                  <a:moveTo>
                    <a:pt x="212" y="732"/>
                  </a:moveTo>
                  <a:lnTo>
                    <a:pt x="224" y="720"/>
                  </a:lnTo>
                  <a:lnTo>
                    <a:pt x="218" y="718"/>
                  </a:lnTo>
                  <a:lnTo>
                    <a:pt x="206" y="730"/>
                  </a:lnTo>
                  <a:lnTo>
                    <a:pt x="212" y="732"/>
                  </a:lnTo>
                  <a:close/>
                  <a:moveTo>
                    <a:pt x="228" y="717"/>
                  </a:moveTo>
                  <a:lnTo>
                    <a:pt x="239" y="705"/>
                  </a:lnTo>
                  <a:lnTo>
                    <a:pt x="233" y="702"/>
                  </a:lnTo>
                  <a:lnTo>
                    <a:pt x="221" y="714"/>
                  </a:lnTo>
                  <a:lnTo>
                    <a:pt x="228" y="717"/>
                  </a:lnTo>
                  <a:close/>
                  <a:moveTo>
                    <a:pt x="243" y="701"/>
                  </a:moveTo>
                  <a:lnTo>
                    <a:pt x="255" y="689"/>
                  </a:lnTo>
                  <a:lnTo>
                    <a:pt x="249" y="686"/>
                  </a:lnTo>
                  <a:lnTo>
                    <a:pt x="237" y="698"/>
                  </a:lnTo>
                  <a:lnTo>
                    <a:pt x="243" y="701"/>
                  </a:lnTo>
                  <a:close/>
                  <a:moveTo>
                    <a:pt x="259" y="685"/>
                  </a:moveTo>
                  <a:lnTo>
                    <a:pt x="271" y="673"/>
                  </a:lnTo>
                  <a:lnTo>
                    <a:pt x="265" y="670"/>
                  </a:lnTo>
                  <a:lnTo>
                    <a:pt x="253" y="682"/>
                  </a:lnTo>
                  <a:lnTo>
                    <a:pt x="259" y="685"/>
                  </a:lnTo>
                  <a:close/>
                  <a:moveTo>
                    <a:pt x="275" y="669"/>
                  </a:moveTo>
                  <a:lnTo>
                    <a:pt x="287" y="657"/>
                  </a:lnTo>
                  <a:lnTo>
                    <a:pt x="281" y="654"/>
                  </a:lnTo>
                  <a:lnTo>
                    <a:pt x="269" y="666"/>
                  </a:lnTo>
                  <a:lnTo>
                    <a:pt x="275" y="669"/>
                  </a:lnTo>
                  <a:close/>
                  <a:moveTo>
                    <a:pt x="291" y="653"/>
                  </a:moveTo>
                  <a:lnTo>
                    <a:pt x="303" y="641"/>
                  </a:lnTo>
                  <a:lnTo>
                    <a:pt x="297" y="638"/>
                  </a:lnTo>
                  <a:lnTo>
                    <a:pt x="285" y="650"/>
                  </a:lnTo>
                  <a:lnTo>
                    <a:pt x="291" y="653"/>
                  </a:lnTo>
                  <a:close/>
                  <a:moveTo>
                    <a:pt x="307" y="637"/>
                  </a:moveTo>
                  <a:lnTo>
                    <a:pt x="319" y="625"/>
                  </a:lnTo>
                  <a:lnTo>
                    <a:pt x="313" y="622"/>
                  </a:lnTo>
                  <a:lnTo>
                    <a:pt x="301" y="634"/>
                  </a:lnTo>
                  <a:lnTo>
                    <a:pt x="307" y="637"/>
                  </a:lnTo>
                  <a:close/>
                  <a:moveTo>
                    <a:pt x="323" y="621"/>
                  </a:moveTo>
                  <a:lnTo>
                    <a:pt x="335" y="609"/>
                  </a:lnTo>
                  <a:lnTo>
                    <a:pt x="329" y="606"/>
                  </a:lnTo>
                  <a:lnTo>
                    <a:pt x="317" y="618"/>
                  </a:lnTo>
                  <a:lnTo>
                    <a:pt x="323" y="621"/>
                  </a:lnTo>
                  <a:close/>
                  <a:moveTo>
                    <a:pt x="339" y="605"/>
                  </a:moveTo>
                  <a:lnTo>
                    <a:pt x="350" y="593"/>
                  </a:lnTo>
                  <a:lnTo>
                    <a:pt x="344" y="590"/>
                  </a:lnTo>
                  <a:lnTo>
                    <a:pt x="332" y="602"/>
                  </a:lnTo>
                  <a:lnTo>
                    <a:pt x="339" y="605"/>
                  </a:lnTo>
                  <a:close/>
                  <a:moveTo>
                    <a:pt x="354" y="589"/>
                  </a:moveTo>
                  <a:lnTo>
                    <a:pt x="366" y="577"/>
                  </a:lnTo>
                  <a:lnTo>
                    <a:pt x="360" y="574"/>
                  </a:lnTo>
                  <a:lnTo>
                    <a:pt x="348" y="586"/>
                  </a:lnTo>
                  <a:lnTo>
                    <a:pt x="354" y="589"/>
                  </a:lnTo>
                  <a:close/>
                  <a:moveTo>
                    <a:pt x="370" y="573"/>
                  </a:moveTo>
                  <a:lnTo>
                    <a:pt x="382" y="561"/>
                  </a:lnTo>
                  <a:lnTo>
                    <a:pt x="376" y="558"/>
                  </a:lnTo>
                  <a:lnTo>
                    <a:pt x="364" y="570"/>
                  </a:lnTo>
                  <a:lnTo>
                    <a:pt x="370" y="573"/>
                  </a:lnTo>
                  <a:close/>
                  <a:moveTo>
                    <a:pt x="386" y="557"/>
                  </a:moveTo>
                  <a:lnTo>
                    <a:pt x="398" y="545"/>
                  </a:lnTo>
                  <a:lnTo>
                    <a:pt x="392" y="542"/>
                  </a:lnTo>
                  <a:lnTo>
                    <a:pt x="380" y="554"/>
                  </a:lnTo>
                  <a:lnTo>
                    <a:pt x="386" y="557"/>
                  </a:lnTo>
                  <a:close/>
                  <a:moveTo>
                    <a:pt x="402" y="541"/>
                  </a:moveTo>
                  <a:lnTo>
                    <a:pt x="414" y="529"/>
                  </a:lnTo>
                  <a:lnTo>
                    <a:pt x="408" y="526"/>
                  </a:lnTo>
                  <a:lnTo>
                    <a:pt x="396" y="538"/>
                  </a:lnTo>
                  <a:lnTo>
                    <a:pt x="402" y="541"/>
                  </a:lnTo>
                  <a:close/>
                  <a:moveTo>
                    <a:pt x="418" y="525"/>
                  </a:moveTo>
                  <a:lnTo>
                    <a:pt x="430" y="513"/>
                  </a:lnTo>
                  <a:lnTo>
                    <a:pt x="424" y="511"/>
                  </a:lnTo>
                  <a:lnTo>
                    <a:pt x="412" y="522"/>
                  </a:lnTo>
                  <a:lnTo>
                    <a:pt x="418" y="525"/>
                  </a:lnTo>
                  <a:close/>
                  <a:moveTo>
                    <a:pt x="434" y="509"/>
                  </a:moveTo>
                  <a:lnTo>
                    <a:pt x="446" y="497"/>
                  </a:lnTo>
                  <a:lnTo>
                    <a:pt x="440" y="495"/>
                  </a:lnTo>
                  <a:lnTo>
                    <a:pt x="428" y="506"/>
                  </a:lnTo>
                  <a:lnTo>
                    <a:pt x="434" y="509"/>
                  </a:lnTo>
                  <a:close/>
                  <a:moveTo>
                    <a:pt x="450" y="493"/>
                  </a:moveTo>
                  <a:lnTo>
                    <a:pt x="461" y="481"/>
                  </a:lnTo>
                  <a:lnTo>
                    <a:pt x="455" y="479"/>
                  </a:lnTo>
                  <a:lnTo>
                    <a:pt x="443" y="491"/>
                  </a:lnTo>
                  <a:lnTo>
                    <a:pt x="450" y="493"/>
                  </a:lnTo>
                  <a:close/>
                  <a:moveTo>
                    <a:pt x="465" y="477"/>
                  </a:moveTo>
                  <a:lnTo>
                    <a:pt x="477" y="465"/>
                  </a:lnTo>
                  <a:lnTo>
                    <a:pt x="471" y="463"/>
                  </a:lnTo>
                  <a:lnTo>
                    <a:pt x="459" y="475"/>
                  </a:lnTo>
                  <a:lnTo>
                    <a:pt x="465" y="477"/>
                  </a:lnTo>
                  <a:close/>
                  <a:moveTo>
                    <a:pt x="481" y="461"/>
                  </a:moveTo>
                  <a:lnTo>
                    <a:pt x="493" y="449"/>
                  </a:lnTo>
                  <a:lnTo>
                    <a:pt x="487" y="447"/>
                  </a:lnTo>
                  <a:lnTo>
                    <a:pt x="475" y="459"/>
                  </a:lnTo>
                  <a:lnTo>
                    <a:pt x="481" y="461"/>
                  </a:lnTo>
                  <a:close/>
                  <a:moveTo>
                    <a:pt x="497" y="445"/>
                  </a:moveTo>
                  <a:lnTo>
                    <a:pt x="509" y="433"/>
                  </a:lnTo>
                  <a:lnTo>
                    <a:pt x="503" y="431"/>
                  </a:lnTo>
                  <a:lnTo>
                    <a:pt x="491" y="443"/>
                  </a:lnTo>
                  <a:lnTo>
                    <a:pt x="497" y="445"/>
                  </a:lnTo>
                  <a:close/>
                  <a:moveTo>
                    <a:pt x="513" y="429"/>
                  </a:moveTo>
                  <a:lnTo>
                    <a:pt x="525" y="417"/>
                  </a:lnTo>
                  <a:lnTo>
                    <a:pt x="519" y="415"/>
                  </a:lnTo>
                  <a:lnTo>
                    <a:pt x="507" y="427"/>
                  </a:lnTo>
                  <a:lnTo>
                    <a:pt x="513" y="429"/>
                  </a:lnTo>
                  <a:close/>
                  <a:moveTo>
                    <a:pt x="529" y="413"/>
                  </a:moveTo>
                  <a:lnTo>
                    <a:pt x="541" y="402"/>
                  </a:lnTo>
                  <a:lnTo>
                    <a:pt x="535" y="399"/>
                  </a:lnTo>
                  <a:lnTo>
                    <a:pt x="523" y="411"/>
                  </a:lnTo>
                  <a:lnTo>
                    <a:pt x="529" y="413"/>
                  </a:lnTo>
                  <a:close/>
                  <a:moveTo>
                    <a:pt x="545" y="397"/>
                  </a:moveTo>
                  <a:lnTo>
                    <a:pt x="557" y="386"/>
                  </a:lnTo>
                  <a:lnTo>
                    <a:pt x="551" y="383"/>
                  </a:lnTo>
                  <a:lnTo>
                    <a:pt x="539" y="395"/>
                  </a:lnTo>
                  <a:lnTo>
                    <a:pt x="545" y="397"/>
                  </a:lnTo>
                  <a:close/>
                  <a:moveTo>
                    <a:pt x="560" y="382"/>
                  </a:moveTo>
                  <a:lnTo>
                    <a:pt x="572" y="370"/>
                  </a:lnTo>
                  <a:lnTo>
                    <a:pt x="566" y="367"/>
                  </a:lnTo>
                  <a:lnTo>
                    <a:pt x="554" y="379"/>
                  </a:lnTo>
                  <a:lnTo>
                    <a:pt x="560" y="382"/>
                  </a:lnTo>
                  <a:close/>
                  <a:moveTo>
                    <a:pt x="576" y="366"/>
                  </a:moveTo>
                  <a:lnTo>
                    <a:pt x="588" y="354"/>
                  </a:lnTo>
                  <a:lnTo>
                    <a:pt x="582" y="351"/>
                  </a:lnTo>
                  <a:lnTo>
                    <a:pt x="570" y="363"/>
                  </a:lnTo>
                  <a:lnTo>
                    <a:pt x="576" y="366"/>
                  </a:lnTo>
                  <a:close/>
                  <a:moveTo>
                    <a:pt x="592" y="350"/>
                  </a:moveTo>
                  <a:lnTo>
                    <a:pt x="604" y="338"/>
                  </a:lnTo>
                  <a:lnTo>
                    <a:pt x="598" y="335"/>
                  </a:lnTo>
                  <a:lnTo>
                    <a:pt x="586" y="347"/>
                  </a:lnTo>
                  <a:lnTo>
                    <a:pt x="592" y="350"/>
                  </a:lnTo>
                  <a:close/>
                  <a:moveTo>
                    <a:pt x="608" y="334"/>
                  </a:moveTo>
                  <a:lnTo>
                    <a:pt x="620" y="322"/>
                  </a:lnTo>
                  <a:lnTo>
                    <a:pt x="614" y="319"/>
                  </a:lnTo>
                  <a:lnTo>
                    <a:pt x="602" y="331"/>
                  </a:lnTo>
                  <a:lnTo>
                    <a:pt x="608" y="334"/>
                  </a:lnTo>
                  <a:close/>
                  <a:moveTo>
                    <a:pt x="624" y="318"/>
                  </a:moveTo>
                  <a:lnTo>
                    <a:pt x="636" y="306"/>
                  </a:lnTo>
                  <a:lnTo>
                    <a:pt x="630" y="303"/>
                  </a:lnTo>
                  <a:lnTo>
                    <a:pt x="618" y="315"/>
                  </a:lnTo>
                  <a:lnTo>
                    <a:pt x="624" y="318"/>
                  </a:lnTo>
                  <a:close/>
                  <a:moveTo>
                    <a:pt x="640" y="302"/>
                  </a:moveTo>
                  <a:lnTo>
                    <a:pt x="652" y="290"/>
                  </a:lnTo>
                  <a:lnTo>
                    <a:pt x="646" y="287"/>
                  </a:lnTo>
                  <a:lnTo>
                    <a:pt x="634" y="299"/>
                  </a:lnTo>
                  <a:lnTo>
                    <a:pt x="640" y="302"/>
                  </a:lnTo>
                  <a:close/>
                  <a:moveTo>
                    <a:pt x="656" y="286"/>
                  </a:moveTo>
                  <a:lnTo>
                    <a:pt x="668" y="274"/>
                  </a:lnTo>
                  <a:lnTo>
                    <a:pt x="662" y="271"/>
                  </a:lnTo>
                  <a:lnTo>
                    <a:pt x="650" y="283"/>
                  </a:lnTo>
                  <a:lnTo>
                    <a:pt x="656" y="286"/>
                  </a:lnTo>
                  <a:close/>
                  <a:moveTo>
                    <a:pt x="671" y="270"/>
                  </a:moveTo>
                  <a:lnTo>
                    <a:pt x="683" y="258"/>
                  </a:lnTo>
                  <a:lnTo>
                    <a:pt x="677" y="255"/>
                  </a:lnTo>
                  <a:lnTo>
                    <a:pt x="665" y="267"/>
                  </a:lnTo>
                  <a:lnTo>
                    <a:pt x="671" y="270"/>
                  </a:lnTo>
                  <a:close/>
                  <a:moveTo>
                    <a:pt x="687" y="254"/>
                  </a:moveTo>
                  <a:lnTo>
                    <a:pt x="699" y="242"/>
                  </a:lnTo>
                  <a:lnTo>
                    <a:pt x="693" y="239"/>
                  </a:lnTo>
                  <a:lnTo>
                    <a:pt x="681" y="251"/>
                  </a:lnTo>
                  <a:lnTo>
                    <a:pt x="687" y="254"/>
                  </a:lnTo>
                  <a:close/>
                  <a:moveTo>
                    <a:pt x="703" y="238"/>
                  </a:moveTo>
                  <a:lnTo>
                    <a:pt x="715" y="226"/>
                  </a:lnTo>
                  <a:lnTo>
                    <a:pt x="709" y="223"/>
                  </a:lnTo>
                  <a:lnTo>
                    <a:pt x="697" y="235"/>
                  </a:lnTo>
                  <a:lnTo>
                    <a:pt x="703" y="238"/>
                  </a:lnTo>
                  <a:close/>
                  <a:moveTo>
                    <a:pt x="719" y="222"/>
                  </a:moveTo>
                  <a:lnTo>
                    <a:pt x="731" y="210"/>
                  </a:lnTo>
                  <a:lnTo>
                    <a:pt x="725" y="207"/>
                  </a:lnTo>
                  <a:lnTo>
                    <a:pt x="713" y="219"/>
                  </a:lnTo>
                  <a:lnTo>
                    <a:pt x="719" y="222"/>
                  </a:lnTo>
                  <a:close/>
                  <a:moveTo>
                    <a:pt x="735" y="206"/>
                  </a:moveTo>
                  <a:lnTo>
                    <a:pt x="747" y="194"/>
                  </a:lnTo>
                  <a:lnTo>
                    <a:pt x="741" y="191"/>
                  </a:lnTo>
                  <a:lnTo>
                    <a:pt x="729" y="203"/>
                  </a:lnTo>
                  <a:lnTo>
                    <a:pt x="735" y="206"/>
                  </a:lnTo>
                  <a:close/>
                  <a:moveTo>
                    <a:pt x="751" y="190"/>
                  </a:moveTo>
                  <a:lnTo>
                    <a:pt x="763" y="178"/>
                  </a:lnTo>
                  <a:lnTo>
                    <a:pt x="757" y="176"/>
                  </a:lnTo>
                  <a:lnTo>
                    <a:pt x="745" y="188"/>
                  </a:lnTo>
                  <a:lnTo>
                    <a:pt x="751" y="190"/>
                  </a:lnTo>
                  <a:close/>
                  <a:moveTo>
                    <a:pt x="767" y="174"/>
                  </a:moveTo>
                  <a:lnTo>
                    <a:pt x="779" y="162"/>
                  </a:lnTo>
                  <a:lnTo>
                    <a:pt x="772" y="160"/>
                  </a:lnTo>
                  <a:lnTo>
                    <a:pt x="761" y="172"/>
                  </a:lnTo>
                  <a:lnTo>
                    <a:pt x="767" y="174"/>
                  </a:lnTo>
                  <a:close/>
                  <a:moveTo>
                    <a:pt x="782" y="158"/>
                  </a:moveTo>
                  <a:lnTo>
                    <a:pt x="794" y="146"/>
                  </a:lnTo>
                  <a:lnTo>
                    <a:pt x="788" y="144"/>
                  </a:lnTo>
                  <a:lnTo>
                    <a:pt x="776" y="156"/>
                  </a:lnTo>
                  <a:lnTo>
                    <a:pt x="782" y="158"/>
                  </a:lnTo>
                  <a:close/>
                  <a:moveTo>
                    <a:pt x="798" y="142"/>
                  </a:moveTo>
                  <a:lnTo>
                    <a:pt x="810" y="130"/>
                  </a:lnTo>
                  <a:lnTo>
                    <a:pt x="804" y="128"/>
                  </a:lnTo>
                  <a:lnTo>
                    <a:pt x="792" y="140"/>
                  </a:lnTo>
                  <a:lnTo>
                    <a:pt x="798" y="142"/>
                  </a:lnTo>
                  <a:close/>
                  <a:moveTo>
                    <a:pt x="814" y="126"/>
                  </a:moveTo>
                  <a:lnTo>
                    <a:pt x="826" y="114"/>
                  </a:lnTo>
                  <a:lnTo>
                    <a:pt x="820" y="112"/>
                  </a:lnTo>
                  <a:lnTo>
                    <a:pt x="808" y="124"/>
                  </a:lnTo>
                  <a:lnTo>
                    <a:pt x="814" y="126"/>
                  </a:lnTo>
                  <a:close/>
                  <a:moveTo>
                    <a:pt x="830" y="110"/>
                  </a:moveTo>
                  <a:lnTo>
                    <a:pt x="842" y="98"/>
                  </a:lnTo>
                  <a:lnTo>
                    <a:pt x="836" y="96"/>
                  </a:lnTo>
                  <a:lnTo>
                    <a:pt x="824" y="108"/>
                  </a:lnTo>
                  <a:lnTo>
                    <a:pt x="830" y="110"/>
                  </a:lnTo>
                  <a:close/>
                  <a:moveTo>
                    <a:pt x="846" y="94"/>
                  </a:moveTo>
                  <a:lnTo>
                    <a:pt x="858" y="82"/>
                  </a:lnTo>
                  <a:lnTo>
                    <a:pt x="852" y="80"/>
                  </a:lnTo>
                  <a:lnTo>
                    <a:pt x="840" y="92"/>
                  </a:lnTo>
                  <a:lnTo>
                    <a:pt x="846" y="94"/>
                  </a:lnTo>
                  <a:close/>
                  <a:moveTo>
                    <a:pt x="862" y="79"/>
                  </a:moveTo>
                  <a:lnTo>
                    <a:pt x="874" y="66"/>
                  </a:lnTo>
                  <a:lnTo>
                    <a:pt x="868" y="64"/>
                  </a:lnTo>
                  <a:lnTo>
                    <a:pt x="856" y="76"/>
                  </a:lnTo>
                  <a:lnTo>
                    <a:pt x="862" y="79"/>
                  </a:lnTo>
                  <a:close/>
                  <a:moveTo>
                    <a:pt x="878" y="63"/>
                  </a:moveTo>
                  <a:lnTo>
                    <a:pt x="890" y="51"/>
                  </a:lnTo>
                  <a:lnTo>
                    <a:pt x="883" y="48"/>
                  </a:lnTo>
                  <a:lnTo>
                    <a:pt x="872" y="60"/>
                  </a:lnTo>
                  <a:lnTo>
                    <a:pt x="878" y="63"/>
                  </a:lnTo>
                  <a:close/>
                  <a:moveTo>
                    <a:pt x="893" y="47"/>
                  </a:moveTo>
                  <a:lnTo>
                    <a:pt x="905" y="35"/>
                  </a:lnTo>
                  <a:lnTo>
                    <a:pt x="899" y="32"/>
                  </a:lnTo>
                  <a:lnTo>
                    <a:pt x="887" y="44"/>
                  </a:lnTo>
                  <a:lnTo>
                    <a:pt x="893" y="47"/>
                  </a:lnTo>
                  <a:close/>
                  <a:moveTo>
                    <a:pt x="909" y="31"/>
                  </a:moveTo>
                  <a:lnTo>
                    <a:pt x="921" y="19"/>
                  </a:lnTo>
                  <a:lnTo>
                    <a:pt x="915" y="16"/>
                  </a:lnTo>
                  <a:lnTo>
                    <a:pt x="903" y="28"/>
                  </a:lnTo>
                  <a:lnTo>
                    <a:pt x="909" y="31"/>
                  </a:lnTo>
                  <a:close/>
                  <a:moveTo>
                    <a:pt x="925" y="15"/>
                  </a:moveTo>
                  <a:lnTo>
                    <a:pt x="937" y="3"/>
                  </a:lnTo>
                  <a:lnTo>
                    <a:pt x="931" y="0"/>
                  </a:lnTo>
                  <a:lnTo>
                    <a:pt x="919" y="12"/>
                  </a:lnTo>
                  <a:lnTo>
                    <a:pt x="925" y="15"/>
                  </a:lnTo>
                  <a:close/>
                </a:path>
              </a:pathLst>
            </a:custGeom>
            <a:solidFill>
              <a:srgbClr val="D0CECE"/>
            </a:solidFill>
            <a:ln w="0" cap="flat">
              <a:solidFill>
                <a:srgbClr val="D0CECE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50" name="Freeform 88"/>
            <p:cNvSpPr>
              <a:spLocks noEditPoints="1"/>
            </p:cNvSpPr>
            <p:nvPr/>
          </p:nvSpPr>
          <p:spPr bwMode="auto">
            <a:xfrm>
              <a:off x="2815" y="928"/>
              <a:ext cx="1348" cy="1329"/>
            </a:xfrm>
            <a:custGeom>
              <a:avLst/>
              <a:gdLst>
                <a:gd name="T0" fmla="*/ 28 w 939"/>
                <a:gd name="T1" fmla="*/ 1302 h 1332"/>
                <a:gd name="T2" fmla="*/ 25 w 939"/>
                <a:gd name="T3" fmla="*/ 1295 h 1332"/>
                <a:gd name="T4" fmla="*/ 55 w 939"/>
                <a:gd name="T5" fmla="*/ 1263 h 1332"/>
                <a:gd name="T6" fmla="*/ 70 w 939"/>
                <a:gd name="T7" fmla="*/ 1230 h 1332"/>
                <a:gd name="T8" fmla="*/ 80 w 939"/>
                <a:gd name="T9" fmla="*/ 1228 h 1332"/>
                <a:gd name="T10" fmla="*/ 113 w 939"/>
                <a:gd name="T11" fmla="*/ 1180 h 1332"/>
                <a:gd name="T12" fmla="*/ 110 w 939"/>
                <a:gd name="T13" fmla="*/ 1174 h 1332"/>
                <a:gd name="T14" fmla="*/ 141 w 939"/>
                <a:gd name="T15" fmla="*/ 1141 h 1332"/>
                <a:gd name="T16" fmla="*/ 155 w 939"/>
                <a:gd name="T17" fmla="*/ 1109 h 1332"/>
                <a:gd name="T18" fmla="*/ 165 w 939"/>
                <a:gd name="T19" fmla="*/ 1107 h 1332"/>
                <a:gd name="T20" fmla="*/ 198 w 939"/>
                <a:gd name="T21" fmla="*/ 1059 h 1332"/>
                <a:gd name="T22" fmla="*/ 195 w 939"/>
                <a:gd name="T23" fmla="*/ 1053 h 1332"/>
                <a:gd name="T24" fmla="*/ 226 w 939"/>
                <a:gd name="T25" fmla="*/ 1020 h 1332"/>
                <a:gd name="T26" fmla="*/ 240 w 939"/>
                <a:gd name="T27" fmla="*/ 988 h 1332"/>
                <a:gd name="T28" fmla="*/ 250 w 939"/>
                <a:gd name="T29" fmla="*/ 985 h 1332"/>
                <a:gd name="T30" fmla="*/ 283 w 939"/>
                <a:gd name="T31" fmla="*/ 938 h 1332"/>
                <a:gd name="T32" fmla="*/ 280 w 939"/>
                <a:gd name="T33" fmla="*/ 931 h 1332"/>
                <a:gd name="T34" fmla="*/ 311 w 939"/>
                <a:gd name="T35" fmla="*/ 899 h 1332"/>
                <a:gd name="T36" fmla="*/ 325 w 939"/>
                <a:gd name="T37" fmla="*/ 867 h 1332"/>
                <a:gd name="T38" fmla="*/ 335 w 939"/>
                <a:gd name="T39" fmla="*/ 864 h 1332"/>
                <a:gd name="T40" fmla="*/ 368 w 939"/>
                <a:gd name="T41" fmla="*/ 817 h 1332"/>
                <a:gd name="T42" fmla="*/ 365 w 939"/>
                <a:gd name="T43" fmla="*/ 810 h 1332"/>
                <a:gd name="T44" fmla="*/ 396 w 939"/>
                <a:gd name="T45" fmla="*/ 778 h 1332"/>
                <a:gd name="T46" fmla="*/ 410 w 939"/>
                <a:gd name="T47" fmla="*/ 745 h 1332"/>
                <a:gd name="T48" fmla="*/ 420 w 939"/>
                <a:gd name="T49" fmla="*/ 743 h 1332"/>
                <a:gd name="T50" fmla="*/ 453 w 939"/>
                <a:gd name="T51" fmla="*/ 695 h 1332"/>
                <a:gd name="T52" fmla="*/ 450 w 939"/>
                <a:gd name="T53" fmla="*/ 689 h 1332"/>
                <a:gd name="T54" fmla="*/ 481 w 939"/>
                <a:gd name="T55" fmla="*/ 656 h 1332"/>
                <a:gd name="T56" fmla="*/ 495 w 939"/>
                <a:gd name="T57" fmla="*/ 624 h 1332"/>
                <a:gd name="T58" fmla="*/ 505 w 939"/>
                <a:gd name="T59" fmla="*/ 622 h 1332"/>
                <a:gd name="T60" fmla="*/ 538 w 939"/>
                <a:gd name="T61" fmla="*/ 574 h 1332"/>
                <a:gd name="T62" fmla="*/ 535 w 939"/>
                <a:gd name="T63" fmla="*/ 568 h 1332"/>
                <a:gd name="T64" fmla="*/ 566 w 939"/>
                <a:gd name="T65" fmla="*/ 535 h 1332"/>
                <a:gd name="T66" fmla="*/ 581 w 939"/>
                <a:gd name="T67" fmla="*/ 503 h 1332"/>
                <a:gd name="T68" fmla="*/ 590 w 939"/>
                <a:gd name="T69" fmla="*/ 500 h 1332"/>
                <a:gd name="T70" fmla="*/ 624 w 939"/>
                <a:gd name="T71" fmla="*/ 453 h 1332"/>
                <a:gd name="T72" fmla="*/ 620 w 939"/>
                <a:gd name="T73" fmla="*/ 447 h 1332"/>
                <a:gd name="T74" fmla="*/ 651 w 939"/>
                <a:gd name="T75" fmla="*/ 414 h 1332"/>
                <a:gd name="T76" fmla="*/ 666 w 939"/>
                <a:gd name="T77" fmla="*/ 382 h 1332"/>
                <a:gd name="T78" fmla="*/ 675 w 939"/>
                <a:gd name="T79" fmla="*/ 379 h 1332"/>
                <a:gd name="T80" fmla="*/ 709 w 939"/>
                <a:gd name="T81" fmla="*/ 332 h 1332"/>
                <a:gd name="T82" fmla="*/ 705 w 939"/>
                <a:gd name="T83" fmla="*/ 325 h 1332"/>
                <a:gd name="T84" fmla="*/ 736 w 939"/>
                <a:gd name="T85" fmla="*/ 293 h 1332"/>
                <a:gd name="T86" fmla="*/ 751 w 939"/>
                <a:gd name="T87" fmla="*/ 260 h 1332"/>
                <a:gd name="T88" fmla="*/ 760 w 939"/>
                <a:gd name="T89" fmla="*/ 258 h 1332"/>
                <a:gd name="T90" fmla="*/ 794 w 939"/>
                <a:gd name="T91" fmla="*/ 210 h 1332"/>
                <a:gd name="T92" fmla="*/ 790 w 939"/>
                <a:gd name="T93" fmla="*/ 204 h 1332"/>
                <a:gd name="T94" fmla="*/ 821 w 939"/>
                <a:gd name="T95" fmla="*/ 171 h 1332"/>
                <a:gd name="T96" fmla="*/ 836 w 939"/>
                <a:gd name="T97" fmla="*/ 139 h 1332"/>
                <a:gd name="T98" fmla="*/ 845 w 939"/>
                <a:gd name="T99" fmla="*/ 137 h 1332"/>
                <a:gd name="T100" fmla="*/ 879 w 939"/>
                <a:gd name="T101" fmla="*/ 89 h 1332"/>
                <a:gd name="T102" fmla="*/ 875 w 939"/>
                <a:gd name="T103" fmla="*/ 83 h 1332"/>
                <a:gd name="T104" fmla="*/ 906 w 939"/>
                <a:gd name="T105" fmla="*/ 50 h 1332"/>
                <a:gd name="T106" fmla="*/ 921 w 939"/>
                <a:gd name="T107" fmla="*/ 18 h 1332"/>
                <a:gd name="T108" fmla="*/ 930 w 939"/>
                <a:gd name="T109" fmla="*/ 16 h 13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939" h="1332">
                  <a:moveTo>
                    <a:pt x="7" y="1332"/>
                  </a:moveTo>
                  <a:lnTo>
                    <a:pt x="16" y="1319"/>
                  </a:lnTo>
                  <a:lnTo>
                    <a:pt x="9" y="1317"/>
                  </a:lnTo>
                  <a:lnTo>
                    <a:pt x="0" y="1330"/>
                  </a:lnTo>
                  <a:lnTo>
                    <a:pt x="7" y="1332"/>
                  </a:lnTo>
                  <a:close/>
                  <a:moveTo>
                    <a:pt x="19" y="1315"/>
                  </a:moveTo>
                  <a:lnTo>
                    <a:pt x="28" y="1302"/>
                  </a:lnTo>
                  <a:lnTo>
                    <a:pt x="22" y="1300"/>
                  </a:lnTo>
                  <a:lnTo>
                    <a:pt x="12" y="1312"/>
                  </a:lnTo>
                  <a:lnTo>
                    <a:pt x="19" y="1315"/>
                  </a:lnTo>
                  <a:close/>
                  <a:moveTo>
                    <a:pt x="31" y="1297"/>
                  </a:moveTo>
                  <a:lnTo>
                    <a:pt x="40" y="1284"/>
                  </a:lnTo>
                  <a:lnTo>
                    <a:pt x="34" y="1282"/>
                  </a:lnTo>
                  <a:lnTo>
                    <a:pt x="25" y="1295"/>
                  </a:lnTo>
                  <a:lnTo>
                    <a:pt x="31" y="1297"/>
                  </a:lnTo>
                  <a:close/>
                  <a:moveTo>
                    <a:pt x="43" y="1280"/>
                  </a:moveTo>
                  <a:lnTo>
                    <a:pt x="52" y="1267"/>
                  </a:lnTo>
                  <a:lnTo>
                    <a:pt x="46" y="1265"/>
                  </a:lnTo>
                  <a:lnTo>
                    <a:pt x="37" y="1278"/>
                  </a:lnTo>
                  <a:lnTo>
                    <a:pt x="43" y="1280"/>
                  </a:lnTo>
                  <a:close/>
                  <a:moveTo>
                    <a:pt x="55" y="1263"/>
                  </a:moveTo>
                  <a:lnTo>
                    <a:pt x="65" y="1250"/>
                  </a:lnTo>
                  <a:lnTo>
                    <a:pt x="58" y="1248"/>
                  </a:lnTo>
                  <a:lnTo>
                    <a:pt x="49" y="1261"/>
                  </a:lnTo>
                  <a:lnTo>
                    <a:pt x="55" y="1263"/>
                  </a:lnTo>
                  <a:close/>
                  <a:moveTo>
                    <a:pt x="68" y="1245"/>
                  </a:moveTo>
                  <a:lnTo>
                    <a:pt x="77" y="1232"/>
                  </a:lnTo>
                  <a:lnTo>
                    <a:pt x="70" y="1230"/>
                  </a:lnTo>
                  <a:lnTo>
                    <a:pt x="61" y="1243"/>
                  </a:lnTo>
                  <a:lnTo>
                    <a:pt x="68" y="1245"/>
                  </a:lnTo>
                  <a:close/>
                  <a:moveTo>
                    <a:pt x="80" y="1228"/>
                  </a:moveTo>
                  <a:lnTo>
                    <a:pt x="89" y="1215"/>
                  </a:lnTo>
                  <a:lnTo>
                    <a:pt x="82" y="1213"/>
                  </a:lnTo>
                  <a:lnTo>
                    <a:pt x="73" y="1226"/>
                  </a:lnTo>
                  <a:lnTo>
                    <a:pt x="80" y="1228"/>
                  </a:lnTo>
                  <a:close/>
                  <a:moveTo>
                    <a:pt x="92" y="1211"/>
                  </a:moveTo>
                  <a:lnTo>
                    <a:pt x="101" y="1198"/>
                  </a:lnTo>
                  <a:lnTo>
                    <a:pt x="94" y="1196"/>
                  </a:lnTo>
                  <a:lnTo>
                    <a:pt x="85" y="1209"/>
                  </a:lnTo>
                  <a:lnTo>
                    <a:pt x="92" y="1211"/>
                  </a:lnTo>
                  <a:close/>
                  <a:moveTo>
                    <a:pt x="104" y="1193"/>
                  </a:moveTo>
                  <a:lnTo>
                    <a:pt x="113" y="1180"/>
                  </a:lnTo>
                  <a:lnTo>
                    <a:pt x="107" y="1178"/>
                  </a:lnTo>
                  <a:lnTo>
                    <a:pt x="98" y="1191"/>
                  </a:lnTo>
                  <a:lnTo>
                    <a:pt x="104" y="1193"/>
                  </a:lnTo>
                  <a:close/>
                  <a:moveTo>
                    <a:pt x="116" y="1176"/>
                  </a:moveTo>
                  <a:lnTo>
                    <a:pt x="125" y="1163"/>
                  </a:lnTo>
                  <a:lnTo>
                    <a:pt x="119" y="1161"/>
                  </a:lnTo>
                  <a:lnTo>
                    <a:pt x="110" y="1174"/>
                  </a:lnTo>
                  <a:lnTo>
                    <a:pt x="116" y="1176"/>
                  </a:lnTo>
                  <a:close/>
                  <a:moveTo>
                    <a:pt x="128" y="1159"/>
                  </a:moveTo>
                  <a:lnTo>
                    <a:pt x="137" y="1146"/>
                  </a:lnTo>
                  <a:lnTo>
                    <a:pt x="131" y="1144"/>
                  </a:lnTo>
                  <a:lnTo>
                    <a:pt x="122" y="1157"/>
                  </a:lnTo>
                  <a:lnTo>
                    <a:pt x="128" y="1159"/>
                  </a:lnTo>
                  <a:close/>
                  <a:moveTo>
                    <a:pt x="141" y="1141"/>
                  </a:moveTo>
                  <a:lnTo>
                    <a:pt x="150" y="1128"/>
                  </a:lnTo>
                  <a:lnTo>
                    <a:pt x="143" y="1126"/>
                  </a:lnTo>
                  <a:lnTo>
                    <a:pt x="134" y="1139"/>
                  </a:lnTo>
                  <a:lnTo>
                    <a:pt x="141" y="1141"/>
                  </a:lnTo>
                  <a:close/>
                  <a:moveTo>
                    <a:pt x="153" y="1124"/>
                  </a:moveTo>
                  <a:lnTo>
                    <a:pt x="162" y="1111"/>
                  </a:lnTo>
                  <a:lnTo>
                    <a:pt x="155" y="1109"/>
                  </a:lnTo>
                  <a:lnTo>
                    <a:pt x="146" y="1122"/>
                  </a:lnTo>
                  <a:lnTo>
                    <a:pt x="153" y="1124"/>
                  </a:lnTo>
                  <a:close/>
                  <a:moveTo>
                    <a:pt x="165" y="1107"/>
                  </a:moveTo>
                  <a:lnTo>
                    <a:pt x="174" y="1094"/>
                  </a:lnTo>
                  <a:lnTo>
                    <a:pt x="167" y="1092"/>
                  </a:lnTo>
                  <a:lnTo>
                    <a:pt x="158" y="1105"/>
                  </a:lnTo>
                  <a:lnTo>
                    <a:pt x="165" y="1107"/>
                  </a:lnTo>
                  <a:close/>
                  <a:moveTo>
                    <a:pt x="177" y="1089"/>
                  </a:moveTo>
                  <a:lnTo>
                    <a:pt x="186" y="1076"/>
                  </a:lnTo>
                  <a:lnTo>
                    <a:pt x="180" y="1074"/>
                  </a:lnTo>
                  <a:lnTo>
                    <a:pt x="170" y="1087"/>
                  </a:lnTo>
                  <a:lnTo>
                    <a:pt x="177" y="1089"/>
                  </a:lnTo>
                  <a:close/>
                  <a:moveTo>
                    <a:pt x="189" y="1072"/>
                  </a:moveTo>
                  <a:lnTo>
                    <a:pt x="198" y="1059"/>
                  </a:lnTo>
                  <a:lnTo>
                    <a:pt x="192" y="1057"/>
                  </a:lnTo>
                  <a:lnTo>
                    <a:pt x="183" y="1070"/>
                  </a:lnTo>
                  <a:lnTo>
                    <a:pt x="189" y="1072"/>
                  </a:lnTo>
                  <a:close/>
                  <a:moveTo>
                    <a:pt x="201" y="1055"/>
                  </a:moveTo>
                  <a:lnTo>
                    <a:pt x="210" y="1042"/>
                  </a:lnTo>
                  <a:lnTo>
                    <a:pt x="204" y="1040"/>
                  </a:lnTo>
                  <a:lnTo>
                    <a:pt x="195" y="1053"/>
                  </a:lnTo>
                  <a:lnTo>
                    <a:pt x="201" y="1055"/>
                  </a:lnTo>
                  <a:close/>
                  <a:moveTo>
                    <a:pt x="213" y="1037"/>
                  </a:moveTo>
                  <a:lnTo>
                    <a:pt x="223" y="1024"/>
                  </a:lnTo>
                  <a:lnTo>
                    <a:pt x="216" y="1022"/>
                  </a:lnTo>
                  <a:lnTo>
                    <a:pt x="207" y="1035"/>
                  </a:lnTo>
                  <a:lnTo>
                    <a:pt x="213" y="1037"/>
                  </a:lnTo>
                  <a:close/>
                  <a:moveTo>
                    <a:pt x="226" y="1020"/>
                  </a:moveTo>
                  <a:lnTo>
                    <a:pt x="235" y="1007"/>
                  </a:lnTo>
                  <a:lnTo>
                    <a:pt x="228" y="1005"/>
                  </a:lnTo>
                  <a:lnTo>
                    <a:pt x="219" y="1018"/>
                  </a:lnTo>
                  <a:lnTo>
                    <a:pt x="226" y="1020"/>
                  </a:lnTo>
                  <a:close/>
                  <a:moveTo>
                    <a:pt x="238" y="1003"/>
                  </a:moveTo>
                  <a:lnTo>
                    <a:pt x="247" y="990"/>
                  </a:lnTo>
                  <a:lnTo>
                    <a:pt x="240" y="988"/>
                  </a:lnTo>
                  <a:lnTo>
                    <a:pt x="231" y="1001"/>
                  </a:lnTo>
                  <a:lnTo>
                    <a:pt x="238" y="1003"/>
                  </a:lnTo>
                  <a:close/>
                  <a:moveTo>
                    <a:pt x="250" y="985"/>
                  </a:moveTo>
                  <a:lnTo>
                    <a:pt x="259" y="972"/>
                  </a:lnTo>
                  <a:lnTo>
                    <a:pt x="252" y="970"/>
                  </a:lnTo>
                  <a:lnTo>
                    <a:pt x="243" y="983"/>
                  </a:lnTo>
                  <a:lnTo>
                    <a:pt x="250" y="985"/>
                  </a:lnTo>
                  <a:close/>
                  <a:moveTo>
                    <a:pt x="262" y="968"/>
                  </a:moveTo>
                  <a:lnTo>
                    <a:pt x="271" y="955"/>
                  </a:lnTo>
                  <a:lnTo>
                    <a:pt x="265" y="953"/>
                  </a:lnTo>
                  <a:lnTo>
                    <a:pt x="255" y="966"/>
                  </a:lnTo>
                  <a:lnTo>
                    <a:pt x="262" y="968"/>
                  </a:lnTo>
                  <a:close/>
                  <a:moveTo>
                    <a:pt x="274" y="951"/>
                  </a:moveTo>
                  <a:lnTo>
                    <a:pt x="283" y="938"/>
                  </a:lnTo>
                  <a:lnTo>
                    <a:pt x="277" y="936"/>
                  </a:lnTo>
                  <a:lnTo>
                    <a:pt x="268" y="949"/>
                  </a:lnTo>
                  <a:lnTo>
                    <a:pt x="274" y="951"/>
                  </a:lnTo>
                  <a:close/>
                  <a:moveTo>
                    <a:pt x="286" y="933"/>
                  </a:moveTo>
                  <a:lnTo>
                    <a:pt x="295" y="920"/>
                  </a:lnTo>
                  <a:lnTo>
                    <a:pt x="289" y="918"/>
                  </a:lnTo>
                  <a:lnTo>
                    <a:pt x="280" y="931"/>
                  </a:lnTo>
                  <a:lnTo>
                    <a:pt x="286" y="933"/>
                  </a:lnTo>
                  <a:close/>
                  <a:moveTo>
                    <a:pt x="298" y="916"/>
                  </a:moveTo>
                  <a:lnTo>
                    <a:pt x="308" y="903"/>
                  </a:lnTo>
                  <a:lnTo>
                    <a:pt x="301" y="901"/>
                  </a:lnTo>
                  <a:lnTo>
                    <a:pt x="292" y="914"/>
                  </a:lnTo>
                  <a:lnTo>
                    <a:pt x="298" y="916"/>
                  </a:lnTo>
                  <a:close/>
                  <a:moveTo>
                    <a:pt x="311" y="899"/>
                  </a:moveTo>
                  <a:lnTo>
                    <a:pt x="320" y="886"/>
                  </a:lnTo>
                  <a:lnTo>
                    <a:pt x="313" y="884"/>
                  </a:lnTo>
                  <a:lnTo>
                    <a:pt x="304" y="897"/>
                  </a:lnTo>
                  <a:lnTo>
                    <a:pt x="311" y="899"/>
                  </a:lnTo>
                  <a:close/>
                  <a:moveTo>
                    <a:pt x="323" y="882"/>
                  </a:moveTo>
                  <a:lnTo>
                    <a:pt x="332" y="869"/>
                  </a:lnTo>
                  <a:lnTo>
                    <a:pt x="325" y="867"/>
                  </a:lnTo>
                  <a:lnTo>
                    <a:pt x="316" y="880"/>
                  </a:lnTo>
                  <a:lnTo>
                    <a:pt x="323" y="882"/>
                  </a:lnTo>
                  <a:close/>
                  <a:moveTo>
                    <a:pt x="335" y="864"/>
                  </a:moveTo>
                  <a:lnTo>
                    <a:pt x="344" y="851"/>
                  </a:lnTo>
                  <a:lnTo>
                    <a:pt x="338" y="849"/>
                  </a:lnTo>
                  <a:lnTo>
                    <a:pt x="328" y="862"/>
                  </a:lnTo>
                  <a:lnTo>
                    <a:pt x="335" y="864"/>
                  </a:lnTo>
                  <a:close/>
                  <a:moveTo>
                    <a:pt x="347" y="847"/>
                  </a:moveTo>
                  <a:lnTo>
                    <a:pt x="356" y="834"/>
                  </a:lnTo>
                  <a:lnTo>
                    <a:pt x="350" y="832"/>
                  </a:lnTo>
                  <a:lnTo>
                    <a:pt x="341" y="845"/>
                  </a:lnTo>
                  <a:lnTo>
                    <a:pt x="347" y="847"/>
                  </a:lnTo>
                  <a:close/>
                  <a:moveTo>
                    <a:pt x="359" y="830"/>
                  </a:moveTo>
                  <a:lnTo>
                    <a:pt x="368" y="817"/>
                  </a:lnTo>
                  <a:lnTo>
                    <a:pt x="362" y="815"/>
                  </a:lnTo>
                  <a:lnTo>
                    <a:pt x="353" y="828"/>
                  </a:lnTo>
                  <a:lnTo>
                    <a:pt x="359" y="830"/>
                  </a:lnTo>
                  <a:close/>
                  <a:moveTo>
                    <a:pt x="371" y="812"/>
                  </a:moveTo>
                  <a:lnTo>
                    <a:pt x="381" y="799"/>
                  </a:lnTo>
                  <a:lnTo>
                    <a:pt x="374" y="797"/>
                  </a:lnTo>
                  <a:lnTo>
                    <a:pt x="365" y="810"/>
                  </a:lnTo>
                  <a:lnTo>
                    <a:pt x="371" y="812"/>
                  </a:lnTo>
                  <a:close/>
                  <a:moveTo>
                    <a:pt x="384" y="795"/>
                  </a:moveTo>
                  <a:lnTo>
                    <a:pt x="393" y="782"/>
                  </a:lnTo>
                  <a:lnTo>
                    <a:pt x="386" y="780"/>
                  </a:lnTo>
                  <a:lnTo>
                    <a:pt x="377" y="793"/>
                  </a:lnTo>
                  <a:lnTo>
                    <a:pt x="384" y="795"/>
                  </a:lnTo>
                  <a:close/>
                  <a:moveTo>
                    <a:pt x="396" y="778"/>
                  </a:moveTo>
                  <a:lnTo>
                    <a:pt x="405" y="765"/>
                  </a:lnTo>
                  <a:lnTo>
                    <a:pt x="398" y="763"/>
                  </a:lnTo>
                  <a:lnTo>
                    <a:pt x="389" y="776"/>
                  </a:lnTo>
                  <a:lnTo>
                    <a:pt x="396" y="778"/>
                  </a:lnTo>
                  <a:close/>
                  <a:moveTo>
                    <a:pt x="408" y="760"/>
                  </a:moveTo>
                  <a:lnTo>
                    <a:pt x="417" y="747"/>
                  </a:lnTo>
                  <a:lnTo>
                    <a:pt x="410" y="745"/>
                  </a:lnTo>
                  <a:lnTo>
                    <a:pt x="401" y="758"/>
                  </a:lnTo>
                  <a:lnTo>
                    <a:pt x="408" y="760"/>
                  </a:lnTo>
                  <a:close/>
                  <a:moveTo>
                    <a:pt x="420" y="743"/>
                  </a:moveTo>
                  <a:lnTo>
                    <a:pt x="429" y="730"/>
                  </a:lnTo>
                  <a:lnTo>
                    <a:pt x="423" y="728"/>
                  </a:lnTo>
                  <a:lnTo>
                    <a:pt x="414" y="741"/>
                  </a:lnTo>
                  <a:lnTo>
                    <a:pt x="420" y="743"/>
                  </a:lnTo>
                  <a:close/>
                  <a:moveTo>
                    <a:pt x="432" y="726"/>
                  </a:moveTo>
                  <a:lnTo>
                    <a:pt x="441" y="713"/>
                  </a:lnTo>
                  <a:lnTo>
                    <a:pt x="435" y="711"/>
                  </a:lnTo>
                  <a:lnTo>
                    <a:pt x="426" y="724"/>
                  </a:lnTo>
                  <a:lnTo>
                    <a:pt x="432" y="726"/>
                  </a:lnTo>
                  <a:close/>
                  <a:moveTo>
                    <a:pt x="444" y="708"/>
                  </a:moveTo>
                  <a:lnTo>
                    <a:pt x="453" y="695"/>
                  </a:lnTo>
                  <a:lnTo>
                    <a:pt x="447" y="693"/>
                  </a:lnTo>
                  <a:lnTo>
                    <a:pt x="438" y="706"/>
                  </a:lnTo>
                  <a:lnTo>
                    <a:pt x="444" y="708"/>
                  </a:lnTo>
                  <a:close/>
                  <a:moveTo>
                    <a:pt x="456" y="691"/>
                  </a:moveTo>
                  <a:lnTo>
                    <a:pt x="466" y="678"/>
                  </a:lnTo>
                  <a:lnTo>
                    <a:pt x="459" y="676"/>
                  </a:lnTo>
                  <a:lnTo>
                    <a:pt x="450" y="689"/>
                  </a:lnTo>
                  <a:lnTo>
                    <a:pt x="456" y="691"/>
                  </a:lnTo>
                  <a:close/>
                  <a:moveTo>
                    <a:pt x="469" y="674"/>
                  </a:moveTo>
                  <a:lnTo>
                    <a:pt x="478" y="661"/>
                  </a:lnTo>
                  <a:lnTo>
                    <a:pt x="471" y="659"/>
                  </a:lnTo>
                  <a:lnTo>
                    <a:pt x="462" y="672"/>
                  </a:lnTo>
                  <a:lnTo>
                    <a:pt x="469" y="674"/>
                  </a:lnTo>
                  <a:close/>
                  <a:moveTo>
                    <a:pt x="481" y="656"/>
                  </a:moveTo>
                  <a:lnTo>
                    <a:pt x="490" y="643"/>
                  </a:lnTo>
                  <a:lnTo>
                    <a:pt x="483" y="641"/>
                  </a:lnTo>
                  <a:lnTo>
                    <a:pt x="474" y="654"/>
                  </a:lnTo>
                  <a:lnTo>
                    <a:pt x="481" y="656"/>
                  </a:lnTo>
                  <a:close/>
                  <a:moveTo>
                    <a:pt x="493" y="639"/>
                  </a:moveTo>
                  <a:lnTo>
                    <a:pt x="502" y="626"/>
                  </a:lnTo>
                  <a:lnTo>
                    <a:pt x="495" y="624"/>
                  </a:lnTo>
                  <a:lnTo>
                    <a:pt x="486" y="637"/>
                  </a:lnTo>
                  <a:lnTo>
                    <a:pt x="493" y="639"/>
                  </a:lnTo>
                  <a:close/>
                  <a:moveTo>
                    <a:pt x="505" y="622"/>
                  </a:moveTo>
                  <a:lnTo>
                    <a:pt x="514" y="609"/>
                  </a:lnTo>
                  <a:lnTo>
                    <a:pt x="508" y="607"/>
                  </a:lnTo>
                  <a:lnTo>
                    <a:pt x="499" y="620"/>
                  </a:lnTo>
                  <a:lnTo>
                    <a:pt x="505" y="622"/>
                  </a:lnTo>
                  <a:close/>
                  <a:moveTo>
                    <a:pt x="517" y="604"/>
                  </a:moveTo>
                  <a:lnTo>
                    <a:pt x="526" y="591"/>
                  </a:lnTo>
                  <a:lnTo>
                    <a:pt x="520" y="589"/>
                  </a:lnTo>
                  <a:lnTo>
                    <a:pt x="511" y="602"/>
                  </a:lnTo>
                  <a:lnTo>
                    <a:pt x="517" y="604"/>
                  </a:lnTo>
                  <a:close/>
                  <a:moveTo>
                    <a:pt x="529" y="587"/>
                  </a:moveTo>
                  <a:lnTo>
                    <a:pt x="538" y="574"/>
                  </a:lnTo>
                  <a:lnTo>
                    <a:pt x="532" y="572"/>
                  </a:lnTo>
                  <a:lnTo>
                    <a:pt x="523" y="585"/>
                  </a:lnTo>
                  <a:lnTo>
                    <a:pt x="529" y="587"/>
                  </a:lnTo>
                  <a:close/>
                  <a:moveTo>
                    <a:pt x="542" y="570"/>
                  </a:moveTo>
                  <a:lnTo>
                    <a:pt x="551" y="557"/>
                  </a:lnTo>
                  <a:lnTo>
                    <a:pt x="544" y="555"/>
                  </a:lnTo>
                  <a:lnTo>
                    <a:pt x="535" y="568"/>
                  </a:lnTo>
                  <a:lnTo>
                    <a:pt x="542" y="570"/>
                  </a:lnTo>
                  <a:close/>
                  <a:moveTo>
                    <a:pt x="554" y="552"/>
                  </a:moveTo>
                  <a:lnTo>
                    <a:pt x="563" y="539"/>
                  </a:lnTo>
                  <a:lnTo>
                    <a:pt x="556" y="537"/>
                  </a:lnTo>
                  <a:lnTo>
                    <a:pt x="547" y="550"/>
                  </a:lnTo>
                  <a:lnTo>
                    <a:pt x="554" y="552"/>
                  </a:lnTo>
                  <a:close/>
                  <a:moveTo>
                    <a:pt x="566" y="535"/>
                  </a:moveTo>
                  <a:lnTo>
                    <a:pt x="575" y="522"/>
                  </a:lnTo>
                  <a:lnTo>
                    <a:pt x="568" y="520"/>
                  </a:lnTo>
                  <a:lnTo>
                    <a:pt x="559" y="533"/>
                  </a:lnTo>
                  <a:lnTo>
                    <a:pt x="566" y="535"/>
                  </a:lnTo>
                  <a:close/>
                  <a:moveTo>
                    <a:pt x="578" y="518"/>
                  </a:moveTo>
                  <a:lnTo>
                    <a:pt x="587" y="505"/>
                  </a:lnTo>
                  <a:lnTo>
                    <a:pt x="581" y="503"/>
                  </a:lnTo>
                  <a:lnTo>
                    <a:pt x="571" y="516"/>
                  </a:lnTo>
                  <a:lnTo>
                    <a:pt x="578" y="518"/>
                  </a:lnTo>
                  <a:close/>
                  <a:moveTo>
                    <a:pt x="590" y="500"/>
                  </a:moveTo>
                  <a:lnTo>
                    <a:pt x="599" y="487"/>
                  </a:lnTo>
                  <a:lnTo>
                    <a:pt x="593" y="485"/>
                  </a:lnTo>
                  <a:lnTo>
                    <a:pt x="584" y="498"/>
                  </a:lnTo>
                  <a:lnTo>
                    <a:pt x="590" y="500"/>
                  </a:lnTo>
                  <a:close/>
                  <a:moveTo>
                    <a:pt x="602" y="483"/>
                  </a:moveTo>
                  <a:lnTo>
                    <a:pt x="611" y="470"/>
                  </a:lnTo>
                  <a:lnTo>
                    <a:pt x="605" y="468"/>
                  </a:lnTo>
                  <a:lnTo>
                    <a:pt x="596" y="481"/>
                  </a:lnTo>
                  <a:lnTo>
                    <a:pt x="602" y="483"/>
                  </a:lnTo>
                  <a:close/>
                  <a:moveTo>
                    <a:pt x="614" y="466"/>
                  </a:moveTo>
                  <a:lnTo>
                    <a:pt x="624" y="453"/>
                  </a:lnTo>
                  <a:lnTo>
                    <a:pt x="617" y="451"/>
                  </a:lnTo>
                  <a:lnTo>
                    <a:pt x="608" y="464"/>
                  </a:lnTo>
                  <a:lnTo>
                    <a:pt x="614" y="466"/>
                  </a:lnTo>
                  <a:close/>
                  <a:moveTo>
                    <a:pt x="627" y="449"/>
                  </a:moveTo>
                  <a:lnTo>
                    <a:pt x="636" y="436"/>
                  </a:lnTo>
                  <a:lnTo>
                    <a:pt x="629" y="434"/>
                  </a:lnTo>
                  <a:lnTo>
                    <a:pt x="620" y="447"/>
                  </a:lnTo>
                  <a:lnTo>
                    <a:pt x="627" y="449"/>
                  </a:lnTo>
                  <a:close/>
                  <a:moveTo>
                    <a:pt x="639" y="431"/>
                  </a:moveTo>
                  <a:lnTo>
                    <a:pt x="648" y="418"/>
                  </a:lnTo>
                  <a:lnTo>
                    <a:pt x="641" y="416"/>
                  </a:lnTo>
                  <a:lnTo>
                    <a:pt x="632" y="429"/>
                  </a:lnTo>
                  <a:lnTo>
                    <a:pt x="639" y="431"/>
                  </a:lnTo>
                  <a:close/>
                  <a:moveTo>
                    <a:pt x="651" y="414"/>
                  </a:moveTo>
                  <a:lnTo>
                    <a:pt x="660" y="401"/>
                  </a:lnTo>
                  <a:lnTo>
                    <a:pt x="653" y="399"/>
                  </a:lnTo>
                  <a:lnTo>
                    <a:pt x="644" y="412"/>
                  </a:lnTo>
                  <a:lnTo>
                    <a:pt x="651" y="414"/>
                  </a:lnTo>
                  <a:close/>
                  <a:moveTo>
                    <a:pt x="663" y="397"/>
                  </a:moveTo>
                  <a:lnTo>
                    <a:pt x="672" y="384"/>
                  </a:lnTo>
                  <a:lnTo>
                    <a:pt x="666" y="382"/>
                  </a:lnTo>
                  <a:lnTo>
                    <a:pt x="656" y="395"/>
                  </a:lnTo>
                  <a:lnTo>
                    <a:pt x="663" y="397"/>
                  </a:lnTo>
                  <a:close/>
                  <a:moveTo>
                    <a:pt x="675" y="379"/>
                  </a:moveTo>
                  <a:lnTo>
                    <a:pt x="684" y="366"/>
                  </a:lnTo>
                  <a:lnTo>
                    <a:pt x="678" y="364"/>
                  </a:lnTo>
                  <a:lnTo>
                    <a:pt x="669" y="377"/>
                  </a:lnTo>
                  <a:lnTo>
                    <a:pt x="675" y="379"/>
                  </a:lnTo>
                  <a:close/>
                  <a:moveTo>
                    <a:pt x="687" y="362"/>
                  </a:moveTo>
                  <a:lnTo>
                    <a:pt x="696" y="349"/>
                  </a:lnTo>
                  <a:lnTo>
                    <a:pt x="690" y="347"/>
                  </a:lnTo>
                  <a:lnTo>
                    <a:pt x="681" y="360"/>
                  </a:lnTo>
                  <a:lnTo>
                    <a:pt x="687" y="362"/>
                  </a:lnTo>
                  <a:close/>
                  <a:moveTo>
                    <a:pt x="699" y="345"/>
                  </a:moveTo>
                  <a:lnTo>
                    <a:pt x="709" y="332"/>
                  </a:lnTo>
                  <a:lnTo>
                    <a:pt x="702" y="330"/>
                  </a:lnTo>
                  <a:lnTo>
                    <a:pt x="693" y="343"/>
                  </a:lnTo>
                  <a:lnTo>
                    <a:pt x="699" y="345"/>
                  </a:lnTo>
                  <a:close/>
                  <a:moveTo>
                    <a:pt x="712" y="327"/>
                  </a:moveTo>
                  <a:lnTo>
                    <a:pt x="721" y="314"/>
                  </a:lnTo>
                  <a:lnTo>
                    <a:pt x="714" y="312"/>
                  </a:lnTo>
                  <a:lnTo>
                    <a:pt x="705" y="325"/>
                  </a:lnTo>
                  <a:lnTo>
                    <a:pt x="712" y="327"/>
                  </a:lnTo>
                  <a:close/>
                  <a:moveTo>
                    <a:pt x="724" y="310"/>
                  </a:moveTo>
                  <a:lnTo>
                    <a:pt x="733" y="297"/>
                  </a:lnTo>
                  <a:lnTo>
                    <a:pt x="726" y="295"/>
                  </a:lnTo>
                  <a:lnTo>
                    <a:pt x="717" y="308"/>
                  </a:lnTo>
                  <a:lnTo>
                    <a:pt x="724" y="310"/>
                  </a:lnTo>
                  <a:close/>
                  <a:moveTo>
                    <a:pt x="736" y="293"/>
                  </a:moveTo>
                  <a:lnTo>
                    <a:pt x="745" y="280"/>
                  </a:lnTo>
                  <a:lnTo>
                    <a:pt x="739" y="278"/>
                  </a:lnTo>
                  <a:lnTo>
                    <a:pt x="729" y="291"/>
                  </a:lnTo>
                  <a:lnTo>
                    <a:pt x="736" y="293"/>
                  </a:lnTo>
                  <a:close/>
                  <a:moveTo>
                    <a:pt x="748" y="275"/>
                  </a:moveTo>
                  <a:lnTo>
                    <a:pt x="757" y="262"/>
                  </a:lnTo>
                  <a:lnTo>
                    <a:pt x="751" y="260"/>
                  </a:lnTo>
                  <a:lnTo>
                    <a:pt x="742" y="273"/>
                  </a:lnTo>
                  <a:lnTo>
                    <a:pt x="748" y="275"/>
                  </a:lnTo>
                  <a:close/>
                  <a:moveTo>
                    <a:pt x="760" y="258"/>
                  </a:moveTo>
                  <a:lnTo>
                    <a:pt x="769" y="245"/>
                  </a:lnTo>
                  <a:lnTo>
                    <a:pt x="763" y="243"/>
                  </a:lnTo>
                  <a:lnTo>
                    <a:pt x="754" y="256"/>
                  </a:lnTo>
                  <a:lnTo>
                    <a:pt x="760" y="258"/>
                  </a:lnTo>
                  <a:close/>
                  <a:moveTo>
                    <a:pt x="772" y="241"/>
                  </a:moveTo>
                  <a:lnTo>
                    <a:pt x="782" y="228"/>
                  </a:lnTo>
                  <a:lnTo>
                    <a:pt x="775" y="226"/>
                  </a:lnTo>
                  <a:lnTo>
                    <a:pt x="766" y="239"/>
                  </a:lnTo>
                  <a:lnTo>
                    <a:pt x="772" y="241"/>
                  </a:lnTo>
                  <a:close/>
                  <a:moveTo>
                    <a:pt x="785" y="223"/>
                  </a:moveTo>
                  <a:lnTo>
                    <a:pt x="794" y="210"/>
                  </a:lnTo>
                  <a:lnTo>
                    <a:pt x="787" y="208"/>
                  </a:lnTo>
                  <a:lnTo>
                    <a:pt x="778" y="221"/>
                  </a:lnTo>
                  <a:lnTo>
                    <a:pt x="785" y="223"/>
                  </a:lnTo>
                  <a:close/>
                  <a:moveTo>
                    <a:pt x="797" y="206"/>
                  </a:moveTo>
                  <a:lnTo>
                    <a:pt x="806" y="193"/>
                  </a:lnTo>
                  <a:lnTo>
                    <a:pt x="799" y="191"/>
                  </a:lnTo>
                  <a:lnTo>
                    <a:pt x="790" y="204"/>
                  </a:lnTo>
                  <a:lnTo>
                    <a:pt x="797" y="206"/>
                  </a:lnTo>
                  <a:close/>
                  <a:moveTo>
                    <a:pt x="809" y="189"/>
                  </a:moveTo>
                  <a:lnTo>
                    <a:pt x="818" y="176"/>
                  </a:lnTo>
                  <a:lnTo>
                    <a:pt x="811" y="174"/>
                  </a:lnTo>
                  <a:lnTo>
                    <a:pt x="802" y="187"/>
                  </a:lnTo>
                  <a:lnTo>
                    <a:pt x="809" y="189"/>
                  </a:lnTo>
                  <a:close/>
                  <a:moveTo>
                    <a:pt x="821" y="171"/>
                  </a:moveTo>
                  <a:lnTo>
                    <a:pt x="830" y="158"/>
                  </a:lnTo>
                  <a:lnTo>
                    <a:pt x="824" y="156"/>
                  </a:lnTo>
                  <a:lnTo>
                    <a:pt x="815" y="169"/>
                  </a:lnTo>
                  <a:lnTo>
                    <a:pt x="821" y="171"/>
                  </a:lnTo>
                  <a:close/>
                  <a:moveTo>
                    <a:pt x="833" y="154"/>
                  </a:moveTo>
                  <a:lnTo>
                    <a:pt x="842" y="141"/>
                  </a:lnTo>
                  <a:lnTo>
                    <a:pt x="836" y="139"/>
                  </a:lnTo>
                  <a:lnTo>
                    <a:pt x="827" y="152"/>
                  </a:lnTo>
                  <a:lnTo>
                    <a:pt x="833" y="154"/>
                  </a:lnTo>
                  <a:close/>
                  <a:moveTo>
                    <a:pt x="845" y="137"/>
                  </a:moveTo>
                  <a:lnTo>
                    <a:pt x="854" y="124"/>
                  </a:lnTo>
                  <a:lnTo>
                    <a:pt x="848" y="122"/>
                  </a:lnTo>
                  <a:lnTo>
                    <a:pt x="839" y="135"/>
                  </a:lnTo>
                  <a:lnTo>
                    <a:pt x="845" y="137"/>
                  </a:lnTo>
                  <a:close/>
                  <a:moveTo>
                    <a:pt x="858" y="119"/>
                  </a:moveTo>
                  <a:lnTo>
                    <a:pt x="867" y="106"/>
                  </a:lnTo>
                  <a:lnTo>
                    <a:pt x="860" y="104"/>
                  </a:lnTo>
                  <a:lnTo>
                    <a:pt x="851" y="117"/>
                  </a:lnTo>
                  <a:lnTo>
                    <a:pt x="858" y="119"/>
                  </a:lnTo>
                  <a:close/>
                  <a:moveTo>
                    <a:pt x="870" y="102"/>
                  </a:moveTo>
                  <a:lnTo>
                    <a:pt x="879" y="89"/>
                  </a:lnTo>
                  <a:lnTo>
                    <a:pt x="872" y="87"/>
                  </a:lnTo>
                  <a:lnTo>
                    <a:pt x="863" y="100"/>
                  </a:lnTo>
                  <a:lnTo>
                    <a:pt x="870" y="102"/>
                  </a:lnTo>
                  <a:close/>
                  <a:moveTo>
                    <a:pt x="882" y="85"/>
                  </a:moveTo>
                  <a:lnTo>
                    <a:pt x="891" y="72"/>
                  </a:lnTo>
                  <a:lnTo>
                    <a:pt x="884" y="70"/>
                  </a:lnTo>
                  <a:lnTo>
                    <a:pt x="875" y="83"/>
                  </a:lnTo>
                  <a:lnTo>
                    <a:pt x="882" y="85"/>
                  </a:lnTo>
                  <a:close/>
                  <a:moveTo>
                    <a:pt x="894" y="67"/>
                  </a:moveTo>
                  <a:lnTo>
                    <a:pt x="903" y="55"/>
                  </a:lnTo>
                  <a:lnTo>
                    <a:pt x="896" y="52"/>
                  </a:lnTo>
                  <a:lnTo>
                    <a:pt x="887" y="65"/>
                  </a:lnTo>
                  <a:lnTo>
                    <a:pt x="894" y="67"/>
                  </a:lnTo>
                  <a:close/>
                  <a:moveTo>
                    <a:pt x="906" y="50"/>
                  </a:moveTo>
                  <a:lnTo>
                    <a:pt x="915" y="37"/>
                  </a:lnTo>
                  <a:lnTo>
                    <a:pt x="909" y="35"/>
                  </a:lnTo>
                  <a:lnTo>
                    <a:pt x="900" y="48"/>
                  </a:lnTo>
                  <a:lnTo>
                    <a:pt x="906" y="50"/>
                  </a:lnTo>
                  <a:close/>
                  <a:moveTo>
                    <a:pt x="918" y="33"/>
                  </a:moveTo>
                  <a:lnTo>
                    <a:pt x="927" y="20"/>
                  </a:lnTo>
                  <a:lnTo>
                    <a:pt x="921" y="18"/>
                  </a:lnTo>
                  <a:lnTo>
                    <a:pt x="912" y="31"/>
                  </a:lnTo>
                  <a:lnTo>
                    <a:pt x="918" y="33"/>
                  </a:lnTo>
                  <a:close/>
                  <a:moveTo>
                    <a:pt x="930" y="16"/>
                  </a:moveTo>
                  <a:lnTo>
                    <a:pt x="939" y="3"/>
                  </a:lnTo>
                  <a:lnTo>
                    <a:pt x="933" y="0"/>
                  </a:lnTo>
                  <a:lnTo>
                    <a:pt x="924" y="14"/>
                  </a:lnTo>
                  <a:lnTo>
                    <a:pt x="930" y="16"/>
                  </a:lnTo>
                  <a:close/>
                </a:path>
              </a:pathLst>
            </a:custGeom>
            <a:solidFill>
              <a:srgbClr val="D0CECE"/>
            </a:solidFill>
            <a:ln w="0" cap="flat">
              <a:solidFill>
                <a:srgbClr val="D0CECE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51" name="Freeform 89"/>
            <p:cNvSpPr>
              <a:spLocks noEditPoints="1"/>
            </p:cNvSpPr>
            <p:nvPr/>
          </p:nvSpPr>
          <p:spPr bwMode="auto">
            <a:xfrm>
              <a:off x="2815" y="891"/>
              <a:ext cx="1335" cy="1757"/>
            </a:xfrm>
            <a:custGeom>
              <a:avLst/>
              <a:gdLst>
                <a:gd name="T0" fmla="*/ 17 w 940"/>
                <a:gd name="T1" fmla="*/ 1690 h 1723"/>
                <a:gd name="T2" fmla="*/ 36 w 940"/>
                <a:gd name="T3" fmla="*/ 1669 h 1723"/>
                <a:gd name="T4" fmla="*/ 39 w 940"/>
                <a:gd name="T5" fmla="*/ 1649 h 1723"/>
                <a:gd name="T6" fmla="*/ 73 w 940"/>
                <a:gd name="T7" fmla="*/ 1602 h 1723"/>
                <a:gd name="T8" fmla="*/ 75 w 940"/>
                <a:gd name="T9" fmla="*/ 1597 h 1723"/>
                <a:gd name="T10" fmla="*/ 95 w 940"/>
                <a:gd name="T11" fmla="*/ 1546 h 1723"/>
                <a:gd name="T12" fmla="*/ 114 w 940"/>
                <a:gd name="T13" fmla="*/ 1525 h 1723"/>
                <a:gd name="T14" fmla="*/ 117 w 940"/>
                <a:gd name="T15" fmla="*/ 1506 h 1723"/>
                <a:gd name="T16" fmla="*/ 151 w 940"/>
                <a:gd name="T17" fmla="*/ 1458 h 1723"/>
                <a:gd name="T18" fmla="*/ 153 w 940"/>
                <a:gd name="T19" fmla="*/ 1453 h 1723"/>
                <a:gd name="T20" fmla="*/ 173 w 940"/>
                <a:gd name="T21" fmla="*/ 1402 h 1723"/>
                <a:gd name="T22" fmla="*/ 192 w 940"/>
                <a:gd name="T23" fmla="*/ 1381 h 1723"/>
                <a:gd name="T24" fmla="*/ 195 w 940"/>
                <a:gd name="T25" fmla="*/ 1362 h 1723"/>
                <a:gd name="T26" fmla="*/ 229 w 940"/>
                <a:gd name="T27" fmla="*/ 1314 h 1723"/>
                <a:gd name="T28" fmla="*/ 231 w 940"/>
                <a:gd name="T29" fmla="*/ 1310 h 1723"/>
                <a:gd name="T30" fmla="*/ 251 w 940"/>
                <a:gd name="T31" fmla="*/ 1258 h 1723"/>
                <a:gd name="T32" fmla="*/ 270 w 940"/>
                <a:gd name="T33" fmla="*/ 1238 h 1723"/>
                <a:gd name="T34" fmla="*/ 273 w 940"/>
                <a:gd name="T35" fmla="*/ 1218 h 1723"/>
                <a:gd name="T36" fmla="*/ 307 w 940"/>
                <a:gd name="T37" fmla="*/ 1170 h 1723"/>
                <a:gd name="T38" fmla="*/ 309 w 940"/>
                <a:gd name="T39" fmla="*/ 1166 h 1723"/>
                <a:gd name="T40" fmla="*/ 329 w 940"/>
                <a:gd name="T41" fmla="*/ 1115 h 1723"/>
                <a:gd name="T42" fmla="*/ 348 w 940"/>
                <a:gd name="T43" fmla="*/ 1094 h 1723"/>
                <a:gd name="T44" fmla="*/ 351 w 940"/>
                <a:gd name="T45" fmla="*/ 1074 h 1723"/>
                <a:gd name="T46" fmla="*/ 385 w 940"/>
                <a:gd name="T47" fmla="*/ 1026 h 1723"/>
                <a:gd name="T48" fmla="*/ 387 w 940"/>
                <a:gd name="T49" fmla="*/ 1022 h 1723"/>
                <a:gd name="T50" fmla="*/ 407 w 940"/>
                <a:gd name="T51" fmla="*/ 971 h 1723"/>
                <a:gd name="T52" fmla="*/ 426 w 940"/>
                <a:gd name="T53" fmla="*/ 950 h 1723"/>
                <a:gd name="T54" fmla="*/ 429 w 940"/>
                <a:gd name="T55" fmla="*/ 930 h 1723"/>
                <a:gd name="T56" fmla="*/ 463 w 940"/>
                <a:gd name="T57" fmla="*/ 883 h 1723"/>
                <a:gd name="T58" fmla="*/ 465 w 940"/>
                <a:gd name="T59" fmla="*/ 878 h 1723"/>
                <a:gd name="T60" fmla="*/ 485 w 940"/>
                <a:gd name="T61" fmla="*/ 827 h 1723"/>
                <a:gd name="T62" fmla="*/ 504 w 940"/>
                <a:gd name="T63" fmla="*/ 806 h 1723"/>
                <a:gd name="T64" fmla="*/ 507 w 940"/>
                <a:gd name="T65" fmla="*/ 787 h 1723"/>
                <a:gd name="T66" fmla="*/ 541 w 940"/>
                <a:gd name="T67" fmla="*/ 739 h 1723"/>
                <a:gd name="T68" fmla="*/ 543 w 940"/>
                <a:gd name="T69" fmla="*/ 734 h 1723"/>
                <a:gd name="T70" fmla="*/ 563 w 940"/>
                <a:gd name="T71" fmla="*/ 683 h 1723"/>
                <a:gd name="T72" fmla="*/ 582 w 940"/>
                <a:gd name="T73" fmla="*/ 662 h 1723"/>
                <a:gd name="T74" fmla="*/ 585 w 940"/>
                <a:gd name="T75" fmla="*/ 643 h 1723"/>
                <a:gd name="T76" fmla="*/ 619 w 940"/>
                <a:gd name="T77" fmla="*/ 595 h 1723"/>
                <a:gd name="T78" fmla="*/ 621 w 940"/>
                <a:gd name="T79" fmla="*/ 591 h 1723"/>
                <a:gd name="T80" fmla="*/ 641 w 940"/>
                <a:gd name="T81" fmla="*/ 539 h 1723"/>
                <a:gd name="T82" fmla="*/ 660 w 940"/>
                <a:gd name="T83" fmla="*/ 519 h 1723"/>
                <a:gd name="T84" fmla="*/ 663 w 940"/>
                <a:gd name="T85" fmla="*/ 499 h 1723"/>
                <a:gd name="T86" fmla="*/ 696 w 940"/>
                <a:gd name="T87" fmla="*/ 451 h 1723"/>
                <a:gd name="T88" fmla="*/ 699 w 940"/>
                <a:gd name="T89" fmla="*/ 447 h 1723"/>
                <a:gd name="T90" fmla="*/ 719 w 940"/>
                <a:gd name="T91" fmla="*/ 396 h 1723"/>
                <a:gd name="T92" fmla="*/ 738 w 940"/>
                <a:gd name="T93" fmla="*/ 375 h 1723"/>
                <a:gd name="T94" fmla="*/ 741 w 940"/>
                <a:gd name="T95" fmla="*/ 355 h 1723"/>
                <a:gd name="T96" fmla="*/ 774 w 940"/>
                <a:gd name="T97" fmla="*/ 307 h 1723"/>
                <a:gd name="T98" fmla="*/ 777 w 940"/>
                <a:gd name="T99" fmla="*/ 303 h 1723"/>
                <a:gd name="T100" fmla="*/ 797 w 940"/>
                <a:gd name="T101" fmla="*/ 252 h 1723"/>
                <a:gd name="T102" fmla="*/ 816 w 940"/>
                <a:gd name="T103" fmla="*/ 231 h 1723"/>
                <a:gd name="T104" fmla="*/ 819 w 940"/>
                <a:gd name="T105" fmla="*/ 211 h 1723"/>
                <a:gd name="T106" fmla="*/ 852 w 940"/>
                <a:gd name="T107" fmla="*/ 164 h 1723"/>
                <a:gd name="T108" fmla="*/ 855 w 940"/>
                <a:gd name="T109" fmla="*/ 159 h 1723"/>
                <a:gd name="T110" fmla="*/ 875 w 940"/>
                <a:gd name="T111" fmla="*/ 108 h 1723"/>
                <a:gd name="T112" fmla="*/ 894 w 940"/>
                <a:gd name="T113" fmla="*/ 87 h 1723"/>
                <a:gd name="T114" fmla="*/ 897 w 940"/>
                <a:gd name="T115" fmla="*/ 68 h 1723"/>
                <a:gd name="T116" fmla="*/ 930 w 940"/>
                <a:gd name="T117" fmla="*/ 20 h 1723"/>
                <a:gd name="T118" fmla="*/ 933 w 940"/>
                <a:gd name="T119" fmla="*/ 15 h 17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940" h="1723">
                  <a:moveTo>
                    <a:pt x="7" y="1723"/>
                  </a:moveTo>
                  <a:lnTo>
                    <a:pt x="14" y="1710"/>
                  </a:lnTo>
                  <a:lnTo>
                    <a:pt x="7" y="1708"/>
                  </a:lnTo>
                  <a:lnTo>
                    <a:pt x="0" y="1721"/>
                  </a:lnTo>
                  <a:lnTo>
                    <a:pt x="7" y="1723"/>
                  </a:lnTo>
                  <a:close/>
                  <a:moveTo>
                    <a:pt x="17" y="1705"/>
                  </a:moveTo>
                  <a:lnTo>
                    <a:pt x="24" y="1692"/>
                  </a:lnTo>
                  <a:lnTo>
                    <a:pt x="17" y="1690"/>
                  </a:lnTo>
                  <a:lnTo>
                    <a:pt x="10" y="1703"/>
                  </a:lnTo>
                  <a:lnTo>
                    <a:pt x="17" y="1705"/>
                  </a:lnTo>
                  <a:close/>
                  <a:moveTo>
                    <a:pt x="26" y="1687"/>
                  </a:moveTo>
                  <a:lnTo>
                    <a:pt x="34" y="1674"/>
                  </a:lnTo>
                  <a:lnTo>
                    <a:pt x="27" y="1672"/>
                  </a:lnTo>
                  <a:lnTo>
                    <a:pt x="20" y="1685"/>
                  </a:lnTo>
                  <a:lnTo>
                    <a:pt x="26" y="1687"/>
                  </a:lnTo>
                  <a:close/>
                  <a:moveTo>
                    <a:pt x="36" y="1669"/>
                  </a:moveTo>
                  <a:lnTo>
                    <a:pt x="43" y="1656"/>
                  </a:lnTo>
                  <a:lnTo>
                    <a:pt x="37" y="1654"/>
                  </a:lnTo>
                  <a:lnTo>
                    <a:pt x="29" y="1667"/>
                  </a:lnTo>
                  <a:lnTo>
                    <a:pt x="36" y="1669"/>
                  </a:lnTo>
                  <a:close/>
                  <a:moveTo>
                    <a:pt x="46" y="1651"/>
                  </a:moveTo>
                  <a:lnTo>
                    <a:pt x="53" y="1638"/>
                  </a:lnTo>
                  <a:lnTo>
                    <a:pt x="47" y="1636"/>
                  </a:lnTo>
                  <a:lnTo>
                    <a:pt x="39" y="1649"/>
                  </a:lnTo>
                  <a:lnTo>
                    <a:pt x="46" y="1651"/>
                  </a:lnTo>
                  <a:close/>
                  <a:moveTo>
                    <a:pt x="56" y="1633"/>
                  </a:moveTo>
                  <a:lnTo>
                    <a:pt x="63" y="1620"/>
                  </a:lnTo>
                  <a:lnTo>
                    <a:pt x="56" y="1618"/>
                  </a:lnTo>
                  <a:lnTo>
                    <a:pt x="49" y="1631"/>
                  </a:lnTo>
                  <a:lnTo>
                    <a:pt x="56" y="1633"/>
                  </a:lnTo>
                  <a:close/>
                  <a:moveTo>
                    <a:pt x="65" y="1615"/>
                  </a:moveTo>
                  <a:lnTo>
                    <a:pt x="73" y="1602"/>
                  </a:lnTo>
                  <a:lnTo>
                    <a:pt x="66" y="1600"/>
                  </a:lnTo>
                  <a:lnTo>
                    <a:pt x="59" y="1613"/>
                  </a:lnTo>
                  <a:lnTo>
                    <a:pt x="65" y="1615"/>
                  </a:lnTo>
                  <a:close/>
                  <a:moveTo>
                    <a:pt x="75" y="1597"/>
                  </a:moveTo>
                  <a:lnTo>
                    <a:pt x="82" y="1584"/>
                  </a:lnTo>
                  <a:lnTo>
                    <a:pt x="76" y="1582"/>
                  </a:lnTo>
                  <a:lnTo>
                    <a:pt x="68" y="1595"/>
                  </a:lnTo>
                  <a:lnTo>
                    <a:pt x="75" y="1597"/>
                  </a:lnTo>
                  <a:close/>
                  <a:moveTo>
                    <a:pt x="85" y="1579"/>
                  </a:moveTo>
                  <a:lnTo>
                    <a:pt x="92" y="1566"/>
                  </a:lnTo>
                  <a:lnTo>
                    <a:pt x="85" y="1564"/>
                  </a:lnTo>
                  <a:lnTo>
                    <a:pt x="78" y="1578"/>
                  </a:lnTo>
                  <a:lnTo>
                    <a:pt x="85" y="1579"/>
                  </a:lnTo>
                  <a:close/>
                  <a:moveTo>
                    <a:pt x="95" y="1561"/>
                  </a:moveTo>
                  <a:lnTo>
                    <a:pt x="102" y="1548"/>
                  </a:lnTo>
                  <a:lnTo>
                    <a:pt x="95" y="1546"/>
                  </a:lnTo>
                  <a:lnTo>
                    <a:pt x="88" y="1560"/>
                  </a:lnTo>
                  <a:lnTo>
                    <a:pt x="95" y="1561"/>
                  </a:lnTo>
                  <a:close/>
                  <a:moveTo>
                    <a:pt x="104" y="1543"/>
                  </a:moveTo>
                  <a:lnTo>
                    <a:pt x="112" y="1530"/>
                  </a:lnTo>
                  <a:lnTo>
                    <a:pt x="105" y="1528"/>
                  </a:lnTo>
                  <a:lnTo>
                    <a:pt x="98" y="1542"/>
                  </a:lnTo>
                  <a:lnTo>
                    <a:pt x="104" y="1543"/>
                  </a:lnTo>
                  <a:close/>
                  <a:moveTo>
                    <a:pt x="114" y="1525"/>
                  </a:moveTo>
                  <a:lnTo>
                    <a:pt x="122" y="1512"/>
                  </a:lnTo>
                  <a:lnTo>
                    <a:pt x="115" y="1510"/>
                  </a:lnTo>
                  <a:lnTo>
                    <a:pt x="107" y="1524"/>
                  </a:lnTo>
                  <a:lnTo>
                    <a:pt x="114" y="1525"/>
                  </a:lnTo>
                  <a:close/>
                  <a:moveTo>
                    <a:pt x="124" y="1507"/>
                  </a:moveTo>
                  <a:lnTo>
                    <a:pt x="131" y="1494"/>
                  </a:lnTo>
                  <a:lnTo>
                    <a:pt x="124" y="1492"/>
                  </a:lnTo>
                  <a:lnTo>
                    <a:pt x="117" y="1506"/>
                  </a:lnTo>
                  <a:lnTo>
                    <a:pt x="124" y="1507"/>
                  </a:lnTo>
                  <a:close/>
                  <a:moveTo>
                    <a:pt x="134" y="1489"/>
                  </a:moveTo>
                  <a:lnTo>
                    <a:pt x="141" y="1476"/>
                  </a:lnTo>
                  <a:lnTo>
                    <a:pt x="134" y="1474"/>
                  </a:lnTo>
                  <a:lnTo>
                    <a:pt x="127" y="1488"/>
                  </a:lnTo>
                  <a:lnTo>
                    <a:pt x="134" y="1489"/>
                  </a:lnTo>
                  <a:close/>
                  <a:moveTo>
                    <a:pt x="143" y="1471"/>
                  </a:moveTo>
                  <a:lnTo>
                    <a:pt x="151" y="1458"/>
                  </a:lnTo>
                  <a:lnTo>
                    <a:pt x="144" y="1456"/>
                  </a:lnTo>
                  <a:lnTo>
                    <a:pt x="137" y="1470"/>
                  </a:lnTo>
                  <a:lnTo>
                    <a:pt x="143" y="1471"/>
                  </a:lnTo>
                  <a:close/>
                  <a:moveTo>
                    <a:pt x="153" y="1453"/>
                  </a:moveTo>
                  <a:lnTo>
                    <a:pt x="160" y="1440"/>
                  </a:lnTo>
                  <a:lnTo>
                    <a:pt x="154" y="1438"/>
                  </a:lnTo>
                  <a:lnTo>
                    <a:pt x="146" y="1452"/>
                  </a:lnTo>
                  <a:lnTo>
                    <a:pt x="153" y="1453"/>
                  </a:lnTo>
                  <a:close/>
                  <a:moveTo>
                    <a:pt x="163" y="1435"/>
                  </a:moveTo>
                  <a:lnTo>
                    <a:pt x="170" y="1422"/>
                  </a:lnTo>
                  <a:lnTo>
                    <a:pt x="163" y="1420"/>
                  </a:lnTo>
                  <a:lnTo>
                    <a:pt x="156" y="1434"/>
                  </a:lnTo>
                  <a:lnTo>
                    <a:pt x="163" y="1435"/>
                  </a:lnTo>
                  <a:close/>
                  <a:moveTo>
                    <a:pt x="173" y="1417"/>
                  </a:moveTo>
                  <a:lnTo>
                    <a:pt x="180" y="1404"/>
                  </a:lnTo>
                  <a:lnTo>
                    <a:pt x="173" y="1402"/>
                  </a:lnTo>
                  <a:lnTo>
                    <a:pt x="166" y="1416"/>
                  </a:lnTo>
                  <a:lnTo>
                    <a:pt x="173" y="1417"/>
                  </a:lnTo>
                  <a:close/>
                  <a:moveTo>
                    <a:pt x="182" y="1399"/>
                  </a:moveTo>
                  <a:lnTo>
                    <a:pt x="190" y="1386"/>
                  </a:lnTo>
                  <a:lnTo>
                    <a:pt x="183" y="1384"/>
                  </a:lnTo>
                  <a:lnTo>
                    <a:pt x="176" y="1398"/>
                  </a:lnTo>
                  <a:lnTo>
                    <a:pt x="182" y="1399"/>
                  </a:lnTo>
                  <a:close/>
                  <a:moveTo>
                    <a:pt x="192" y="1381"/>
                  </a:moveTo>
                  <a:lnTo>
                    <a:pt x="199" y="1368"/>
                  </a:lnTo>
                  <a:lnTo>
                    <a:pt x="193" y="1366"/>
                  </a:lnTo>
                  <a:lnTo>
                    <a:pt x="185" y="1380"/>
                  </a:lnTo>
                  <a:lnTo>
                    <a:pt x="192" y="1381"/>
                  </a:lnTo>
                  <a:close/>
                  <a:moveTo>
                    <a:pt x="202" y="1363"/>
                  </a:moveTo>
                  <a:lnTo>
                    <a:pt x="209" y="1350"/>
                  </a:lnTo>
                  <a:lnTo>
                    <a:pt x="202" y="1348"/>
                  </a:lnTo>
                  <a:lnTo>
                    <a:pt x="195" y="1362"/>
                  </a:lnTo>
                  <a:lnTo>
                    <a:pt x="202" y="1363"/>
                  </a:lnTo>
                  <a:close/>
                  <a:moveTo>
                    <a:pt x="212" y="1345"/>
                  </a:moveTo>
                  <a:lnTo>
                    <a:pt x="219" y="1332"/>
                  </a:lnTo>
                  <a:lnTo>
                    <a:pt x="212" y="1330"/>
                  </a:lnTo>
                  <a:lnTo>
                    <a:pt x="205" y="1344"/>
                  </a:lnTo>
                  <a:lnTo>
                    <a:pt x="212" y="1345"/>
                  </a:lnTo>
                  <a:close/>
                  <a:moveTo>
                    <a:pt x="221" y="1327"/>
                  </a:moveTo>
                  <a:lnTo>
                    <a:pt x="229" y="1314"/>
                  </a:lnTo>
                  <a:lnTo>
                    <a:pt x="222" y="1312"/>
                  </a:lnTo>
                  <a:lnTo>
                    <a:pt x="215" y="1326"/>
                  </a:lnTo>
                  <a:lnTo>
                    <a:pt x="221" y="1327"/>
                  </a:lnTo>
                  <a:close/>
                  <a:moveTo>
                    <a:pt x="231" y="1310"/>
                  </a:moveTo>
                  <a:lnTo>
                    <a:pt x="238" y="1296"/>
                  </a:lnTo>
                  <a:lnTo>
                    <a:pt x="232" y="1294"/>
                  </a:lnTo>
                  <a:lnTo>
                    <a:pt x="224" y="1308"/>
                  </a:lnTo>
                  <a:lnTo>
                    <a:pt x="231" y="1310"/>
                  </a:lnTo>
                  <a:close/>
                  <a:moveTo>
                    <a:pt x="241" y="1292"/>
                  </a:moveTo>
                  <a:lnTo>
                    <a:pt x="248" y="1278"/>
                  </a:lnTo>
                  <a:lnTo>
                    <a:pt x="241" y="1276"/>
                  </a:lnTo>
                  <a:lnTo>
                    <a:pt x="234" y="1290"/>
                  </a:lnTo>
                  <a:lnTo>
                    <a:pt x="241" y="1292"/>
                  </a:lnTo>
                  <a:close/>
                  <a:moveTo>
                    <a:pt x="251" y="1274"/>
                  </a:moveTo>
                  <a:lnTo>
                    <a:pt x="258" y="1260"/>
                  </a:lnTo>
                  <a:lnTo>
                    <a:pt x="251" y="1258"/>
                  </a:lnTo>
                  <a:lnTo>
                    <a:pt x="244" y="1272"/>
                  </a:lnTo>
                  <a:lnTo>
                    <a:pt x="251" y="1274"/>
                  </a:lnTo>
                  <a:close/>
                  <a:moveTo>
                    <a:pt x="260" y="1256"/>
                  </a:moveTo>
                  <a:lnTo>
                    <a:pt x="268" y="1242"/>
                  </a:lnTo>
                  <a:lnTo>
                    <a:pt x="261" y="1240"/>
                  </a:lnTo>
                  <a:lnTo>
                    <a:pt x="254" y="1254"/>
                  </a:lnTo>
                  <a:lnTo>
                    <a:pt x="260" y="1256"/>
                  </a:lnTo>
                  <a:close/>
                  <a:moveTo>
                    <a:pt x="270" y="1238"/>
                  </a:moveTo>
                  <a:lnTo>
                    <a:pt x="277" y="1224"/>
                  </a:lnTo>
                  <a:lnTo>
                    <a:pt x="271" y="1223"/>
                  </a:lnTo>
                  <a:lnTo>
                    <a:pt x="263" y="1236"/>
                  </a:lnTo>
                  <a:lnTo>
                    <a:pt x="270" y="1238"/>
                  </a:lnTo>
                  <a:close/>
                  <a:moveTo>
                    <a:pt x="280" y="1220"/>
                  </a:moveTo>
                  <a:lnTo>
                    <a:pt x="287" y="1206"/>
                  </a:lnTo>
                  <a:lnTo>
                    <a:pt x="280" y="1205"/>
                  </a:lnTo>
                  <a:lnTo>
                    <a:pt x="273" y="1218"/>
                  </a:lnTo>
                  <a:lnTo>
                    <a:pt x="280" y="1220"/>
                  </a:lnTo>
                  <a:close/>
                  <a:moveTo>
                    <a:pt x="290" y="1202"/>
                  </a:moveTo>
                  <a:lnTo>
                    <a:pt x="297" y="1188"/>
                  </a:lnTo>
                  <a:lnTo>
                    <a:pt x="290" y="1187"/>
                  </a:lnTo>
                  <a:lnTo>
                    <a:pt x="283" y="1200"/>
                  </a:lnTo>
                  <a:lnTo>
                    <a:pt x="290" y="1202"/>
                  </a:lnTo>
                  <a:close/>
                  <a:moveTo>
                    <a:pt x="299" y="1184"/>
                  </a:moveTo>
                  <a:lnTo>
                    <a:pt x="307" y="1170"/>
                  </a:lnTo>
                  <a:lnTo>
                    <a:pt x="300" y="1169"/>
                  </a:lnTo>
                  <a:lnTo>
                    <a:pt x="293" y="1182"/>
                  </a:lnTo>
                  <a:lnTo>
                    <a:pt x="299" y="1184"/>
                  </a:lnTo>
                  <a:close/>
                  <a:moveTo>
                    <a:pt x="309" y="1166"/>
                  </a:moveTo>
                  <a:lnTo>
                    <a:pt x="316" y="1152"/>
                  </a:lnTo>
                  <a:lnTo>
                    <a:pt x="310" y="1151"/>
                  </a:lnTo>
                  <a:lnTo>
                    <a:pt x="302" y="1164"/>
                  </a:lnTo>
                  <a:lnTo>
                    <a:pt x="309" y="1166"/>
                  </a:lnTo>
                  <a:close/>
                  <a:moveTo>
                    <a:pt x="319" y="1148"/>
                  </a:moveTo>
                  <a:lnTo>
                    <a:pt x="326" y="1134"/>
                  </a:lnTo>
                  <a:lnTo>
                    <a:pt x="319" y="1133"/>
                  </a:lnTo>
                  <a:lnTo>
                    <a:pt x="312" y="1146"/>
                  </a:lnTo>
                  <a:lnTo>
                    <a:pt x="319" y="1148"/>
                  </a:lnTo>
                  <a:close/>
                  <a:moveTo>
                    <a:pt x="329" y="1130"/>
                  </a:moveTo>
                  <a:lnTo>
                    <a:pt x="336" y="1116"/>
                  </a:lnTo>
                  <a:lnTo>
                    <a:pt x="329" y="1115"/>
                  </a:lnTo>
                  <a:lnTo>
                    <a:pt x="322" y="1128"/>
                  </a:lnTo>
                  <a:lnTo>
                    <a:pt x="329" y="1130"/>
                  </a:lnTo>
                  <a:close/>
                  <a:moveTo>
                    <a:pt x="338" y="1112"/>
                  </a:moveTo>
                  <a:lnTo>
                    <a:pt x="346" y="1098"/>
                  </a:lnTo>
                  <a:lnTo>
                    <a:pt x="339" y="1097"/>
                  </a:lnTo>
                  <a:lnTo>
                    <a:pt x="332" y="1110"/>
                  </a:lnTo>
                  <a:lnTo>
                    <a:pt x="338" y="1112"/>
                  </a:lnTo>
                  <a:close/>
                  <a:moveTo>
                    <a:pt x="348" y="1094"/>
                  </a:moveTo>
                  <a:lnTo>
                    <a:pt x="355" y="1080"/>
                  </a:lnTo>
                  <a:lnTo>
                    <a:pt x="349" y="1079"/>
                  </a:lnTo>
                  <a:lnTo>
                    <a:pt x="341" y="1092"/>
                  </a:lnTo>
                  <a:lnTo>
                    <a:pt x="348" y="1094"/>
                  </a:lnTo>
                  <a:close/>
                  <a:moveTo>
                    <a:pt x="358" y="1076"/>
                  </a:moveTo>
                  <a:lnTo>
                    <a:pt x="365" y="1062"/>
                  </a:lnTo>
                  <a:lnTo>
                    <a:pt x="358" y="1061"/>
                  </a:lnTo>
                  <a:lnTo>
                    <a:pt x="351" y="1074"/>
                  </a:lnTo>
                  <a:lnTo>
                    <a:pt x="358" y="1076"/>
                  </a:lnTo>
                  <a:close/>
                  <a:moveTo>
                    <a:pt x="368" y="1058"/>
                  </a:moveTo>
                  <a:lnTo>
                    <a:pt x="375" y="1044"/>
                  </a:lnTo>
                  <a:lnTo>
                    <a:pt x="368" y="1043"/>
                  </a:lnTo>
                  <a:lnTo>
                    <a:pt x="361" y="1056"/>
                  </a:lnTo>
                  <a:lnTo>
                    <a:pt x="368" y="1058"/>
                  </a:lnTo>
                  <a:close/>
                  <a:moveTo>
                    <a:pt x="377" y="1040"/>
                  </a:moveTo>
                  <a:lnTo>
                    <a:pt x="385" y="1026"/>
                  </a:lnTo>
                  <a:lnTo>
                    <a:pt x="378" y="1025"/>
                  </a:lnTo>
                  <a:lnTo>
                    <a:pt x="371" y="1038"/>
                  </a:lnTo>
                  <a:lnTo>
                    <a:pt x="377" y="1040"/>
                  </a:lnTo>
                  <a:close/>
                  <a:moveTo>
                    <a:pt x="387" y="1022"/>
                  </a:moveTo>
                  <a:lnTo>
                    <a:pt x="394" y="1008"/>
                  </a:lnTo>
                  <a:lnTo>
                    <a:pt x="388" y="1007"/>
                  </a:lnTo>
                  <a:lnTo>
                    <a:pt x="380" y="1020"/>
                  </a:lnTo>
                  <a:lnTo>
                    <a:pt x="387" y="1022"/>
                  </a:lnTo>
                  <a:close/>
                  <a:moveTo>
                    <a:pt x="397" y="1004"/>
                  </a:moveTo>
                  <a:lnTo>
                    <a:pt x="404" y="990"/>
                  </a:lnTo>
                  <a:lnTo>
                    <a:pt x="397" y="989"/>
                  </a:lnTo>
                  <a:lnTo>
                    <a:pt x="390" y="1002"/>
                  </a:lnTo>
                  <a:lnTo>
                    <a:pt x="397" y="1004"/>
                  </a:lnTo>
                  <a:close/>
                  <a:moveTo>
                    <a:pt x="407" y="986"/>
                  </a:moveTo>
                  <a:lnTo>
                    <a:pt x="414" y="972"/>
                  </a:lnTo>
                  <a:lnTo>
                    <a:pt x="407" y="971"/>
                  </a:lnTo>
                  <a:lnTo>
                    <a:pt x="400" y="984"/>
                  </a:lnTo>
                  <a:lnTo>
                    <a:pt x="407" y="986"/>
                  </a:lnTo>
                  <a:close/>
                  <a:moveTo>
                    <a:pt x="416" y="968"/>
                  </a:moveTo>
                  <a:lnTo>
                    <a:pt x="424" y="954"/>
                  </a:lnTo>
                  <a:lnTo>
                    <a:pt x="417" y="953"/>
                  </a:lnTo>
                  <a:lnTo>
                    <a:pt x="409" y="966"/>
                  </a:lnTo>
                  <a:lnTo>
                    <a:pt x="416" y="968"/>
                  </a:lnTo>
                  <a:close/>
                  <a:moveTo>
                    <a:pt x="426" y="950"/>
                  </a:moveTo>
                  <a:lnTo>
                    <a:pt x="433" y="937"/>
                  </a:lnTo>
                  <a:lnTo>
                    <a:pt x="427" y="935"/>
                  </a:lnTo>
                  <a:lnTo>
                    <a:pt x="419" y="948"/>
                  </a:lnTo>
                  <a:lnTo>
                    <a:pt x="426" y="950"/>
                  </a:lnTo>
                  <a:close/>
                  <a:moveTo>
                    <a:pt x="436" y="932"/>
                  </a:moveTo>
                  <a:lnTo>
                    <a:pt x="443" y="919"/>
                  </a:lnTo>
                  <a:lnTo>
                    <a:pt x="436" y="917"/>
                  </a:lnTo>
                  <a:lnTo>
                    <a:pt x="429" y="930"/>
                  </a:lnTo>
                  <a:lnTo>
                    <a:pt x="436" y="932"/>
                  </a:lnTo>
                  <a:close/>
                  <a:moveTo>
                    <a:pt x="446" y="914"/>
                  </a:moveTo>
                  <a:lnTo>
                    <a:pt x="453" y="901"/>
                  </a:lnTo>
                  <a:lnTo>
                    <a:pt x="446" y="899"/>
                  </a:lnTo>
                  <a:lnTo>
                    <a:pt x="439" y="912"/>
                  </a:lnTo>
                  <a:lnTo>
                    <a:pt x="446" y="914"/>
                  </a:lnTo>
                  <a:close/>
                  <a:moveTo>
                    <a:pt x="455" y="896"/>
                  </a:moveTo>
                  <a:lnTo>
                    <a:pt x="463" y="883"/>
                  </a:lnTo>
                  <a:lnTo>
                    <a:pt x="456" y="881"/>
                  </a:lnTo>
                  <a:lnTo>
                    <a:pt x="449" y="895"/>
                  </a:lnTo>
                  <a:lnTo>
                    <a:pt x="455" y="896"/>
                  </a:lnTo>
                  <a:close/>
                  <a:moveTo>
                    <a:pt x="465" y="878"/>
                  </a:moveTo>
                  <a:lnTo>
                    <a:pt x="472" y="865"/>
                  </a:lnTo>
                  <a:lnTo>
                    <a:pt x="466" y="863"/>
                  </a:lnTo>
                  <a:lnTo>
                    <a:pt x="458" y="877"/>
                  </a:lnTo>
                  <a:lnTo>
                    <a:pt x="465" y="878"/>
                  </a:lnTo>
                  <a:close/>
                  <a:moveTo>
                    <a:pt x="475" y="860"/>
                  </a:moveTo>
                  <a:lnTo>
                    <a:pt x="482" y="847"/>
                  </a:lnTo>
                  <a:lnTo>
                    <a:pt x="475" y="845"/>
                  </a:lnTo>
                  <a:lnTo>
                    <a:pt x="468" y="859"/>
                  </a:lnTo>
                  <a:lnTo>
                    <a:pt x="475" y="860"/>
                  </a:lnTo>
                  <a:close/>
                  <a:moveTo>
                    <a:pt x="485" y="842"/>
                  </a:moveTo>
                  <a:lnTo>
                    <a:pt x="492" y="829"/>
                  </a:lnTo>
                  <a:lnTo>
                    <a:pt x="485" y="827"/>
                  </a:lnTo>
                  <a:lnTo>
                    <a:pt x="478" y="841"/>
                  </a:lnTo>
                  <a:lnTo>
                    <a:pt x="485" y="842"/>
                  </a:lnTo>
                  <a:close/>
                  <a:moveTo>
                    <a:pt x="494" y="824"/>
                  </a:moveTo>
                  <a:lnTo>
                    <a:pt x="502" y="811"/>
                  </a:lnTo>
                  <a:lnTo>
                    <a:pt x="495" y="809"/>
                  </a:lnTo>
                  <a:lnTo>
                    <a:pt x="487" y="823"/>
                  </a:lnTo>
                  <a:lnTo>
                    <a:pt x="494" y="824"/>
                  </a:lnTo>
                  <a:close/>
                  <a:moveTo>
                    <a:pt x="504" y="806"/>
                  </a:moveTo>
                  <a:lnTo>
                    <a:pt x="511" y="793"/>
                  </a:lnTo>
                  <a:lnTo>
                    <a:pt x="504" y="791"/>
                  </a:lnTo>
                  <a:lnTo>
                    <a:pt x="497" y="805"/>
                  </a:lnTo>
                  <a:lnTo>
                    <a:pt x="504" y="806"/>
                  </a:lnTo>
                  <a:close/>
                  <a:moveTo>
                    <a:pt x="514" y="788"/>
                  </a:moveTo>
                  <a:lnTo>
                    <a:pt x="521" y="775"/>
                  </a:lnTo>
                  <a:lnTo>
                    <a:pt x="514" y="773"/>
                  </a:lnTo>
                  <a:lnTo>
                    <a:pt x="507" y="787"/>
                  </a:lnTo>
                  <a:lnTo>
                    <a:pt x="514" y="788"/>
                  </a:lnTo>
                  <a:close/>
                  <a:moveTo>
                    <a:pt x="524" y="770"/>
                  </a:moveTo>
                  <a:lnTo>
                    <a:pt x="531" y="757"/>
                  </a:lnTo>
                  <a:lnTo>
                    <a:pt x="524" y="755"/>
                  </a:lnTo>
                  <a:lnTo>
                    <a:pt x="517" y="769"/>
                  </a:lnTo>
                  <a:lnTo>
                    <a:pt x="524" y="770"/>
                  </a:lnTo>
                  <a:close/>
                  <a:moveTo>
                    <a:pt x="533" y="752"/>
                  </a:moveTo>
                  <a:lnTo>
                    <a:pt x="541" y="739"/>
                  </a:lnTo>
                  <a:lnTo>
                    <a:pt x="534" y="737"/>
                  </a:lnTo>
                  <a:lnTo>
                    <a:pt x="526" y="751"/>
                  </a:lnTo>
                  <a:lnTo>
                    <a:pt x="533" y="752"/>
                  </a:lnTo>
                  <a:close/>
                  <a:moveTo>
                    <a:pt x="543" y="734"/>
                  </a:moveTo>
                  <a:lnTo>
                    <a:pt x="550" y="721"/>
                  </a:lnTo>
                  <a:lnTo>
                    <a:pt x="544" y="719"/>
                  </a:lnTo>
                  <a:lnTo>
                    <a:pt x="536" y="733"/>
                  </a:lnTo>
                  <a:lnTo>
                    <a:pt x="543" y="734"/>
                  </a:lnTo>
                  <a:close/>
                  <a:moveTo>
                    <a:pt x="553" y="716"/>
                  </a:moveTo>
                  <a:lnTo>
                    <a:pt x="560" y="703"/>
                  </a:lnTo>
                  <a:lnTo>
                    <a:pt x="553" y="701"/>
                  </a:lnTo>
                  <a:lnTo>
                    <a:pt x="546" y="715"/>
                  </a:lnTo>
                  <a:lnTo>
                    <a:pt x="553" y="716"/>
                  </a:lnTo>
                  <a:close/>
                  <a:moveTo>
                    <a:pt x="562" y="698"/>
                  </a:moveTo>
                  <a:lnTo>
                    <a:pt x="570" y="685"/>
                  </a:lnTo>
                  <a:lnTo>
                    <a:pt x="563" y="683"/>
                  </a:lnTo>
                  <a:lnTo>
                    <a:pt x="556" y="697"/>
                  </a:lnTo>
                  <a:lnTo>
                    <a:pt x="562" y="698"/>
                  </a:lnTo>
                  <a:close/>
                  <a:moveTo>
                    <a:pt x="572" y="680"/>
                  </a:moveTo>
                  <a:lnTo>
                    <a:pt x="580" y="667"/>
                  </a:lnTo>
                  <a:lnTo>
                    <a:pt x="573" y="665"/>
                  </a:lnTo>
                  <a:lnTo>
                    <a:pt x="565" y="679"/>
                  </a:lnTo>
                  <a:lnTo>
                    <a:pt x="572" y="680"/>
                  </a:lnTo>
                  <a:close/>
                  <a:moveTo>
                    <a:pt x="582" y="662"/>
                  </a:moveTo>
                  <a:lnTo>
                    <a:pt x="589" y="649"/>
                  </a:lnTo>
                  <a:lnTo>
                    <a:pt x="583" y="647"/>
                  </a:lnTo>
                  <a:lnTo>
                    <a:pt x="575" y="661"/>
                  </a:lnTo>
                  <a:lnTo>
                    <a:pt x="582" y="662"/>
                  </a:lnTo>
                  <a:close/>
                  <a:moveTo>
                    <a:pt x="592" y="644"/>
                  </a:moveTo>
                  <a:lnTo>
                    <a:pt x="599" y="631"/>
                  </a:lnTo>
                  <a:lnTo>
                    <a:pt x="592" y="629"/>
                  </a:lnTo>
                  <a:lnTo>
                    <a:pt x="585" y="643"/>
                  </a:lnTo>
                  <a:lnTo>
                    <a:pt x="592" y="644"/>
                  </a:lnTo>
                  <a:close/>
                  <a:moveTo>
                    <a:pt x="601" y="626"/>
                  </a:moveTo>
                  <a:lnTo>
                    <a:pt x="609" y="613"/>
                  </a:lnTo>
                  <a:lnTo>
                    <a:pt x="602" y="611"/>
                  </a:lnTo>
                  <a:lnTo>
                    <a:pt x="595" y="625"/>
                  </a:lnTo>
                  <a:lnTo>
                    <a:pt x="601" y="626"/>
                  </a:lnTo>
                  <a:close/>
                  <a:moveTo>
                    <a:pt x="611" y="609"/>
                  </a:moveTo>
                  <a:lnTo>
                    <a:pt x="619" y="595"/>
                  </a:lnTo>
                  <a:lnTo>
                    <a:pt x="612" y="593"/>
                  </a:lnTo>
                  <a:lnTo>
                    <a:pt x="604" y="607"/>
                  </a:lnTo>
                  <a:lnTo>
                    <a:pt x="611" y="609"/>
                  </a:lnTo>
                  <a:close/>
                  <a:moveTo>
                    <a:pt x="621" y="591"/>
                  </a:moveTo>
                  <a:lnTo>
                    <a:pt x="628" y="577"/>
                  </a:lnTo>
                  <a:lnTo>
                    <a:pt x="621" y="575"/>
                  </a:lnTo>
                  <a:lnTo>
                    <a:pt x="614" y="589"/>
                  </a:lnTo>
                  <a:lnTo>
                    <a:pt x="621" y="591"/>
                  </a:lnTo>
                  <a:close/>
                  <a:moveTo>
                    <a:pt x="631" y="573"/>
                  </a:moveTo>
                  <a:lnTo>
                    <a:pt x="638" y="559"/>
                  </a:lnTo>
                  <a:lnTo>
                    <a:pt x="631" y="557"/>
                  </a:lnTo>
                  <a:lnTo>
                    <a:pt x="624" y="571"/>
                  </a:lnTo>
                  <a:lnTo>
                    <a:pt x="631" y="573"/>
                  </a:lnTo>
                  <a:close/>
                  <a:moveTo>
                    <a:pt x="640" y="555"/>
                  </a:moveTo>
                  <a:lnTo>
                    <a:pt x="648" y="541"/>
                  </a:lnTo>
                  <a:lnTo>
                    <a:pt x="641" y="539"/>
                  </a:lnTo>
                  <a:lnTo>
                    <a:pt x="634" y="553"/>
                  </a:lnTo>
                  <a:lnTo>
                    <a:pt x="640" y="555"/>
                  </a:lnTo>
                  <a:close/>
                  <a:moveTo>
                    <a:pt x="650" y="537"/>
                  </a:moveTo>
                  <a:lnTo>
                    <a:pt x="657" y="523"/>
                  </a:lnTo>
                  <a:lnTo>
                    <a:pt x="651" y="522"/>
                  </a:lnTo>
                  <a:lnTo>
                    <a:pt x="643" y="535"/>
                  </a:lnTo>
                  <a:lnTo>
                    <a:pt x="650" y="537"/>
                  </a:lnTo>
                  <a:close/>
                  <a:moveTo>
                    <a:pt x="660" y="519"/>
                  </a:moveTo>
                  <a:lnTo>
                    <a:pt x="667" y="505"/>
                  </a:lnTo>
                  <a:lnTo>
                    <a:pt x="660" y="504"/>
                  </a:lnTo>
                  <a:lnTo>
                    <a:pt x="653" y="517"/>
                  </a:lnTo>
                  <a:lnTo>
                    <a:pt x="660" y="519"/>
                  </a:lnTo>
                  <a:close/>
                  <a:moveTo>
                    <a:pt x="670" y="501"/>
                  </a:moveTo>
                  <a:lnTo>
                    <a:pt x="677" y="487"/>
                  </a:lnTo>
                  <a:lnTo>
                    <a:pt x="670" y="486"/>
                  </a:lnTo>
                  <a:lnTo>
                    <a:pt x="663" y="499"/>
                  </a:lnTo>
                  <a:lnTo>
                    <a:pt x="670" y="501"/>
                  </a:lnTo>
                  <a:close/>
                  <a:moveTo>
                    <a:pt x="679" y="483"/>
                  </a:moveTo>
                  <a:lnTo>
                    <a:pt x="687" y="469"/>
                  </a:lnTo>
                  <a:lnTo>
                    <a:pt x="680" y="468"/>
                  </a:lnTo>
                  <a:lnTo>
                    <a:pt x="673" y="481"/>
                  </a:lnTo>
                  <a:lnTo>
                    <a:pt x="679" y="483"/>
                  </a:lnTo>
                  <a:close/>
                  <a:moveTo>
                    <a:pt x="689" y="465"/>
                  </a:moveTo>
                  <a:lnTo>
                    <a:pt x="696" y="451"/>
                  </a:lnTo>
                  <a:lnTo>
                    <a:pt x="690" y="450"/>
                  </a:lnTo>
                  <a:lnTo>
                    <a:pt x="682" y="463"/>
                  </a:lnTo>
                  <a:lnTo>
                    <a:pt x="689" y="465"/>
                  </a:lnTo>
                  <a:close/>
                  <a:moveTo>
                    <a:pt x="699" y="447"/>
                  </a:moveTo>
                  <a:lnTo>
                    <a:pt x="706" y="433"/>
                  </a:lnTo>
                  <a:lnTo>
                    <a:pt x="699" y="432"/>
                  </a:lnTo>
                  <a:lnTo>
                    <a:pt x="692" y="445"/>
                  </a:lnTo>
                  <a:lnTo>
                    <a:pt x="699" y="447"/>
                  </a:lnTo>
                  <a:close/>
                  <a:moveTo>
                    <a:pt x="709" y="429"/>
                  </a:moveTo>
                  <a:lnTo>
                    <a:pt x="716" y="415"/>
                  </a:lnTo>
                  <a:lnTo>
                    <a:pt x="709" y="414"/>
                  </a:lnTo>
                  <a:lnTo>
                    <a:pt x="702" y="427"/>
                  </a:lnTo>
                  <a:lnTo>
                    <a:pt x="709" y="429"/>
                  </a:lnTo>
                  <a:close/>
                  <a:moveTo>
                    <a:pt x="718" y="411"/>
                  </a:moveTo>
                  <a:lnTo>
                    <a:pt x="726" y="397"/>
                  </a:lnTo>
                  <a:lnTo>
                    <a:pt x="719" y="396"/>
                  </a:lnTo>
                  <a:lnTo>
                    <a:pt x="712" y="409"/>
                  </a:lnTo>
                  <a:lnTo>
                    <a:pt x="718" y="411"/>
                  </a:lnTo>
                  <a:close/>
                  <a:moveTo>
                    <a:pt x="728" y="393"/>
                  </a:moveTo>
                  <a:lnTo>
                    <a:pt x="736" y="379"/>
                  </a:lnTo>
                  <a:lnTo>
                    <a:pt x="729" y="378"/>
                  </a:lnTo>
                  <a:lnTo>
                    <a:pt x="721" y="391"/>
                  </a:lnTo>
                  <a:lnTo>
                    <a:pt x="728" y="393"/>
                  </a:lnTo>
                  <a:close/>
                  <a:moveTo>
                    <a:pt x="738" y="375"/>
                  </a:moveTo>
                  <a:lnTo>
                    <a:pt x="745" y="361"/>
                  </a:lnTo>
                  <a:lnTo>
                    <a:pt x="738" y="360"/>
                  </a:lnTo>
                  <a:lnTo>
                    <a:pt x="731" y="373"/>
                  </a:lnTo>
                  <a:lnTo>
                    <a:pt x="738" y="375"/>
                  </a:lnTo>
                  <a:close/>
                  <a:moveTo>
                    <a:pt x="748" y="357"/>
                  </a:moveTo>
                  <a:lnTo>
                    <a:pt x="755" y="343"/>
                  </a:lnTo>
                  <a:lnTo>
                    <a:pt x="748" y="342"/>
                  </a:lnTo>
                  <a:lnTo>
                    <a:pt x="741" y="355"/>
                  </a:lnTo>
                  <a:lnTo>
                    <a:pt x="748" y="357"/>
                  </a:lnTo>
                  <a:close/>
                  <a:moveTo>
                    <a:pt x="757" y="339"/>
                  </a:moveTo>
                  <a:lnTo>
                    <a:pt x="765" y="325"/>
                  </a:lnTo>
                  <a:lnTo>
                    <a:pt x="758" y="324"/>
                  </a:lnTo>
                  <a:lnTo>
                    <a:pt x="751" y="337"/>
                  </a:lnTo>
                  <a:lnTo>
                    <a:pt x="757" y="339"/>
                  </a:lnTo>
                  <a:close/>
                  <a:moveTo>
                    <a:pt x="767" y="321"/>
                  </a:moveTo>
                  <a:lnTo>
                    <a:pt x="774" y="307"/>
                  </a:lnTo>
                  <a:lnTo>
                    <a:pt x="768" y="306"/>
                  </a:lnTo>
                  <a:lnTo>
                    <a:pt x="760" y="319"/>
                  </a:lnTo>
                  <a:lnTo>
                    <a:pt x="767" y="321"/>
                  </a:lnTo>
                  <a:close/>
                  <a:moveTo>
                    <a:pt x="777" y="303"/>
                  </a:moveTo>
                  <a:lnTo>
                    <a:pt x="784" y="289"/>
                  </a:lnTo>
                  <a:lnTo>
                    <a:pt x="777" y="288"/>
                  </a:lnTo>
                  <a:lnTo>
                    <a:pt x="770" y="301"/>
                  </a:lnTo>
                  <a:lnTo>
                    <a:pt x="777" y="303"/>
                  </a:lnTo>
                  <a:close/>
                  <a:moveTo>
                    <a:pt x="787" y="285"/>
                  </a:moveTo>
                  <a:lnTo>
                    <a:pt x="794" y="271"/>
                  </a:lnTo>
                  <a:lnTo>
                    <a:pt x="787" y="270"/>
                  </a:lnTo>
                  <a:lnTo>
                    <a:pt x="780" y="283"/>
                  </a:lnTo>
                  <a:lnTo>
                    <a:pt x="787" y="285"/>
                  </a:lnTo>
                  <a:close/>
                  <a:moveTo>
                    <a:pt x="796" y="267"/>
                  </a:moveTo>
                  <a:lnTo>
                    <a:pt x="804" y="253"/>
                  </a:lnTo>
                  <a:lnTo>
                    <a:pt x="797" y="252"/>
                  </a:lnTo>
                  <a:lnTo>
                    <a:pt x="790" y="265"/>
                  </a:lnTo>
                  <a:lnTo>
                    <a:pt x="796" y="267"/>
                  </a:lnTo>
                  <a:close/>
                  <a:moveTo>
                    <a:pt x="806" y="249"/>
                  </a:moveTo>
                  <a:lnTo>
                    <a:pt x="813" y="236"/>
                  </a:lnTo>
                  <a:lnTo>
                    <a:pt x="807" y="234"/>
                  </a:lnTo>
                  <a:lnTo>
                    <a:pt x="799" y="247"/>
                  </a:lnTo>
                  <a:lnTo>
                    <a:pt x="806" y="249"/>
                  </a:lnTo>
                  <a:close/>
                  <a:moveTo>
                    <a:pt x="816" y="231"/>
                  </a:moveTo>
                  <a:lnTo>
                    <a:pt x="823" y="218"/>
                  </a:lnTo>
                  <a:lnTo>
                    <a:pt x="816" y="216"/>
                  </a:lnTo>
                  <a:lnTo>
                    <a:pt x="809" y="229"/>
                  </a:lnTo>
                  <a:lnTo>
                    <a:pt x="816" y="231"/>
                  </a:lnTo>
                  <a:close/>
                  <a:moveTo>
                    <a:pt x="826" y="213"/>
                  </a:moveTo>
                  <a:lnTo>
                    <a:pt x="833" y="200"/>
                  </a:lnTo>
                  <a:lnTo>
                    <a:pt x="826" y="198"/>
                  </a:lnTo>
                  <a:lnTo>
                    <a:pt x="819" y="211"/>
                  </a:lnTo>
                  <a:lnTo>
                    <a:pt x="826" y="213"/>
                  </a:lnTo>
                  <a:close/>
                  <a:moveTo>
                    <a:pt x="835" y="195"/>
                  </a:moveTo>
                  <a:lnTo>
                    <a:pt x="843" y="182"/>
                  </a:lnTo>
                  <a:lnTo>
                    <a:pt x="836" y="180"/>
                  </a:lnTo>
                  <a:lnTo>
                    <a:pt x="829" y="193"/>
                  </a:lnTo>
                  <a:lnTo>
                    <a:pt x="835" y="195"/>
                  </a:lnTo>
                  <a:close/>
                  <a:moveTo>
                    <a:pt x="845" y="177"/>
                  </a:moveTo>
                  <a:lnTo>
                    <a:pt x="852" y="164"/>
                  </a:lnTo>
                  <a:lnTo>
                    <a:pt x="846" y="162"/>
                  </a:lnTo>
                  <a:lnTo>
                    <a:pt x="838" y="175"/>
                  </a:lnTo>
                  <a:lnTo>
                    <a:pt x="845" y="177"/>
                  </a:lnTo>
                  <a:close/>
                  <a:moveTo>
                    <a:pt x="855" y="159"/>
                  </a:moveTo>
                  <a:lnTo>
                    <a:pt x="862" y="146"/>
                  </a:lnTo>
                  <a:lnTo>
                    <a:pt x="855" y="144"/>
                  </a:lnTo>
                  <a:lnTo>
                    <a:pt x="848" y="157"/>
                  </a:lnTo>
                  <a:lnTo>
                    <a:pt x="855" y="159"/>
                  </a:lnTo>
                  <a:close/>
                  <a:moveTo>
                    <a:pt x="865" y="141"/>
                  </a:moveTo>
                  <a:lnTo>
                    <a:pt x="872" y="128"/>
                  </a:lnTo>
                  <a:lnTo>
                    <a:pt x="865" y="126"/>
                  </a:lnTo>
                  <a:lnTo>
                    <a:pt x="858" y="139"/>
                  </a:lnTo>
                  <a:lnTo>
                    <a:pt x="865" y="141"/>
                  </a:lnTo>
                  <a:close/>
                  <a:moveTo>
                    <a:pt x="874" y="123"/>
                  </a:moveTo>
                  <a:lnTo>
                    <a:pt x="882" y="110"/>
                  </a:lnTo>
                  <a:lnTo>
                    <a:pt x="875" y="108"/>
                  </a:lnTo>
                  <a:lnTo>
                    <a:pt x="868" y="122"/>
                  </a:lnTo>
                  <a:lnTo>
                    <a:pt x="874" y="123"/>
                  </a:lnTo>
                  <a:close/>
                  <a:moveTo>
                    <a:pt x="884" y="105"/>
                  </a:moveTo>
                  <a:lnTo>
                    <a:pt x="891" y="92"/>
                  </a:lnTo>
                  <a:lnTo>
                    <a:pt x="885" y="90"/>
                  </a:lnTo>
                  <a:lnTo>
                    <a:pt x="877" y="104"/>
                  </a:lnTo>
                  <a:lnTo>
                    <a:pt x="884" y="105"/>
                  </a:lnTo>
                  <a:close/>
                  <a:moveTo>
                    <a:pt x="894" y="87"/>
                  </a:moveTo>
                  <a:lnTo>
                    <a:pt x="901" y="74"/>
                  </a:lnTo>
                  <a:lnTo>
                    <a:pt x="894" y="72"/>
                  </a:lnTo>
                  <a:lnTo>
                    <a:pt x="887" y="86"/>
                  </a:lnTo>
                  <a:lnTo>
                    <a:pt x="894" y="87"/>
                  </a:lnTo>
                  <a:close/>
                  <a:moveTo>
                    <a:pt x="904" y="69"/>
                  </a:moveTo>
                  <a:lnTo>
                    <a:pt x="911" y="56"/>
                  </a:lnTo>
                  <a:lnTo>
                    <a:pt x="904" y="54"/>
                  </a:lnTo>
                  <a:lnTo>
                    <a:pt x="897" y="68"/>
                  </a:lnTo>
                  <a:lnTo>
                    <a:pt x="904" y="69"/>
                  </a:lnTo>
                  <a:close/>
                  <a:moveTo>
                    <a:pt x="913" y="51"/>
                  </a:moveTo>
                  <a:lnTo>
                    <a:pt x="921" y="38"/>
                  </a:lnTo>
                  <a:lnTo>
                    <a:pt x="914" y="36"/>
                  </a:lnTo>
                  <a:lnTo>
                    <a:pt x="907" y="50"/>
                  </a:lnTo>
                  <a:lnTo>
                    <a:pt x="913" y="51"/>
                  </a:lnTo>
                  <a:close/>
                  <a:moveTo>
                    <a:pt x="923" y="33"/>
                  </a:moveTo>
                  <a:lnTo>
                    <a:pt x="930" y="20"/>
                  </a:lnTo>
                  <a:lnTo>
                    <a:pt x="924" y="18"/>
                  </a:lnTo>
                  <a:lnTo>
                    <a:pt x="916" y="32"/>
                  </a:lnTo>
                  <a:lnTo>
                    <a:pt x="923" y="33"/>
                  </a:lnTo>
                  <a:close/>
                  <a:moveTo>
                    <a:pt x="933" y="15"/>
                  </a:moveTo>
                  <a:lnTo>
                    <a:pt x="940" y="2"/>
                  </a:lnTo>
                  <a:lnTo>
                    <a:pt x="933" y="0"/>
                  </a:lnTo>
                  <a:lnTo>
                    <a:pt x="926" y="14"/>
                  </a:lnTo>
                  <a:lnTo>
                    <a:pt x="933" y="15"/>
                  </a:lnTo>
                  <a:close/>
                </a:path>
              </a:pathLst>
            </a:custGeom>
            <a:solidFill>
              <a:srgbClr val="D0CECE"/>
            </a:solidFill>
            <a:ln w="0" cap="flat">
              <a:solidFill>
                <a:srgbClr val="D0CECE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pic>
          <p:nvPicPr>
            <p:cNvPr id="1114" name="Picture 90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47" y="451"/>
              <a:ext cx="1432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16" name="Picture 92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41" y="531"/>
              <a:ext cx="1474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18" name="Picture 94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10" y="611"/>
              <a:ext cx="936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20" name="Picture 96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44" y="692"/>
              <a:ext cx="837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22" name="Picture 98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82" y="772"/>
              <a:ext cx="562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2" name="Line 100"/>
            <p:cNvSpPr>
              <a:spLocks noChangeShapeType="1"/>
            </p:cNvSpPr>
            <p:nvPr/>
          </p:nvSpPr>
          <p:spPr bwMode="auto">
            <a:xfrm flipH="1">
              <a:off x="1742" y="1457"/>
              <a:ext cx="541" cy="168"/>
            </a:xfrm>
            <a:prstGeom prst="line">
              <a:avLst/>
            </a:prstGeom>
            <a:noFill/>
            <a:ln w="1111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sp>
          <p:nvSpPr>
            <p:cNvPr id="53" name="Line 101"/>
            <p:cNvSpPr>
              <a:spLocks noChangeShapeType="1"/>
            </p:cNvSpPr>
            <p:nvPr/>
          </p:nvSpPr>
          <p:spPr bwMode="auto">
            <a:xfrm flipH="1" flipV="1">
              <a:off x="1811" y="1084"/>
              <a:ext cx="472" cy="373"/>
            </a:xfrm>
            <a:prstGeom prst="line">
              <a:avLst/>
            </a:prstGeom>
            <a:noFill/>
            <a:ln w="1111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MX"/>
            </a:p>
          </p:txBody>
        </p:sp>
        <p:pic>
          <p:nvPicPr>
            <p:cNvPr id="1130" name="Picture 106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40" y="947"/>
              <a:ext cx="378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32" name="Picture 108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59" y="1003"/>
              <a:ext cx="463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34" name="Picture 110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59" y="1061"/>
              <a:ext cx="454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38" name="Picture 114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64" y="1594"/>
              <a:ext cx="458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40" name="Picture 116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66" y="1759"/>
              <a:ext cx="454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42" name="Picture 118"/>
            <p:cNvPicPr>
              <a:picLocks noChangeAspect="1" noChangeArrowheads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67" y="790"/>
              <a:ext cx="277" cy="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58" name="CuadroTexto 57"/>
          <p:cNvSpPr txBox="1"/>
          <p:nvPr/>
        </p:nvSpPr>
        <p:spPr>
          <a:xfrm>
            <a:off x="1113949" y="1282159"/>
            <a:ext cx="492443" cy="211538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s-MX" sz="2000" b="1" dirty="0" err="1" smtClean="0"/>
              <a:t>Community</a:t>
            </a:r>
            <a:r>
              <a:rPr lang="es-MX" sz="2000" b="1" dirty="0" smtClean="0"/>
              <a:t> </a:t>
            </a:r>
            <a:r>
              <a:rPr lang="es-MX" sz="2000" b="1" dirty="0" err="1" smtClean="0"/>
              <a:t>setting</a:t>
            </a:r>
            <a:endParaRPr lang="es-MX" sz="2000" b="1" dirty="0"/>
          </a:p>
        </p:txBody>
      </p:sp>
      <p:pic>
        <p:nvPicPr>
          <p:cNvPr id="59" name="Imagen 58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617527" y="1078792"/>
            <a:ext cx="1389062" cy="1104098"/>
          </a:xfrm>
          <a:prstGeom prst="rect">
            <a:avLst/>
          </a:prstGeom>
        </p:spPr>
      </p:pic>
      <p:sp>
        <p:nvSpPr>
          <p:cNvPr id="62" name="CuadroTexto 61"/>
          <p:cNvSpPr txBox="1"/>
          <p:nvPr/>
        </p:nvSpPr>
        <p:spPr>
          <a:xfrm>
            <a:off x="1725455" y="1204364"/>
            <a:ext cx="141890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 smtClean="0"/>
              <a:t>Maternal</a:t>
            </a:r>
          </a:p>
          <a:p>
            <a:r>
              <a:rPr lang="es-MX" dirty="0" smtClean="0"/>
              <a:t> </a:t>
            </a:r>
            <a:r>
              <a:rPr lang="es-MX" dirty="0" err="1" smtClean="0"/>
              <a:t>health</a:t>
            </a:r>
            <a:r>
              <a:rPr lang="es-MX" dirty="0" smtClean="0"/>
              <a:t> </a:t>
            </a:r>
          </a:p>
          <a:p>
            <a:r>
              <a:rPr lang="es-MX" dirty="0" err="1" smtClean="0"/>
              <a:t>committee</a:t>
            </a:r>
            <a:endParaRPr lang="es-MX" dirty="0"/>
          </a:p>
        </p:txBody>
      </p:sp>
      <p:pic>
        <p:nvPicPr>
          <p:cNvPr id="128" name="Imagen 127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677757" y="2506358"/>
            <a:ext cx="1499675" cy="1129595"/>
          </a:xfrm>
          <a:prstGeom prst="rect">
            <a:avLst/>
          </a:prstGeom>
        </p:spPr>
      </p:pic>
      <p:sp>
        <p:nvSpPr>
          <p:cNvPr id="63" name="CuadroTexto 62"/>
          <p:cNvSpPr txBox="1"/>
          <p:nvPr/>
        </p:nvSpPr>
        <p:spPr>
          <a:xfrm>
            <a:off x="1725455" y="2719555"/>
            <a:ext cx="13548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 err="1" smtClean="0"/>
              <a:t>Health</a:t>
            </a:r>
            <a:r>
              <a:rPr lang="es-MX" dirty="0" smtClean="0"/>
              <a:t> </a:t>
            </a:r>
          </a:p>
          <a:p>
            <a:r>
              <a:rPr lang="es-MX" dirty="0" err="1" smtClean="0"/>
              <a:t>Companions</a:t>
            </a:r>
            <a:endParaRPr lang="es-MX" dirty="0"/>
          </a:p>
        </p:txBody>
      </p:sp>
      <p:sp>
        <p:nvSpPr>
          <p:cNvPr id="64" name="CuadroTexto 63"/>
          <p:cNvSpPr txBox="1"/>
          <p:nvPr/>
        </p:nvSpPr>
        <p:spPr>
          <a:xfrm>
            <a:off x="3246977" y="3407"/>
            <a:ext cx="327815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Information flow</a:t>
            </a:r>
          </a:p>
          <a:p>
            <a:r>
              <a:rPr lang="en-US" dirty="0" smtClean="0"/>
              <a:t>Accountability</a:t>
            </a:r>
          </a:p>
          <a:p>
            <a:r>
              <a:rPr lang="en-US" dirty="0" smtClean="0"/>
              <a:t>training, supervision, supports</a:t>
            </a:r>
            <a:endParaRPr lang="es-MX" dirty="0"/>
          </a:p>
        </p:txBody>
      </p:sp>
      <p:sp>
        <p:nvSpPr>
          <p:cNvPr id="65" name="CuadroTexto 64"/>
          <p:cNvSpPr txBox="1"/>
          <p:nvPr/>
        </p:nvSpPr>
        <p:spPr>
          <a:xfrm>
            <a:off x="4193763" y="178956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MX" dirty="0"/>
          </a:p>
        </p:txBody>
      </p:sp>
      <p:sp>
        <p:nvSpPr>
          <p:cNvPr id="66" name="CuadroTexto 65"/>
          <p:cNvSpPr txBox="1"/>
          <p:nvPr/>
        </p:nvSpPr>
        <p:spPr>
          <a:xfrm>
            <a:off x="3524615" y="2396389"/>
            <a:ext cx="8595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 err="1" smtClean="0"/>
              <a:t>Health</a:t>
            </a:r>
            <a:r>
              <a:rPr lang="es-MX" dirty="0" smtClean="0"/>
              <a:t> </a:t>
            </a:r>
          </a:p>
          <a:p>
            <a:r>
              <a:rPr lang="es-MX" dirty="0" smtClean="0"/>
              <a:t>center</a:t>
            </a:r>
            <a:endParaRPr lang="es-MX" dirty="0"/>
          </a:p>
        </p:txBody>
      </p:sp>
      <p:sp>
        <p:nvSpPr>
          <p:cNvPr id="67" name="CuadroTexto 66"/>
          <p:cNvSpPr txBox="1"/>
          <p:nvPr/>
        </p:nvSpPr>
        <p:spPr>
          <a:xfrm>
            <a:off x="3370413" y="3183452"/>
            <a:ext cx="8595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 err="1" smtClean="0"/>
              <a:t>Health</a:t>
            </a:r>
            <a:r>
              <a:rPr lang="es-MX" dirty="0" smtClean="0"/>
              <a:t> </a:t>
            </a:r>
          </a:p>
          <a:p>
            <a:r>
              <a:rPr lang="es-MX" dirty="0" smtClean="0"/>
              <a:t>center</a:t>
            </a:r>
            <a:endParaRPr lang="es-MX" dirty="0"/>
          </a:p>
        </p:txBody>
      </p:sp>
      <p:sp>
        <p:nvSpPr>
          <p:cNvPr id="68" name="CuadroTexto 67"/>
          <p:cNvSpPr txBox="1"/>
          <p:nvPr/>
        </p:nvSpPr>
        <p:spPr>
          <a:xfrm>
            <a:off x="3306188" y="5456587"/>
            <a:ext cx="1954061" cy="646331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 w="317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 smtClean="0"/>
              <a:t>community health </a:t>
            </a:r>
          </a:p>
          <a:p>
            <a:r>
              <a:rPr lang="en-US" dirty="0"/>
              <a:t>c</a:t>
            </a:r>
            <a:r>
              <a:rPr lang="en-US" dirty="0" smtClean="0"/>
              <a:t>enters/houses</a:t>
            </a:r>
            <a:endParaRPr lang="es-MX" dirty="0"/>
          </a:p>
        </p:txBody>
      </p:sp>
      <p:sp>
        <p:nvSpPr>
          <p:cNvPr id="70" name="CuadroTexto 69"/>
          <p:cNvSpPr txBox="1"/>
          <p:nvPr/>
        </p:nvSpPr>
        <p:spPr>
          <a:xfrm>
            <a:off x="7947716" y="2610117"/>
            <a:ext cx="175920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 err="1" smtClean="0"/>
              <a:t>Information</a:t>
            </a:r>
            <a:r>
              <a:rPr lang="es-MX" dirty="0" smtClean="0"/>
              <a:t> </a:t>
            </a:r>
            <a:r>
              <a:rPr lang="es-MX" dirty="0" err="1" smtClean="0"/>
              <a:t>flow</a:t>
            </a:r>
            <a:endParaRPr lang="es-MX" dirty="0"/>
          </a:p>
          <a:p>
            <a:r>
              <a:rPr lang="es-MX" dirty="0" err="1" smtClean="0"/>
              <a:t>Patients</a:t>
            </a:r>
            <a:endParaRPr lang="es-MX" dirty="0" smtClean="0"/>
          </a:p>
          <a:p>
            <a:r>
              <a:rPr lang="es-MX" dirty="0" err="1" smtClean="0"/>
              <a:t>Supplies</a:t>
            </a:r>
            <a:endParaRPr lang="es-MX" dirty="0"/>
          </a:p>
        </p:txBody>
      </p:sp>
      <p:sp>
        <p:nvSpPr>
          <p:cNvPr id="72" name="Flecha abajo 71"/>
          <p:cNvSpPr/>
          <p:nvPr/>
        </p:nvSpPr>
        <p:spPr>
          <a:xfrm rot="10800000">
            <a:off x="4029802" y="4699467"/>
            <a:ext cx="484632" cy="62536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88218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</TotalTime>
  <Words>40</Words>
  <Application>Microsoft Office PowerPoint</Application>
  <PresentationFormat>Panorámica</PresentationFormat>
  <Paragraphs>3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Juarez Ramirez</dc:creator>
  <cp:lastModifiedBy>Clara Juarez Ramirez</cp:lastModifiedBy>
  <cp:revision>8</cp:revision>
  <dcterms:created xsi:type="dcterms:W3CDTF">2020-04-06T22:08:28Z</dcterms:created>
  <dcterms:modified xsi:type="dcterms:W3CDTF">2020-04-07T01:04:26Z</dcterms:modified>
</cp:coreProperties>
</file>